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vml" ContentType="application/vnd.openxmlformats-officedocument.vmlDrawing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17"/>
  </p:notesMasterIdLst>
  <p:sldIdLst>
    <p:sldId id="502" r:id="rId2"/>
    <p:sldId id="500" r:id="rId3"/>
    <p:sldId id="512" r:id="rId4"/>
    <p:sldId id="281" r:id="rId5"/>
    <p:sldId id="517" r:id="rId6"/>
    <p:sldId id="519" r:id="rId7"/>
    <p:sldId id="411" r:id="rId8"/>
    <p:sldId id="412" r:id="rId9"/>
    <p:sldId id="413" r:id="rId10"/>
    <p:sldId id="514" r:id="rId11"/>
    <p:sldId id="509" r:id="rId12"/>
    <p:sldId id="518" r:id="rId13"/>
    <p:sldId id="515" r:id="rId14"/>
    <p:sldId id="513" r:id="rId15"/>
    <p:sldId id="516" r:id="rId16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FFFF"/>
    <a:srgbClr val="00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608" autoAdjust="0"/>
    <p:restoredTop sz="94660"/>
  </p:normalViewPr>
  <p:slideViewPr>
    <p:cSldViewPr snapToGrid="0">
      <p:cViewPr varScale="1">
        <p:scale>
          <a:sx n="74" d="100"/>
          <a:sy n="74" d="100"/>
        </p:scale>
        <p:origin x="1368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tableStyles" Target="tableStyle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Derei Wu" userId="935b1b74ff2f2987" providerId="LiveId" clId="{ED6DE042-E01F-493C-87C7-096D08C4B1A2}"/>
    <pc:docChg chg="undo custSel addSld delSld modSld sldOrd">
      <pc:chgData name="Derei Wu" userId="935b1b74ff2f2987" providerId="LiveId" clId="{ED6DE042-E01F-493C-87C7-096D08C4B1A2}" dt="2021-08-11T08:53:12.679" v="29" actId="14100"/>
      <pc:docMkLst>
        <pc:docMk/>
      </pc:docMkLst>
      <pc:sldChg chg="modSp mod">
        <pc:chgData name="Derei Wu" userId="935b1b74ff2f2987" providerId="LiveId" clId="{ED6DE042-E01F-493C-87C7-096D08C4B1A2}" dt="2021-08-11T08:52:21.321" v="15" actId="1076"/>
        <pc:sldMkLst>
          <pc:docMk/>
          <pc:sldMk cId="1359657506" sldId="502"/>
        </pc:sldMkLst>
        <pc:spChg chg="mod">
          <ac:chgData name="Derei Wu" userId="935b1b74ff2f2987" providerId="LiveId" clId="{ED6DE042-E01F-493C-87C7-096D08C4B1A2}" dt="2021-08-11T08:52:21.321" v="15" actId="1076"/>
          <ac:spMkLst>
            <pc:docMk/>
            <pc:sldMk cId="1359657506" sldId="502"/>
            <ac:spMk id="2" creationId="{613740C7-D1FB-435B-B2E3-6644167D14FC}"/>
          </ac:spMkLst>
        </pc:spChg>
      </pc:sldChg>
      <pc:sldChg chg="new del">
        <pc:chgData name="Derei Wu" userId="935b1b74ff2f2987" providerId="LiveId" clId="{ED6DE042-E01F-493C-87C7-096D08C4B1A2}" dt="2021-08-11T08:52:55.118" v="18" actId="680"/>
        <pc:sldMkLst>
          <pc:docMk/>
          <pc:sldMk cId="302477487" sldId="513"/>
        </pc:sldMkLst>
      </pc:sldChg>
      <pc:sldChg chg="delSp modSp add del mod ord">
        <pc:chgData name="Derei Wu" userId="935b1b74ff2f2987" providerId="LiveId" clId="{ED6DE042-E01F-493C-87C7-096D08C4B1A2}" dt="2021-08-11T08:53:12.679" v="29" actId="14100"/>
        <pc:sldMkLst>
          <pc:docMk/>
          <pc:sldMk cId="1203018646" sldId="513"/>
        </pc:sldMkLst>
        <pc:spChg chg="mod">
          <ac:chgData name="Derei Wu" userId="935b1b74ff2f2987" providerId="LiveId" clId="{ED6DE042-E01F-493C-87C7-096D08C4B1A2}" dt="2021-08-11T08:53:12.679" v="29" actId="14100"/>
          <ac:spMkLst>
            <pc:docMk/>
            <pc:sldMk cId="1203018646" sldId="513"/>
            <ac:spMk id="7" creationId="{A7C5FE25-3BB6-469A-AB20-9EAFF2E64461}"/>
          </ac:spMkLst>
        </pc:spChg>
        <pc:spChg chg="del">
          <ac:chgData name="Derei Wu" userId="935b1b74ff2f2987" providerId="LiveId" clId="{ED6DE042-E01F-493C-87C7-096D08C4B1A2}" dt="2021-08-11T08:53:05.099" v="25" actId="478"/>
          <ac:spMkLst>
            <pc:docMk/>
            <pc:sldMk cId="1203018646" sldId="513"/>
            <ac:spMk id="9" creationId="{9A221062-E642-4B99-BC26-4D6E6C1DDCCD}"/>
          </ac:spMkLst>
        </pc:spChg>
        <pc:spChg chg="del">
          <ac:chgData name="Derei Wu" userId="935b1b74ff2f2987" providerId="LiveId" clId="{ED6DE042-E01F-493C-87C7-096D08C4B1A2}" dt="2021-08-11T08:53:05.099" v="25" actId="478"/>
          <ac:spMkLst>
            <pc:docMk/>
            <pc:sldMk cId="1203018646" sldId="513"/>
            <ac:spMk id="10" creationId="{FB90C96D-B9DC-4327-A649-DFF39F9F2DD7}"/>
          </ac:spMkLst>
        </pc:spChg>
        <pc:spChg chg="del">
          <ac:chgData name="Derei Wu" userId="935b1b74ff2f2987" providerId="LiveId" clId="{ED6DE042-E01F-493C-87C7-096D08C4B1A2}" dt="2021-08-11T08:53:06.571" v="26" actId="478"/>
          <ac:spMkLst>
            <pc:docMk/>
            <pc:sldMk cId="1203018646" sldId="513"/>
            <ac:spMk id="11" creationId="{2D95BDFC-E002-4EAB-866E-30E1BA22251B}"/>
          </ac:spMkLst>
        </pc:spChg>
        <pc:spChg chg="del">
          <ac:chgData name="Derei Wu" userId="935b1b74ff2f2987" providerId="LiveId" clId="{ED6DE042-E01F-493C-87C7-096D08C4B1A2}" dt="2021-08-11T08:53:05.099" v="25" actId="478"/>
          <ac:spMkLst>
            <pc:docMk/>
            <pc:sldMk cId="1203018646" sldId="513"/>
            <ac:spMk id="12" creationId="{3B42DFE1-76CB-44E5-9210-78402F544CBB}"/>
          </ac:spMkLst>
        </pc:spChg>
        <pc:spChg chg="del">
          <ac:chgData name="Derei Wu" userId="935b1b74ff2f2987" providerId="LiveId" clId="{ED6DE042-E01F-493C-87C7-096D08C4B1A2}" dt="2021-08-11T08:53:07.877" v="27" actId="478"/>
          <ac:spMkLst>
            <pc:docMk/>
            <pc:sldMk cId="1203018646" sldId="513"/>
            <ac:spMk id="13" creationId="{A4567671-6FD6-4AE0-A71A-3BA3C9AC8071}"/>
          </ac:spMkLst>
        </pc:spChg>
        <pc:grpChg chg="del">
          <ac:chgData name="Derei Wu" userId="935b1b74ff2f2987" providerId="LiveId" clId="{ED6DE042-E01F-493C-87C7-096D08C4B1A2}" dt="2021-08-11T08:53:01.381" v="22" actId="478"/>
          <ac:grpSpMkLst>
            <pc:docMk/>
            <pc:sldMk cId="1203018646" sldId="513"/>
            <ac:grpSpMk id="14" creationId="{3628665B-BCF9-486A-9B4A-DA519E28789C}"/>
          </ac:grpSpMkLst>
        </pc:grpChg>
        <pc:picChg chg="del">
          <ac:chgData name="Derei Wu" userId="935b1b74ff2f2987" providerId="LiveId" clId="{ED6DE042-E01F-493C-87C7-096D08C4B1A2}" dt="2021-08-11T08:53:02.198" v="23" actId="478"/>
          <ac:picMkLst>
            <pc:docMk/>
            <pc:sldMk cId="1203018646" sldId="513"/>
            <ac:picMk id="37" creationId="{6A2601BC-B4D1-4A8A-A914-A351C1B56A0B}"/>
          </ac:picMkLst>
        </pc:picChg>
        <pc:picChg chg="del">
          <ac:chgData name="Derei Wu" userId="935b1b74ff2f2987" providerId="LiveId" clId="{ED6DE042-E01F-493C-87C7-096D08C4B1A2}" dt="2021-08-11T08:53:02.983" v="24" actId="478"/>
          <ac:picMkLst>
            <pc:docMk/>
            <pc:sldMk cId="1203018646" sldId="513"/>
            <ac:picMk id="38" creationId="{D54C48AA-0662-47F3-B2FC-FCCB9F159E5E}"/>
          </ac:picMkLst>
        </pc:picChg>
      </pc:sldChg>
    </pc:docChg>
  </pc:docChgLst>
  <pc:docChgLst>
    <pc:chgData name="Derei Wu" userId="935b1b74ff2f2987" providerId="LiveId" clId="{096AA361-5A6D-46CE-9C1C-E2F251C453BB}"/>
    <pc:docChg chg="undo redo custSel addSld delSld modSld sldOrd">
      <pc:chgData name="Derei Wu" userId="935b1b74ff2f2987" providerId="LiveId" clId="{096AA361-5A6D-46CE-9C1C-E2F251C453BB}" dt="2021-05-25T00:53:14.841" v="452" actId="14100"/>
      <pc:docMkLst>
        <pc:docMk/>
      </pc:docMkLst>
      <pc:sldChg chg="del">
        <pc:chgData name="Derei Wu" userId="935b1b74ff2f2987" providerId="LiveId" clId="{096AA361-5A6D-46CE-9C1C-E2F251C453BB}" dt="2021-05-24T05:02:56.552" v="21" actId="47"/>
        <pc:sldMkLst>
          <pc:docMk/>
          <pc:sldMk cId="2897164670" sldId="258"/>
        </pc:sldMkLst>
      </pc:sldChg>
      <pc:sldChg chg="addSp delSp modSp mod">
        <pc:chgData name="Derei Wu" userId="935b1b74ff2f2987" providerId="LiveId" clId="{096AA361-5A6D-46CE-9C1C-E2F251C453BB}" dt="2021-05-24T07:17:25.482" v="300" actId="20577"/>
        <pc:sldMkLst>
          <pc:docMk/>
          <pc:sldMk cId="1852453233" sldId="281"/>
        </pc:sldMkLst>
        <pc:spChg chg="mod">
          <ac:chgData name="Derei Wu" userId="935b1b74ff2f2987" providerId="LiveId" clId="{096AA361-5A6D-46CE-9C1C-E2F251C453BB}" dt="2021-05-24T07:17:17.330" v="296" actId="20577"/>
          <ac:spMkLst>
            <pc:docMk/>
            <pc:sldMk cId="1852453233" sldId="281"/>
            <ac:spMk id="2" creationId="{A4B57805-CDFD-4943-8F27-B65F2C07FFD8}"/>
          </ac:spMkLst>
        </pc:spChg>
        <pc:spChg chg="add del mod">
          <ac:chgData name="Derei Wu" userId="935b1b74ff2f2987" providerId="LiveId" clId="{096AA361-5A6D-46CE-9C1C-E2F251C453BB}" dt="2021-05-24T06:07:09.244" v="171" actId="478"/>
          <ac:spMkLst>
            <pc:docMk/>
            <pc:sldMk cId="1852453233" sldId="281"/>
            <ac:spMk id="5" creationId="{45E2F6BB-43BF-46DD-B911-7CAAEE7625F0}"/>
          </ac:spMkLst>
        </pc:spChg>
        <pc:spChg chg="mod">
          <ac:chgData name="Derei Wu" userId="935b1b74ff2f2987" providerId="LiveId" clId="{096AA361-5A6D-46CE-9C1C-E2F251C453BB}" dt="2021-05-24T07:17:25.482" v="300" actId="20577"/>
          <ac:spMkLst>
            <pc:docMk/>
            <pc:sldMk cId="1852453233" sldId="281"/>
            <ac:spMk id="14" creationId="{6AEBF1A3-E155-4211-BD38-3B19B797930B}"/>
          </ac:spMkLst>
        </pc:spChg>
        <pc:spChg chg="add mod">
          <ac:chgData name="Derei Wu" userId="935b1b74ff2f2987" providerId="LiveId" clId="{096AA361-5A6D-46CE-9C1C-E2F251C453BB}" dt="2021-05-24T06:49:21.955" v="292" actId="1076"/>
          <ac:spMkLst>
            <pc:docMk/>
            <pc:sldMk cId="1852453233" sldId="281"/>
            <ac:spMk id="15" creationId="{3DE419F7-9CD6-4116-A2E0-49DBDA0E3C6C}"/>
          </ac:spMkLst>
        </pc:spChg>
        <pc:spChg chg="del">
          <ac:chgData name="Derei Wu" userId="935b1b74ff2f2987" providerId="LiveId" clId="{096AA361-5A6D-46CE-9C1C-E2F251C453BB}" dt="2021-05-24T06:06:23.547" v="148" actId="478"/>
          <ac:spMkLst>
            <pc:docMk/>
            <pc:sldMk cId="1852453233" sldId="281"/>
            <ac:spMk id="16" creationId="{25102EB1-F7D4-4B53-89BD-2E7914179106}"/>
          </ac:spMkLst>
        </pc:spChg>
        <pc:spChg chg="add mod">
          <ac:chgData name="Derei Wu" userId="935b1b74ff2f2987" providerId="LiveId" clId="{096AA361-5A6D-46CE-9C1C-E2F251C453BB}" dt="2021-05-24T06:49:07.465" v="269"/>
          <ac:spMkLst>
            <pc:docMk/>
            <pc:sldMk cId="1852453233" sldId="281"/>
            <ac:spMk id="17" creationId="{5E2DBA6A-2697-445D-854B-C93C2C377AC0}"/>
          </ac:spMkLst>
        </pc:spChg>
        <pc:spChg chg="del">
          <ac:chgData name="Derei Wu" userId="935b1b74ff2f2987" providerId="LiveId" clId="{096AA361-5A6D-46CE-9C1C-E2F251C453BB}" dt="2021-05-24T06:07:07.679" v="170" actId="478"/>
          <ac:spMkLst>
            <pc:docMk/>
            <pc:sldMk cId="1852453233" sldId="281"/>
            <ac:spMk id="18" creationId="{46F7BC8F-D926-4C72-9CE9-55FDFDDB3C17}"/>
          </ac:spMkLst>
        </pc:spChg>
      </pc:sldChg>
      <pc:sldChg chg="modSp del mod">
        <pc:chgData name="Derei Wu" userId="935b1b74ff2f2987" providerId="LiveId" clId="{096AA361-5A6D-46CE-9C1C-E2F251C453BB}" dt="2021-05-24T05:02:15.002" v="18" actId="47"/>
        <pc:sldMkLst>
          <pc:docMk/>
          <pc:sldMk cId="2526091792" sldId="282"/>
        </pc:sldMkLst>
        <pc:spChg chg="mod">
          <ac:chgData name="Derei Wu" userId="935b1b74ff2f2987" providerId="LiveId" clId="{096AA361-5A6D-46CE-9C1C-E2F251C453BB}" dt="2021-05-24T03:25:36.954" v="10" actId="14100"/>
          <ac:spMkLst>
            <pc:docMk/>
            <pc:sldMk cId="2526091792" sldId="282"/>
            <ac:spMk id="6" creationId="{F83CF0B8-5774-4474-8648-66DB480BE8C2}"/>
          </ac:spMkLst>
        </pc:spChg>
      </pc:sldChg>
      <pc:sldChg chg="addSp modSp mod">
        <pc:chgData name="Derei Wu" userId="935b1b74ff2f2987" providerId="LiveId" clId="{096AA361-5A6D-46CE-9C1C-E2F251C453BB}" dt="2021-05-24T08:02:57.835" v="345" actId="14100"/>
        <pc:sldMkLst>
          <pc:docMk/>
          <pc:sldMk cId="1634141280" sldId="411"/>
        </pc:sldMkLst>
        <pc:spChg chg="add mod">
          <ac:chgData name="Derei Wu" userId="935b1b74ff2f2987" providerId="LiveId" clId="{096AA361-5A6D-46CE-9C1C-E2F251C453BB}" dt="2021-05-24T08:02:57.835" v="345" actId="14100"/>
          <ac:spMkLst>
            <pc:docMk/>
            <pc:sldMk cId="1634141280" sldId="411"/>
            <ac:spMk id="2" creationId="{C01CF3C8-D8BE-4989-B0EE-214377157427}"/>
          </ac:spMkLst>
        </pc:spChg>
        <pc:spChg chg="add mod">
          <ac:chgData name="Derei Wu" userId="935b1b74ff2f2987" providerId="LiveId" clId="{096AA361-5A6D-46CE-9C1C-E2F251C453BB}" dt="2021-05-24T08:02:45.337" v="344" actId="1037"/>
          <ac:spMkLst>
            <pc:docMk/>
            <pc:sldMk cId="1634141280" sldId="411"/>
            <ac:spMk id="3" creationId="{32B88BAC-BA08-4A95-9850-076BD6AE4068}"/>
          </ac:spMkLst>
        </pc:spChg>
        <pc:spChg chg="mod">
          <ac:chgData name="Derei Wu" userId="935b1b74ff2f2987" providerId="LiveId" clId="{096AA361-5A6D-46CE-9C1C-E2F251C453BB}" dt="2021-05-24T03:24:52.108" v="7" actId="114"/>
          <ac:spMkLst>
            <pc:docMk/>
            <pc:sldMk cId="1634141280" sldId="411"/>
            <ac:spMk id="7" creationId="{A29EE43C-3472-40A4-91FE-F2017E23B71C}"/>
          </ac:spMkLst>
        </pc:spChg>
      </pc:sldChg>
      <pc:sldChg chg="addSp modSp mod">
        <pc:chgData name="Derei Wu" userId="935b1b74ff2f2987" providerId="LiveId" clId="{096AA361-5A6D-46CE-9C1C-E2F251C453BB}" dt="2021-05-24T08:03:51.082" v="369" actId="1036"/>
        <pc:sldMkLst>
          <pc:docMk/>
          <pc:sldMk cId="4291767262" sldId="412"/>
        </pc:sldMkLst>
        <pc:spChg chg="mod">
          <ac:chgData name="Derei Wu" userId="935b1b74ff2f2987" providerId="LiveId" clId="{096AA361-5A6D-46CE-9C1C-E2F251C453BB}" dt="2021-05-24T03:24:49.172" v="6" actId="114"/>
          <ac:spMkLst>
            <pc:docMk/>
            <pc:sldMk cId="4291767262" sldId="412"/>
            <ac:spMk id="4" creationId="{61D9CA6B-F324-4D06-BAF4-4FACE9CB098F}"/>
          </ac:spMkLst>
        </pc:spChg>
        <pc:spChg chg="add mod">
          <ac:chgData name="Derei Wu" userId="935b1b74ff2f2987" providerId="LiveId" clId="{096AA361-5A6D-46CE-9C1C-E2F251C453BB}" dt="2021-05-24T08:03:30.753" v="354" actId="1035"/>
          <ac:spMkLst>
            <pc:docMk/>
            <pc:sldMk cId="4291767262" sldId="412"/>
            <ac:spMk id="6" creationId="{A3A66660-5F51-4B02-AF96-F042A5834B52}"/>
          </ac:spMkLst>
        </pc:spChg>
        <pc:spChg chg="add mod">
          <ac:chgData name="Derei Wu" userId="935b1b74ff2f2987" providerId="LiveId" clId="{096AA361-5A6D-46CE-9C1C-E2F251C453BB}" dt="2021-05-24T08:03:51.082" v="369" actId="1036"/>
          <ac:spMkLst>
            <pc:docMk/>
            <pc:sldMk cId="4291767262" sldId="412"/>
            <ac:spMk id="7" creationId="{42705EEA-E18C-49BD-A4E1-695DC5BA6195}"/>
          </ac:spMkLst>
        </pc:spChg>
      </pc:sldChg>
      <pc:sldChg chg="addSp delSp modSp mod ord">
        <pc:chgData name="Derei Wu" userId="935b1b74ff2f2987" providerId="LiveId" clId="{096AA361-5A6D-46CE-9C1C-E2F251C453BB}" dt="2021-05-24T08:05:16.604" v="422" actId="20577"/>
        <pc:sldMkLst>
          <pc:docMk/>
          <pc:sldMk cId="2461855473" sldId="413"/>
        </pc:sldMkLst>
        <pc:spChg chg="add del mod">
          <ac:chgData name="Derei Wu" userId="935b1b74ff2f2987" providerId="LiveId" clId="{096AA361-5A6D-46CE-9C1C-E2F251C453BB}" dt="2021-05-24T06:19:10.213" v="257" actId="478"/>
          <ac:spMkLst>
            <pc:docMk/>
            <pc:sldMk cId="2461855473" sldId="413"/>
            <ac:spMk id="3" creationId="{273A7C51-A62E-4149-8E94-7DDFA439D43D}"/>
          </ac:spMkLst>
        </pc:spChg>
        <pc:spChg chg="mod">
          <ac:chgData name="Derei Wu" userId="935b1b74ff2f2987" providerId="LiveId" clId="{096AA361-5A6D-46CE-9C1C-E2F251C453BB}" dt="2021-05-24T08:05:16.604" v="422" actId="20577"/>
          <ac:spMkLst>
            <pc:docMk/>
            <pc:sldMk cId="2461855473" sldId="413"/>
            <ac:spMk id="4" creationId="{FFF15222-A4BC-47D7-8147-A99131964AAC}"/>
          </ac:spMkLst>
        </pc:spChg>
        <pc:spChg chg="add del mod">
          <ac:chgData name="Derei Wu" userId="935b1b74ff2f2987" providerId="LiveId" clId="{096AA361-5A6D-46CE-9C1C-E2F251C453BB}" dt="2021-05-24T06:19:08.997" v="256" actId="478"/>
          <ac:spMkLst>
            <pc:docMk/>
            <pc:sldMk cId="2461855473" sldId="413"/>
            <ac:spMk id="6" creationId="{D7823F56-7F5D-43A4-AEE8-2452775C6CFC}"/>
          </ac:spMkLst>
        </pc:spChg>
        <pc:spChg chg="add mod">
          <ac:chgData name="Derei Wu" userId="935b1b74ff2f2987" providerId="LiveId" clId="{096AA361-5A6D-46CE-9C1C-E2F251C453BB}" dt="2021-05-24T08:05:13.960" v="416" actId="1038"/>
          <ac:spMkLst>
            <pc:docMk/>
            <pc:sldMk cId="2461855473" sldId="413"/>
            <ac:spMk id="7" creationId="{1E88A4C4-97B2-4854-A012-CAFEFC201B65}"/>
          </ac:spMkLst>
        </pc:spChg>
        <pc:spChg chg="add mod">
          <ac:chgData name="Derei Wu" userId="935b1b74ff2f2987" providerId="LiveId" clId="{096AA361-5A6D-46CE-9C1C-E2F251C453BB}" dt="2021-05-24T08:05:13.960" v="416" actId="1038"/>
          <ac:spMkLst>
            <pc:docMk/>
            <pc:sldMk cId="2461855473" sldId="413"/>
            <ac:spMk id="8" creationId="{431CF0C0-E636-424A-927E-8F48BB87C10B}"/>
          </ac:spMkLst>
        </pc:spChg>
        <pc:picChg chg="mod">
          <ac:chgData name="Derei Wu" userId="935b1b74ff2f2987" providerId="LiveId" clId="{096AA361-5A6D-46CE-9C1C-E2F251C453BB}" dt="2021-05-24T08:05:13.960" v="416" actId="1038"/>
          <ac:picMkLst>
            <pc:docMk/>
            <pc:sldMk cId="2461855473" sldId="413"/>
            <ac:picMk id="5" creationId="{7E8B0080-E636-4227-B5F4-D53FF4802629}"/>
          </ac:picMkLst>
        </pc:picChg>
      </pc:sldChg>
      <pc:sldChg chg="addSp delSp modSp mod">
        <pc:chgData name="Derei Wu" userId="935b1b74ff2f2987" providerId="LiveId" clId="{096AA361-5A6D-46CE-9C1C-E2F251C453BB}" dt="2021-05-24T06:49:36.883" v="293" actId="20577"/>
        <pc:sldMkLst>
          <pc:docMk/>
          <pc:sldMk cId="4127656194" sldId="500"/>
        </pc:sldMkLst>
        <pc:spChg chg="mod">
          <ac:chgData name="Derei Wu" userId="935b1b74ff2f2987" providerId="LiveId" clId="{096AA361-5A6D-46CE-9C1C-E2F251C453BB}" dt="2021-05-24T06:05:33.447" v="132" actId="1036"/>
          <ac:spMkLst>
            <pc:docMk/>
            <pc:sldMk cId="4127656194" sldId="500"/>
            <ac:spMk id="2" creationId="{F6676D08-B0B5-43AA-AC9C-2FA26D63DFDB}"/>
          </ac:spMkLst>
        </pc:spChg>
        <pc:spChg chg="add del mod">
          <ac:chgData name="Derei Wu" userId="935b1b74ff2f2987" providerId="LiveId" clId="{096AA361-5A6D-46CE-9C1C-E2F251C453BB}" dt="2021-05-24T06:49:05.316" v="268" actId="478"/>
          <ac:spMkLst>
            <pc:docMk/>
            <pc:sldMk cId="4127656194" sldId="500"/>
            <ac:spMk id="4" creationId="{7024C27E-DF91-48CF-8D9C-A2ABADCC7BEC}"/>
          </ac:spMkLst>
        </pc:spChg>
        <pc:spChg chg="del">
          <ac:chgData name="Derei Wu" userId="935b1b74ff2f2987" providerId="LiveId" clId="{096AA361-5A6D-46CE-9C1C-E2F251C453BB}" dt="2021-05-24T06:49:01.900" v="267" actId="21"/>
          <ac:spMkLst>
            <pc:docMk/>
            <pc:sldMk cId="4127656194" sldId="500"/>
            <ac:spMk id="11" creationId="{BF50B14A-9F87-4A7A-AE9C-AD52BBD8DBB4}"/>
          </ac:spMkLst>
        </pc:spChg>
        <pc:spChg chg="mod">
          <ac:chgData name="Derei Wu" userId="935b1b74ff2f2987" providerId="LiveId" clId="{096AA361-5A6D-46CE-9C1C-E2F251C453BB}" dt="2021-05-24T06:49:36.883" v="293" actId="20577"/>
          <ac:spMkLst>
            <pc:docMk/>
            <pc:sldMk cId="4127656194" sldId="500"/>
            <ac:spMk id="14" creationId="{936FA1D3-5B45-40AB-A225-E4C97C912477}"/>
          </ac:spMkLst>
        </pc:spChg>
        <pc:spChg chg="mod">
          <ac:chgData name="Derei Wu" userId="935b1b74ff2f2987" providerId="LiveId" clId="{096AA361-5A6D-46CE-9C1C-E2F251C453BB}" dt="2021-05-24T06:05:33.447" v="132" actId="1036"/>
          <ac:spMkLst>
            <pc:docMk/>
            <pc:sldMk cId="4127656194" sldId="500"/>
            <ac:spMk id="16" creationId="{583FAA93-F4B9-4A9C-AE9A-8D47776655D7}"/>
          </ac:spMkLst>
        </pc:spChg>
        <pc:spChg chg="mod">
          <ac:chgData name="Derei Wu" userId="935b1b74ff2f2987" providerId="LiveId" clId="{096AA361-5A6D-46CE-9C1C-E2F251C453BB}" dt="2021-05-24T06:05:33.447" v="132" actId="1036"/>
          <ac:spMkLst>
            <pc:docMk/>
            <pc:sldMk cId="4127656194" sldId="500"/>
            <ac:spMk id="17" creationId="{A5235B9F-B0BD-4D4A-A6D2-6E525593F67C}"/>
          </ac:spMkLst>
        </pc:spChg>
        <pc:picChg chg="mod">
          <ac:chgData name="Derei Wu" userId="935b1b74ff2f2987" providerId="LiveId" clId="{096AA361-5A6D-46CE-9C1C-E2F251C453BB}" dt="2021-05-24T06:05:33.447" v="132" actId="1036"/>
          <ac:picMkLst>
            <pc:docMk/>
            <pc:sldMk cId="4127656194" sldId="500"/>
            <ac:picMk id="8" creationId="{1AA3361E-A4F8-4522-8C94-0345F1668E9D}"/>
          </ac:picMkLst>
        </pc:picChg>
        <pc:picChg chg="mod">
          <ac:chgData name="Derei Wu" userId="935b1b74ff2f2987" providerId="LiveId" clId="{096AA361-5A6D-46CE-9C1C-E2F251C453BB}" dt="2021-05-24T06:05:33.447" v="132" actId="1036"/>
          <ac:picMkLst>
            <pc:docMk/>
            <pc:sldMk cId="4127656194" sldId="500"/>
            <ac:picMk id="9" creationId="{C672FCDA-FAAC-4CEE-B78C-BD9D4188F436}"/>
          </ac:picMkLst>
        </pc:picChg>
        <pc:picChg chg="mod">
          <ac:chgData name="Derei Wu" userId="935b1b74ff2f2987" providerId="LiveId" clId="{096AA361-5A6D-46CE-9C1C-E2F251C453BB}" dt="2021-05-24T06:05:33.447" v="132" actId="1036"/>
          <ac:picMkLst>
            <pc:docMk/>
            <pc:sldMk cId="4127656194" sldId="500"/>
            <ac:picMk id="10" creationId="{B7B27E1E-5141-40C1-A1D7-88A024370D37}"/>
          </ac:picMkLst>
        </pc:picChg>
      </pc:sldChg>
      <pc:sldChg chg="modSp mod">
        <pc:chgData name="Derei Wu" userId="935b1b74ff2f2987" providerId="LiveId" clId="{096AA361-5A6D-46CE-9C1C-E2F251C453BB}" dt="2021-05-24T06:49:43.150" v="295" actId="114"/>
        <pc:sldMkLst>
          <pc:docMk/>
          <pc:sldMk cId="903283632" sldId="501"/>
        </pc:sldMkLst>
        <pc:spChg chg="mod">
          <ac:chgData name="Derei Wu" userId="935b1b74ff2f2987" providerId="LiveId" clId="{096AA361-5A6D-46CE-9C1C-E2F251C453BB}" dt="2021-05-24T06:49:43.150" v="295" actId="114"/>
          <ac:spMkLst>
            <pc:docMk/>
            <pc:sldMk cId="903283632" sldId="501"/>
            <ac:spMk id="6" creationId="{D7B9413C-74CA-464E-BB8F-648F6C0D1664}"/>
          </ac:spMkLst>
        </pc:spChg>
      </pc:sldChg>
      <pc:sldChg chg="modSp mod">
        <pc:chgData name="Derei Wu" userId="935b1b74ff2f2987" providerId="LiveId" clId="{096AA361-5A6D-46CE-9C1C-E2F251C453BB}" dt="2021-05-24T06:32:37.423" v="266" actId="1076"/>
        <pc:sldMkLst>
          <pc:docMk/>
          <pc:sldMk cId="1359657506" sldId="502"/>
        </pc:sldMkLst>
        <pc:spChg chg="mod">
          <ac:chgData name="Derei Wu" userId="935b1b74ff2f2987" providerId="LiveId" clId="{096AA361-5A6D-46CE-9C1C-E2F251C453BB}" dt="2021-05-24T06:32:37.423" v="266" actId="1076"/>
          <ac:spMkLst>
            <pc:docMk/>
            <pc:sldMk cId="1359657506" sldId="502"/>
            <ac:spMk id="2" creationId="{613740C7-D1FB-435B-B2E3-6644167D14FC}"/>
          </ac:spMkLst>
        </pc:spChg>
      </pc:sldChg>
      <pc:sldChg chg="del">
        <pc:chgData name="Derei Wu" userId="935b1b74ff2f2987" providerId="LiveId" clId="{096AA361-5A6D-46CE-9C1C-E2F251C453BB}" dt="2021-05-24T05:02:55.082" v="20" actId="47"/>
        <pc:sldMkLst>
          <pc:docMk/>
          <pc:sldMk cId="1409046022" sldId="506"/>
        </pc:sldMkLst>
      </pc:sldChg>
      <pc:sldChg chg="del">
        <pc:chgData name="Derei Wu" userId="935b1b74ff2f2987" providerId="LiveId" clId="{096AA361-5A6D-46CE-9C1C-E2F251C453BB}" dt="2021-05-24T05:03:28.807" v="22" actId="2696"/>
        <pc:sldMkLst>
          <pc:docMk/>
          <pc:sldMk cId="177023995" sldId="509"/>
        </pc:sldMkLst>
      </pc:sldChg>
      <pc:sldChg chg="addSp delSp modSp add mod">
        <pc:chgData name="Derei Wu" userId="935b1b74ff2f2987" providerId="LiveId" clId="{096AA361-5A6D-46CE-9C1C-E2F251C453BB}" dt="2021-05-24T06:25:22.347" v="261" actId="313"/>
        <pc:sldMkLst>
          <pc:docMk/>
          <pc:sldMk cId="1754662003" sldId="509"/>
        </pc:sldMkLst>
        <pc:spChg chg="add del mod">
          <ac:chgData name="Derei Wu" userId="935b1b74ff2f2987" providerId="LiveId" clId="{096AA361-5A6D-46CE-9C1C-E2F251C453BB}" dt="2021-05-24T05:03:46.372" v="26" actId="478"/>
          <ac:spMkLst>
            <pc:docMk/>
            <pc:sldMk cId="1754662003" sldId="509"/>
            <ac:spMk id="3" creationId="{3F63D656-D631-4C14-BB5E-20B5FBEB3B64}"/>
          </ac:spMkLst>
        </pc:spChg>
        <pc:spChg chg="del">
          <ac:chgData name="Derei Wu" userId="935b1b74ff2f2987" providerId="LiveId" clId="{096AA361-5A6D-46CE-9C1C-E2F251C453BB}" dt="2021-05-24T05:03:45.073" v="25" actId="478"/>
          <ac:spMkLst>
            <pc:docMk/>
            <pc:sldMk cId="1754662003" sldId="509"/>
            <ac:spMk id="16" creationId="{6DB06359-E012-49B5-AB6C-43911B332EF7}"/>
          </ac:spMkLst>
        </pc:spChg>
        <pc:spChg chg="del mod">
          <ac:chgData name="Derei Wu" userId="935b1b74ff2f2987" providerId="LiveId" clId="{096AA361-5A6D-46CE-9C1C-E2F251C453BB}" dt="2021-05-24T05:03:52.075" v="28" actId="478"/>
          <ac:spMkLst>
            <pc:docMk/>
            <pc:sldMk cId="1754662003" sldId="509"/>
            <ac:spMk id="18" creationId="{3BBE9420-9653-401F-B56D-2B6796EBF23B}"/>
          </ac:spMkLst>
        </pc:spChg>
        <pc:spChg chg="add mod">
          <ac:chgData name="Derei Wu" userId="935b1b74ff2f2987" providerId="LiveId" clId="{096AA361-5A6D-46CE-9C1C-E2F251C453BB}" dt="2021-05-24T06:25:22.347" v="261" actId="313"/>
          <ac:spMkLst>
            <pc:docMk/>
            <pc:sldMk cId="1754662003" sldId="509"/>
            <ac:spMk id="19" creationId="{06FE688C-23FE-4026-B48F-CF2F49AA760F}"/>
          </ac:spMkLst>
        </pc:spChg>
        <pc:spChg chg="add mod">
          <ac:chgData name="Derei Wu" userId="935b1b74ff2f2987" providerId="LiveId" clId="{096AA361-5A6D-46CE-9C1C-E2F251C453BB}" dt="2021-05-24T06:15:00.832" v="237" actId="20577"/>
          <ac:spMkLst>
            <pc:docMk/>
            <pc:sldMk cId="1754662003" sldId="509"/>
            <ac:spMk id="20" creationId="{E6C0F36F-C33D-40C4-ACD5-F7979E3FFFC3}"/>
          </ac:spMkLst>
        </pc:spChg>
      </pc:sldChg>
      <pc:sldChg chg="del">
        <pc:chgData name="Derei Wu" userId="935b1b74ff2f2987" providerId="LiveId" clId="{096AA361-5A6D-46CE-9C1C-E2F251C453BB}" dt="2021-05-24T05:02:51.396" v="19" actId="47"/>
        <pc:sldMkLst>
          <pc:docMk/>
          <pc:sldMk cId="777699264" sldId="511"/>
        </pc:sldMkLst>
      </pc:sldChg>
      <pc:sldChg chg="addSp delSp modSp mod">
        <pc:chgData name="Derei Wu" userId="935b1b74ff2f2987" providerId="LiveId" clId="{096AA361-5A6D-46CE-9C1C-E2F251C453BB}" dt="2021-05-24T06:08:37.323" v="184" actId="478"/>
        <pc:sldMkLst>
          <pc:docMk/>
          <pc:sldMk cId="2292570021" sldId="512"/>
        </pc:sldMkLst>
        <pc:spChg chg="add del mod">
          <ac:chgData name="Derei Wu" userId="935b1b74ff2f2987" providerId="LiveId" clId="{096AA361-5A6D-46CE-9C1C-E2F251C453BB}" dt="2021-05-24T05:50:47.332" v="91" actId="478"/>
          <ac:spMkLst>
            <pc:docMk/>
            <pc:sldMk cId="2292570021" sldId="512"/>
            <ac:spMk id="4" creationId="{A93EF011-06F2-4109-9F58-29B2A79E41C6}"/>
          </ac:spMkLst>
        </pc:spChg>
        <pc:spChg chg="add del mod">
          <ac:chgData name="Derei Wu" userId="935b1b74ff2f2987" providerId="LiveId" clId="{096AA361-5A6D-46CE-9C1C-E2F251C453BB}" dt="2021-05-24T05:50:43.662" v="89" actId="478"/>
          <ac:spMkLst>
            <pc:docMk/>
            <pc:sldMk cId="2292570021" sldId="512"/>
            <ac:spMk id="8" creationId="{B03C42F6-6E22-4EAA-93A2-3A1D1348FC40}"/>
          </ac:spMkLst>
        </pc:spChg>
        <pc:spChg chg="mod">
          <ac:chgData name="Derei Wu" userId="935b1b74ff2f2987" providerId="LiveId" clId="{096AA361-5A6D-46CE-9C1C-E2F251C453BB}" dt="2021-05-24T05:50:54.313" v="114" actId="1036"/>
          <ac:spMkLst>
            <pc:docMk/>
            <pc:sldMk cId="2292570021" sldId="512"/>
            <ac:spMk id="13" creationId="{49420599-CEE9-412D-AE2E-F6EAC3525F8A}"/>
          </ac:spMkLst>
        </pc:spChg>
        <pc:spChg chg="add del mod">
          <ac:chgData name="Derei Wu" userId="935b1b74ff2f2987" providerId="LiveId" clId="{096AA361-5A6D-46CE-9C1C-E2F251C453BB}" dt="2021-05-24T06:08:37.323" v="184" actId="478"/>
          <ac:spMkLst>
            <pc:docMk/>
            <pc:sldMk cId="2292570021" sldId="512"/>
            <ac:spMk id="14" creationId="{3C21593B-8C96-42F2-A295-9695BC02250A}"/>
          </ac:spMkLst>
        </pc:spChg>
        <pc:spChg chg="mod">
          <ac:chgData name="Derei Wu" userId="935b1b74ff2f2987" providerId="LiveId" clId="{096AA361-5A6D-46CE-9C1C-E2F251C453BB}" dt="2021-05-24T05:50:54.313" v="114" actId="1036"/>
          <ac:spMkLst>
            <pc:docMk/>
            <pc:sldMk cId="2292570021" sldId="512"/>
            <ac:spMk id="16" creationId="{5020D69A-8B15-4992-BAB5-7587533C76B0}"/>
          </ac:spMkLst>
        </pc:spChg>
        <pc:spChg chg="mod">
          <ac:chgData name="Derei Wu" userId="935b1b74ff2f2987" providerId="LiveId" clId="{096AA361-5A6D-46CE-9C1C-E2F251C453BB}" dt="2021-05-24T05:50:54.313" v="114" actId="1036"/>
          <ac:spMkLst>
            <pc:docMk/>
            <pc:sldMk cId="2292570021" sldId="512"/>
            <ac:spMk id="17" creationId="{D1E5EEB5-F810-4FE8-97C3-1864E2E616D8}"/>
          </ac:spMkLst>
        </pc:spChg>
        <pc:picChg chg="mod">
          <ac:chgData name="Derei Wu" userId="935b1b74ff2f2987" providerId="LiveId" clId="{096AA361-5A6D-46CE-9C1C-E2F251C453BB}" dt="2021-05-24T05:50:54.313" v="114" actId="1036"/>
          <ac:picMkLst>
            <pc:docMk/>
            <pc:sldMk cId="2292570021" sldId="512"/>
            <ac:picMk id="3" creationId="{2AF651F2-01C5-46B5-AF3A-9430260F9800}"/>
          </ac:picMkLst>
        </pc:picChg>
        <pc:picChg chg="mod">
          <ac:chgData name="Derei Wu" userId="935b1b74ff2f2987" providerId="LiveId" clId="{096AA361-5A6D-46CE-9C1C-E2F251C453BB}" dt="2021-05-24T05:50:54.313" v="114" actId="1036"/>
          <ac:picMkLst>
            <pc:docMk/>
            <pc:sldMk cId="2292570021" sldId="512"/>
            <ac:picMk id="11" creationId="{B614A086-D9CE-40F1-A52D-BAE159F74BFB}"/>
          </ac:picMkLst>
        </pc:picChg>
        <pc:picChg chg="mod">
          <ac:chgData name="Derei Wu" userId="935b1b74ff2f2987" providerId="LiveId" clId="{096AA361-5A6D-46CE-9C1C-E2F251C453BB}" dt="2021-05-24T05:50:54.313" v="114" actId="1036"/>
          <ac:picMkLst>
            <pc:docMk/>
            <pc:sldMk cId="2292570021" sldId="512"/>
            <ac:picMk id="12" creationId="{BBA10156-3E40-4D68-99E0-832A3C793077}"/>
          </ac:picMkLst>
        </pc:picChg>
      </pc:sldChg>
      <pc:sldChg chg="addSp delSp modSp new mod ord">
        <pc:chgData name="Derei Wu" userId="935b1b74ff2f2987" providerId="LiveId" clId="{096AA361-5A6D-46CE-9C1C-E2F251C453BB}" dt="2021-05-25T00:53:14.841" v="452" actId="14100"/>
        <pc:sldMkLst>
          <pc:docMk/>
          <pc:sldMk cId="1203018646" sldId="513"/>
        </pc:sldMkLst>
        <pc:spChg chg="del">
          <ac:chgData name="Derei Wu" userId="935b1b74ff2f2987" providerId="LiveId" clId="{096AA361-5A6D-46CE-9C1C-E2F251C453BB}" dt="2021-05-24T03:26:02.063" v="12" actId="478"/>
          <ac:spMkLst>
            <pc:docMk/>
            <pc:sldMk cId="1203018646" sldId="513"/>
            <ac:spMk id="2" creationId="{EBFD4B74-5727-42F2-AC46-BBC86F662101}"/>
          </ac:spMkLst>
        </pc:spChg>
        <pc:spChg chg="del">
          <ac:chgData name="Derei Wu" userId="935b1b74ff2f2987" providerId="LiveId" clId="{096AA361-5A6D-46CE-9C1C-E2F251C453BB}" dt="2021-05-24T03:26:02.063" v="12" actId="478"/>
          <ac:spMkLst>
            <pc:docMk/>
            <pc:sldMk cId="1203018646" sldId="513"/>
            <ac:spMk id="3" creationId="{E50F5617-E9AC-4D04-8BB7-30C65733896A}"/>
          </ac:spMkLst>
        </pc:spChg>
        <pc:spChg chg="add mod">
          <ac:chgData name="Derei Wu" userId="935b1b74ff2f2987" providerId="LiveId" clId="{096AA361-5A6D-46CE-9C1C-E2F251C453BB}" dt="2021-05-24T06:14:34.515" v="233" actId="1076"/>
          <ac:spMkLst>
            <pc:docMk/>
            <pc:sldMk cId="1203018646" sldId="513"/>
            <ac:spMk id="7" creationId="{A7C5FE25-3BB6-469A-AB20-9EAFF2E64461}"/>
          </ac:spMkLst>
        </pc:spChg>
        <pc:spChg chg="add mod">
          <ac:chgData name="Derei Wu" userId="935b1b74ff2f2987" providerId="LiveId" clId="{096AA361-5A6D-46CE-9C1C-E2F251C453BB}" dt="2021-05-24T08:09:47.257" v="436" actId="1076"/>
          <ac:spMkLst>
            <pc:docMk/>
            <pc:sldMk cId="1203018646" sldId="513"/>
            <ac:spMk id="9" creationId="{9A221062-E642-4B99-BC26-4D6E6C1DDCCD}"/>
          </ac:spMkLst>
        </pc:spChg>
        <pc:spChg chg="add mod">
          <ac:chgData name="Derei Wu" userId="935b1b74ff2f2987" providerId="LiveId" clId="{096AA361-5A6D-46CE-9C1C-E2F251C453BB}" dt="2021-05-24T08:09:45.440" v="435" actId="1076"/>
          <ac:spMkLst>
            <pc:docMk/>
            <pc:sldMk cId="1203018646" sldId="513"/>
            <ac:spMk id="10" creationId="{FB90C96D-B9DC-4327-A649-DFF39F9F2DD7}"/>
          </ac:spMkLst>
        </pc:spChg>
        <pc:spChg chg="add mod">
          <ac:chgData name="Derei Wu" userId="935b1b74ff2f2987" providerId="LiveId" clId="{096AA361-5A6D-46CE-9C1C-E2F251C453BB}" dt="2021-05-24T08:09:41.559" v="434" actId="20577"/>
          <ac:spMkLst>
            <pc:docMk/>
            <pc:sldMk cId="1203018646" sldId="513"/>
            <ac:spMk id="11" creationId="{2D95BDFC-E002-4EAB-866E-30E1BA22251B}"/>
          </ac:spMkLst>
        </pc:spChg>
        <pc:spChg chg="add mod">
          <ac:chgData name="Derei Wu" userId="935b1b74ff2f2987" providerId="LiveId" clId="{096AA361-5A6D-46CE-9C1C-E2F251C453BB}" dt="2021-05-25T00:53:03.141" v="442" actId="1076"/>
          <ac:spMkLst>
            <pc:docMk/>
            <pc:sldMk cId="1203018646" sldId="513"/>
            <ac:spMk id="12" creationId="{3B42DFE1-76CB-44E5-9210-78402F544CBB}"/>
          </ac:spMkLst>
        </pc:spChg>
        <pc:spChg chg="add mod">
          <ac:chgData name="Derei Wu" userId="935b1b74ff2f2987" providerId="LiveId" clId="{096AA361-5A6D-46CE-9C1C-E2F251C453BB}" dt="2021-05-25T00:53:14.841" v="452" actId="14100"/>
          <ac:spMkLst>
            <pc:docMk/>
            <pc:sldMk cId="1203018646" sldId="513"/>
            <ac:spMk id="13" creationId="{A4567671-6FD6-4AE0-A71A-3BA3C9AC8071}"/>
          </ac:spMkLst>
        </pc:spChg>
        <pc:picChg chg="add mod">
          <ac:chgData name="Derei Wu" userId="935b1b74ff2f2987" providerId="LiveId" clId="{096AA361-5A6D-46CE-9C1C-E2F251C453BB}" dt="2021-05-24T05:07:39.851" v="60" actId="1076"/>
          <ac:picMkLst>
            <pc:docMk/>
            <pc:sldMk cId="1203018646" sldId="513"/>
            <ac:picMk id="3" creationId="{816DD011-8D42-45A7-AA87-D409F06A271C}"/>
          </ac:picMkLst>
        </pc:picChg>
        <pc:picChg chg="add mod">
          <ac:chgData name="Derei Wu" userId="935b1b74ff2f2987" providerId="LiveId" clId="{096AA361-5A6D-46CE-9C1C-E2F251C453BB}" dt="2021-05-24T05:07:16.489" v="45" actId="1076"/>
          <ac:picMkLst>
            <pc:docMk/>
            <pc:sldMk cId="1203018646" sldId="513"/>
            <ac:picMk id="5" creationId="{075FAACE-B6BC-4B07-BE7B-955F6083196D}"/>
          </ac:picMkLst>
        </pc:picChg>
        <pc:picChg chg="add mod">
          <ac:chgData name="Derei Wu" userId="935b1b74ff2f2987" providerId="LiveId" clId="{096AA361-5A6D-46CE-9C1C-E2F251C453BB}" dt="2021-05-24T05:07:39.851" v="60" actId="1076"/>
          <ac:picMkLst>
            <pc:docMk/>
            <pc:sldMk cId="1203018646" sldId="513"/>
            <ac:picMk id="6" creationId="{52E5FC59-709E-4FA4-BE4D-03EFB25FFEAB}"/>
          </ac:picMkLst>
        </pc:picChg>
      </pc:sldChg>
    </pc:docChg>
  </pc:docChgLst>
  <pc:docChgLst>
    <pc:chgData name="Derei Wu" userId="935b1b74ff2f2987" providerId="LiveId" clId="{886393CD-F2F4-42AB-A379-59B3225C7DE2}"/>
    <pc:docChg chg="custSel modSld">
      <pc:chgData name="Derei Wu" userId="935b1b74ff2f2987" providerId="LiveId" clId="{886393CD-F2F4-42AB-A379-59B3225C7DE2}" dt="2021-05-30T06:41:03.006" v="22" actId="1035"/>
      <pc:docMkLst>
        <pc:docMk/>
      </pc:docMkLst>
      <pc:sldChg chg="addSp delSp modSp mod">
        <pc:chgData name="Derei Wu" userId="935b1b74ff2f2987" providerId="LiveId" clId="{886393CD-F2F4-42AB-A379-59B3225C7DE2}" dt="2021-05-30T06:41:03.006" v="22" actId="1035"/>
        <pc:sldMkLst>
          <pc:docMk/>
          <pc:sldMk cId="1203018646" sldId="513"/>
        </pc:sldMkLst>
        <pc:picChg chg="del">
          <ac:chgData name="Derei Wu" userId="935b1b74ff2f2987" providerId="LiveId" clId="{886393CD-F2F4-42AB-A379-59B3225C7DE2}" dt="2021-05-30T06:39:21.821" v="1" actId="478"/>
          <ac:picMkLst>
            <pc:docMk/>
            <pc:sldMk cId="1203018646" sldId="513"/>
            <ac:picMk id="3" creationId="{816DD011-8D42-45A7-AA87-D409F06A271C}"/>
          </ac:picMkLst>
        </pc:picChg>
        <pc:picChg chg="del">
          <ac:chgData name="Derei Wu" userId="935b1b74ff2f2987" providerId="LiveId" clId="{886393CD-F2F4-42AB-A379-59B3225C7DE2}" dt="2021-05-30T06:39:21.010" v="0" actId="478"/>
          <ac:picMkLst>
            <pc:docMk/>
            <pc:sldMk cId="1203018646" sldId="513"/>
            <ac:picMk id="6" creationId="{52E5FC59-709E-4FA4-BE4D-03EFB25FFEAB}"/>
          </ac:picMkLst>
        </pc:picChg>
        <pc:picChg chg="add mod">
          <ac:chgData name="Derei Wu" userId="935b1b74ff2f2987" providerId="LiveId" clId="{886393CD-F2F4-42AB-A379-59B3225C7DE2}" dt="2021-05-30T06:41:03.006" v="22" actId="1035"/>
          <ac:picMkLst>
            <pc:docMk/>
            <pc:sldMk cId="1203018646" sldId="513"/>
            <ac:picMk id="37" creationId="{6A2601BC-B4D1-4A8A-A914-A351C1B56A0B}"/>
          </ac:picMkLst>
        </pc:picChg>
        <pc:picChg chg="add mod">
          <ac:chgData name="Derei Wu" userId="935b1b74ff2f2987" providerId="LiveId" clId="{886393CD-F2F4-42AB-A379-59B3225C7DE2}" dt="2021-05-30T06:40:34.958" v="14" actId="1076"/>
          <ac:picMkLst>
            <pc:docMk/>
            <pc:sldMk cId="1203018646" sldId="513"/>
            <ac:picMk id="38" creationId="{D54C48AA-0662-47F3-B2FC-FCCB9F159E5E}"/>
          </ac:picMkLst>
        </pc:picChg>
      </pc:sldChg>
    </pc:docChg>
  </pc:docChgLst>
  <pc:docChgLst>
    <pc:chgData name="Derei Wu" userId="935b1b74ff2f2987" providerId="LiveId" clId="{C34CCE27-BCC5-4A85-B460-69DD6C594E7D}"/>
    <pc:docChg chg="undo redo custSel addSld delSld modSld">
      <pc:chgData name="Derei Wu" userId="935b1b74ff2f2987" providerId="LiveId" clId="{C34CCE27-BCC5-4A85-B460-69DD6C594E7D}" dt="2021-04-25T11:02:40.802" v="274"/>
      <pc:docMkLst>
        <pc:docMk/>
      </pc:docMkLst>
      <pc:sldChg chg="add del">
        <pc:chgData name="Derei Wu" userId="935b1b74ff2f2987" providerId="LiveId" clId="{C34CCE27-BCC5-4A85-B460-69DD6C594E7D}" dt="2021-04-25T11:02:38.572" v="273" actId="2696"/>
        <pc:sldMkLst>
          <pc:docMk/>
          <pc:sldMk cId="324715096" sldId="258"/>
        </pc:sldMkLst>
      </pc:sldChg>
      <pc:sldChg chg="del">
        <pc:chgData name="Derei Wu" userId="935b1b74ff2f2987" providerId="LiveId" clId="{C34CCE27-BCC5-4A85-B460-69DD6C594E7D}" dt="2021-04-25T10:58:13.926" v="209" actId="2696"/>
        <pc:sldMkLst>
          <pc:docMk/>
          <pc:sldMk cId="869597803" sldId="258"/>
        </pc:sldMkLst>
      </pc:sldChg>
      <pc:sldChg chg="add">
        <pc:chgData name="Derei Wu" userId="935b1b74ff2f2987" providerId="LiveId" clId="{C34CCE27-BCC5-4A85-B460-69DD6C594E7D}" dt="2021-04-25T11:02:40.802" v="274"/>
        <pc:sldMkLst>
          <pc:docMk/>
          <pc:sldMk cId="2897164670" sldId="258"/>
        </pc:sldMkLst>
      </pc:sldChg>
      <pc:sldChg chg="addSp delSp modSp mod">
        <pc:chgData name="Derei Wu" userId="935b1b74ff2f2987" providerId="LiveId" clId="{C34CCE27-BCC5-4A85-B460-69DD6C594E7D}" dt="2021-04-25T11:00:55.583" v="256" actId="1036"/>
        <pc:sldMkLst>
          <pc:docMk/>
          <pc:sldMk cId="1808353223" sldId="281"/>
        </pc:sldMkLst>
        <pc:spChg chg="mod">
          <ac:chgData name="Derei Wu" userId="935b1b74ff2f2987" providerId="LiveId" clId="{C34CCE27-BCC5-4A85-B460-69DD6C594E7D}" dt="2021-04-25T08:37:36.441" v="12" actId="1076"/>
          <ac:spMkLst>
            <pc:docMk/>
            <pc:sldMk cId="1808353223" sldId="281"/>
            <ac:spMk id="2" creationId="{A4B57805-CDFD-4943-8F27-B65F2C07FFD8}"/>
          </ac:spMkLst>
        </pc:spChg>
        <pc:spChg chg="add del mod">
          <ac:chgData name="Derei Wu" userId="935b1b74ff2f2987" providerId="LiveId" clId="{C34CCE27-BCC5-4A85-B460-69DD6C594E7D}" dt="2021-04-25T08:36:46.727" v="2" actId="478"/>
          <ac:spMkLst>
            <pc:docMk/>
            <pc:sldMk cId="1808353223" sldId="281"/>
            <ac:spMk id="5" creationId="{FA208F91-4F9D-4317-A5CD-1C47B5EBBE1D}"/>
          </ac:spMkLst>
        </pc:spChg>
        <pc:spChg chg="mod">
          <ac:chgData name="Derei Wu" userId="935b1b74ff2f2987" providerId="LiveId" clId="{C34CCE27-BCC5-4A85-B460-69DD6C594E7D}" dt="2021-04-25T08:37:36.441" v="12" actId="1076"/>
          <ac:spMkLst>
            <pc:docMk/>
            <pc:sldMk cId="1808353223" sldId="281"/>
            <ac:spMk id="14" creationId="{6AEBF1A3-E155-4211-BD38-3B19B797930B}"/>
          </ac:spMkLst>
        </pc:spChg>
        <pc:spChg chg="add del">
          <ac:chgData name="Derei Wu" userId="935b1b74ff2f2987" providerId="LiveId" clId="{C34CCE27-BCC5-4A85-B460-69DD6C594E7D}" dt="2021-04-25T08:36:59.196" v="7" actId="478"/>
          <ac:spMkLst>
            <pc:docMk/>
            <pc:sldMk cId="1808353223" sldId="281"/>
            <ac:spMk id="15" creationId="{BE6F524F-FB0C-43E1-BDDA-50A04AB6FE78}"/>
          </ac:spMkLst>
        </pc:spChg>
        <pc:spChg chg="mod">
          <ac:chgData name="Derei Wu" userId="935b1b74ff2f2987" providerId="LiveId" clId="{C34CCE27-BCC5-4A85-B460-69DD6C594E7D}" dt="2021-04-25T11:00:55.583" v="256" actId="1036"/>
          <ac:spMkLst>
            <pc:docMk/>
            <pc:sldMk cId="1808353223" sldId="281"/>
            <ac:spMk id="16" creationId="{25102EB1-F7D4-4B53-89BD-2E7914179106}"/>
          </ac:spMkLst>
        </pc:spChg>
        <pc:spChg chg="add del mod">
          <ac:chgData name="Derei Wu" userId="935b1b74ff2f2987" providerId="LiveId" clId="{C34CCE27-BCC5-4A85-B460-69DD6C594E7D}" dt="2021-04-25T08:36:44.781" v="1" actId="478"/>
          <ac:spMkLst>
            <pc:docMk/>
            <pc:sldMk cId="1808353223" sldId="281"/>
            <ac:spMk id="17" creationId="{CF06653C-FF10-49E9-AC29-E96C69254EF9}"/>
          </ac:spMkLst>
        </pc:spChg>
        <pc:spChg chg="add del mod">
          <ac:chgData name="Derei Wu" userId="935b1b74ff2f2987" providerId="LiveId" clId="{C34CCE27-BCC5-4A85-B460-69DD6C594E7D}" dt="2021-04-25T11:00:51.967" v="249" actId="403"/>
          <ac:spMkLst>
            <pc:docMk/>
            <pc:sldMk cId="1808353223" sldId="281"/>
            <ac:spMk id="18" creationId="{46F7BC8F-D926-4C72-9CE9-55FDFDDB3C17}"/>
          </ac:spMkLst>
        </pc:spChg>
        <pc:graphicFrameChg chg="mod">
          <ac:chgData name="Derei Wu" userId="935b1b74ff2f2987" providerId="LiveId" clId="{C34CCE27-BCC5-4A85-B460-69DD6C594E7D}" dt="2021-04-25T08:37:36.441" v="12" actId="1076"/>
          <ac:graphicFrameMkLst>
            <pc:docMk/>
            <pc:sldMk cId="1808353223" sldId="281"/>
            <ac:graphicFrameMk id="3" creationId="{E33A36ED-7717-4CC0-90FA-C2DBD66D98DC}"/>
          </ac:graphicFrameMkLst>
        </pc:graphicFrameChg>
        <pc:graphicFrameChg chg="mod">
          <ac:chgData name="Derei Wu" userId="935b1b74ff2f2987" providerId="LiveId" clId="{C34CCE27-BCC5-4A85-B460-69DD6C594E7D}" dt="2021-04-25T08:37:36.441" v="12" actId="1076"/>
          <ac:graphicFrameMkLst>
            <pc:docMk/>
            <pc:sldMk cId="1808353223" sldId="281"/>
            <ac:graphicFrameMk id="9" creationId="{5CD7DE07-1C36-45AF-ADDB-F2DDD3D6104D}"/>
          </ac:graphicFrameMkLst>
        </pc:graphicFrameChg>
        <pc:graphicFrameChg chg="mod">
          <ac:chgData name="Derei Wu" userId="935b1b74ff2f2987" providerId="LiveId" clId="{C34CCE27-BCC5-4A85-B460-69DD6C594E7D}" dt="2021-04-25T08:37:36.441" v="12" actId="1076"/>
          <ac:graphicFrameMkLst>
            <pc:docMk/>
            <pc:sldMk cId="1808353223" sldId="281"/>
            <ac:graphicFrameMk id="12" creationId="{1626B093-F7C8-4522-A35D-B6C5D93709D3}"/>
          </ac:graphicFrameMkLst>
        </pc:graphicFrameChg>
        <pc:graphicFrameChg chg="mod">
          <ac:chgData name="Derei Wu" userId="935b1b74ff2f2987" providerId="LiveId" clId="{C34CCE27-BCC5-4A85-B460-69DD6C594E7D}" dt="2021-04-25T08:37:36.441" v="12" actId="1076"/>
          <ac:graphicFrameMkLst>
            <pc:docMk/>
            <pc:sldMk cId="1808353223" sldId="281"/>
            <ac:graphicFrameMk id="13" creationId="{9845E477-FD1E-42FC-8F9C-7F65EC37D52D}"/>
          </ac:graphicFrameMkLst>
        </pc:graphicFrameChg>
        <pc:graphicFrameChg chg="mod">
          <ac:chgData name="Derei Wu" userId="935b1b74ff2f2987" providerId="LiveId" clId="{C34CCE27-BCC5-4A85-B460-69DD6C594E7D}" dt="2021-04-25T08:37:36.441" v="12" actId="1076"/>
          <ac:graphicFrameMkLst>
            <pc:docMk/>
            <pc:sldMk cId="1808353223" sldId="281"/>
            <ac:graphicFrameMk id="20" creationId="{233B2F3F-32DE-4853-AA42-AE4E1B6E6685}"/>
          </ac:graphicFrameMkLst>
        </pc:graphicFrameChg>
        <pc:graphicFrameChg chg="mod">
          <ac:chgData name="Derei Wu" userId="935b1b74ff2f2987" providerId="LiveId" clId="{C34CCE27-BCC5-4A85-B460-69DD6C594E7D}" dt="2021-04-25T08:37:36.441" v="12" actId="1076"/>
          <ac:graphicFrameMkLst>
            <pc:docMk/>
            <pc:sldMk cId="1808353223" sldId="281"/>
            <ac:graphicFrameMk id="23" creationId="{5EEE791A-E255-4196-9141-8116471CEA50}"/>
          </ac:graphicFrameMkLst>
        </pc:graphicFrameChg>
        <pc:graphicFrameChg chg="mod">
          <ac:chgData name="Derei Wu" userId="935b1b74ff2f2987" providerId="LiveId" clId="{C34CCE27-BCC5-4A85-B460-69DD6C594E7D}" dt="2021-04-25T08:37:36.441" v="12" actId="1076"/>
          <ac:graphicFrameMkLst>
            <pc:docMk/>
            <pc:sldMk cId="1808353223" sldId="281"/>
            <ac:graphicFrameMk id="24" creationId="{4B263A78-133C-41B2-B763-6CD097A92E05}"/>
          </ac:graphicFrameMkLst>
        </pc:graphicFrameChg>
      </pc:sldChg>
      <pc:sldChg chg="modSp mod">
        <pc:chgData name="Derei Wu" userId="935b1b74ff2f2987" providerId="LiveId" clId="{C34CCE27-BCC5-4A85-B460-69DD6C594E7D}" dt="2021-04-25T11:00:41.884" v="247" actId="403"/>
        <pc:sldMkLst>
          <pc:docMk/>
          <pc:sldMk cId="2526091792" sldId="282"/>
        </pc:sldMkLst>
        <pc:spChg chg="mod">
          <ac:chgData name="Derei Wu" userId="935b1b74ff2f2987" providerId="LiveId" clId="{C34CCE27-BCC5-4A85-B460-69DD6C594E7D}" dt="2021-04-25T11:00:41.884" v="247" actId="403"/>
          <ac:spMkLst>
            <pc:docMk/>
            <pc:sldMk cId="2526091792" sldId="282"/>
            <ac:spMk id="2" creationId="{66D8FC8C-69B2-43B8-A81E-84FD80EB801F}"/>
          </ac:spMkLst>
        </pc:spChg>
      </pc:sldChg>
      <pc:sldChg chg="addSp delSp modSp add mod">
        <pc:chgData name="Derei Wu" userId="935b1b74ff2f2987" providerId="LiveId" clId="{C34CCE27-BCC5-4A85-B460-69DD6C594E7D}" dt="2021-04-25T11:01:44.395" v="265" actId="1076"/>
        <pc:sldMkLst>
          <pc:docMk/>
          <pc:sldMk cId="1634141280" sldId="411"/>
        </pc:sldMkLst>
        <pc:spChg chg="add mod">
          <ac:chgData name="Derei Wu" userId="935b1b74ff2f2987" providerId="LiveId" clId="{C34CCE27-BCC5-4A85-B460-69DD6C594E7D}" dt="2021-04-25T11:00:59.501" v="258" actId="403"/>
          <ac:spMkLst>
            <pc:docMk/>
            <pc:sldMk cId="1634141280" sldId="411"/>
            <ac:spMk id="4" creationId="{FA742DCD-8EFB-497E-A82C-C99606BA31BC}"/>
          </ac:spMkLst>
        </pc:spChg>
        <pc:spChg chg="add del mod">
          <ac:chgData name="Derei Wu" userId="935b1b74ff2f2987" providerId="LiveId" clId="{C34CCE27-BCC5-4A85-B460-69DD6C594E7D}" dt="2021-04-25T11:00:03.627" v="238" actId="478"/>
          <ac:spMkLst>
            <pc:docMk/>
            <pc:sldMk cId="1634141280" sldId="411"/>
            <ac:spMk id="6" creationId="{CEAF3E17-9B59-43BC-A361-0C7E4D931273}"/>
          </ac:spMkLst>
        </pc:spChg>
        <pc:spChg chg="mod">
          <ac:chgData name="Derei Wu" userId="935b1b74ff2f2987" providerId="LiveId" clId="{C34CCE27-BCC5-4A85-B460-69DD6C594E7D}" dt="2021-04-25T11:00:06.207" v="239" actId="1076"/>
          <ac:spMkLst>
            <pc:docMk/>
            <pc:sldMk cId="1634141280" sldId="411"/>
            <ac:spMk id="7" creationId="{A29EE43C-3472-40A4-91FE-F2017E23B71C}"/>
          </ac:spMkLst>
        </pc:spChg>
        <pc:picChg chg="mod">
          <ac:chgData name="Derei Wu" userId="935b1b74ff2f2987" providerId="LiveId" clId="{C34CCE27-BCC5-4A85-B460-69DD6C594E7D}" dt="2021-04-25T11:01:44.395" v="265" actId="1076"/>
          <ac:picMkLst>
            <pc:docMk/>
            <pc:sldMk cId="1634141280" sldId="411"/>
            <ac:picMk id="5" creationId="{1B870E9E-F71B-46C0-ABAD-8095E9771926}"/>
          </ac:picMkLst>
        </pc:picChg>
      </pc:sldChg>
      <pc:sldChg chg="del">
        <pc:chgData name="Derei Wu" userId="935b1b74ff2f2987" providerId="LiveId" clId="{C34CCE27-BCC5-4A85-B460-69DD6C594E7D}" dt="2021-04-25T10:58:13.926" v="209" actId="2696"/>
        <pc:sldMkLst>
          <pc:docMk/>
          <pc:sldMk cId="2142966764" sldId="411"/>
        </pc:sldMkLst>
      </pc:sldChg>
      <pc:sldChg chg="del">
        <pc:chgData name="Derei Wu" userId="935b1b74ff2f2987" providerId="LiveId" clId="{C34CCE27-BCC5-4A85-B460-69DD6C594E7D}" dt="2021-04-25T10:58:13.926" v="209" actId="2696"/>
        <pc:sldMkLst>
          <pc:docMk/>
          <pc:sldMk cId="212389588" sldId="412"/>
        </pc:sldMkLst>
      </pc:sldChg>
      <pc:sldChg chg="addSp delSp modSp add mod">
        <pc:chgData name="Derei Wu" userId="935b1b74ff2f2987" providerId="LiveId" clId="{C34CCE27-BCC5-4A85-B460-69DD6C594E7D}" dt="2021-04-25T11:01:30.214" v="264" actId="1076"/>
        <pc:sldMkLst>
          <pc:docMk/>
          <pc:sldMk cId="4291767262" sldId="412"/>
        </pc:sldMkLst>
        <pc:spChg chg="add mod">
          <ac:chgData name="Derei Wu" userId="935b1b74ff2f2987" providerId="LiveId" clId="{C34CCE27-BCC5-4A85-B460-69DD6C594E7D}" dt="2021-04-25T11:00:20.748" v="244" actId="113"/>
          <ac:spMkLst>
            <pc:docMk/>
            <pc:sldMk cId="4291767262" sldId="412"/>
            <ac:spMk id="4" creationId="{61D9CA6B-F324-4D06-BAF4-4FACE9CB098F}"/>
          </ac:spMkLst>
        </pc:spChg>
        <pc:spChg chg="del">
          <ac:chgData name="Derei Wu" userId="935b1b74ff2f2987" providerId="LiveId" clId="{C34CCE27-BCC5-4A85-B460-69DD6C594E7D}" dt="2021-04-25T11:00:30.423" v="245" actId="478"/>
          <ac:spMkLst>
            <pc:docMk/>
            <pc:sldMk cId="4291767262" sldId="412"/>
            <ac:spMk id="7" creationId="{FA971C95-E898-4746-977C-953C00371138}"/>
          </ac:spMkLst>
        </pc:spChg>
        <pc:picChg chg="mod">
          <ac:chgData name="Derei Wu" userId="935b1b74ff2f2987" providerId="LiveId" clId="{C34CCE27-BCC5-4A85-B460-69DD6C594E7D}" dt="2021-04-25T11:01:30.214" v="264" actId="1076"/>
          <ac:picMkLst>
            <pc:docMk/>
            <pc:sldMk cId="4291767262" sldId="412"/>
            <ac:picMk id="5" creationId="{9FDC8878-07B4-4B53-A941-B056D8F31D7A}"/>
          </ac:picMkLst>
        </pc:picChg>
      </pc:sldChg>
      <pc:sldChg chg="del">
        <pc:chgData name="Derei Wu" userId="935b1b74ff2f2987" providerId="LiveId" clId="{C34CCE27-BCC5-4A85-B460-69DD6C594E7D}" dt="2021-04-25T10:58:13.926" v="209" actId="2696"/>
        <pc:sldMkLst>
          <pc:docMk/>
          <pc:sldMk cId="1842716572" sldId="413"/>
        </pc:sldMkLst>
      </pc:sldChg>
      <pc:sldChg chg="addSp delSp modSp add mod">
        <pc:chgData name="Derei Wu" userId="935b1b74ff2f2987" providerId="LiveId" clId="{C34CCE27-BCC5-4A85-B460-69DD6C594E7D}" dt="2021-04-25T11:02:26.944" v="272" actId="20577"/>
        <pc:sldMkLst>
          <pc:docMk/>
          <pc:sldMk cId="2461855473" sldId="413"/>
        </pc:sldMkLst>
        <pc:spChg chg="add mod">
          <ac:chgData name="Derei Wu" userId="935b1b74ff2f2987" providerId="LiveId" clId="{C34CCE27-BCC5-4A85-B460-69DD6C594E7D}" dt="2021-04-25T11:02:26.944" v="272" actId="20577"/>
          <ac:spMkLst>
            <pc:docMk/>
            <pc:sldMk cId="2461855473" sldId="413"/>
            <ac:spMk id="4" creationId="{FFF15222-A4BC-47D7-8147-A99131964AAC}"/>
          </ac:spMkLst>
        </pc:spChg>
        <pc:spChg chg="del">
          <ac:chgData name="Derei Wu" userId="935b1b74ff2f2987" providerId="LiveId" clId="{C34CCE27-BCC5-4A85-B460-69DD6C594E7D}" dt="2021-04-25T11:02:02.397" v="269" actId="478"/>
          <ac:spMkLst>
            <pc:docMk/>
            <pc:sldMk cId="2461855473" sldId="413"/>
            <ac:spMk id="7" creationId="{835981B7-28B8-4432-A658-E556F096A295}"/>
          </ac:spMkLst>
        </pc:spChg>
        <pc:picChg chg="mod">
          <ac:chgData name="Derei Wu" userId="935b1b74ff2f2987" providerId="LiveId" clId="{C34CCE27-BCC5-4A85-B460-69DD6C594E7D}" dt="2021-04-25T11:02:15.123" v="270" actId="1076"/>
          <ac:picMkLst>
            <pc:docMk/>
            <pc:sldMk cId="2461855473" sldId="413"/>
            <ac:picMk id="5" creationId="{7E8B0080-E636-4227-B5F4-D53FF4802629}"/>
          </ac:picMkLst>
        </pc:picChg>
      </pc:sldChg>
      <pc:sldChg chg="addSp delSp modSp mod">
        <pc:chgData name="Derei Wu" userId="935b1b74ff2f2987" providerId="LiveId" clId="{C34CCE27-BCC5-4A85-B460-69DD6C594E7D}" dt="2021-04-25T08:39:01.677" v="62" actId="1035"/>
        <pc:sldMkLst>
          <pc:docMk/>
          <pc:sldMk cId="4127656194" sldId="500"/>
        </pc:sldMkLst>
        <pc:spChg chg="mod">
          <ac:chgData name="Derei Wu" userId="935b1b74ff2f2987" providerId="LiveId" clId="{C34CCE27-BCC5-4A85-B460-69DD6C594E7D}" dt="2021-04-25T08:39:01.677" v="62" actId="1035"/>
          <ac:spMkLst>
            <pc:docMk/>
            <pc:sldMk cId="4127656194" sldId="500"/>
            <ac:spMk id="2" creationId="{F6676D08-B0B5-43AA-AC9C-2FA26D63DFDB}"/>
          </ac:spMkLst>
        </pc:spChg>
        <pc:spChg chg="add del mod">
          <ac:chgData name="Derei Wu" userId="935b1b74ff2f2987" providerId="LiveId" clId="{C34CCE27-BCC5-4A85-B460-69DD6C594E7D}" dt="2021-04-25T08:38:48.627" v="23" actId="478"/>
          <ac:spMkLst>
            <pc:docMk/>
            <pc:sldMk cId="4127656194" sldId="500"/>
            <ac:spMk id="5" creationId="{DECABEF9-71AB-4E38-B826-2B219B024EB4}"/>
          </ac:spMkLst>
        </pc:spChg>
        <pc:spChg chg="mod">
          <ac:chgData name="Derei Wu" userId="935b1b74ff2f2987" providerId="LiveId" clId="{C34CCE27-BCC5-4A85-B460-69DD6C594E7D}" dt="2021-04-25T08:38:57.216" v="49" actId="1035"/>
          <ac:spMkLst>
            <pc:docMk/>
            <pc:sldMk cId="4127656194" sldId="500"/>
            <ac:spMk id="14" creationId="{936FA1D3-5B45-40AB-A225-E4C97C912477}"/>
          </ac:spMkLst>
        </pc:spChg>
        <pc:spChg chg="del">
          <ac:chgData name="Derei Wu" userId="935b1b74ff2f2987" providerId="LiveId" clId="{C34CCE27-BCC5-4A85-B460-69DD6C594E7D}" dt="2021-04-25T08:38:45.906" v="22" actId="478"/>
          <ac:spMkLst>
            <pc:docMk/>
            <pc:sldMk cId="4127656194" sldId="500"/>
            <ac:spMk id="15" creationId="{6D9B8B3F-227C-4B79-B7E4-94F98DD89397}"/>
          </ac:spMkLst>
        </pc:spChg>
        <pc:spChg chg="mod">
          <ac:chgData name="Derei Wu" userId="935b1b74ff2f2987" providerId="LiveId" clId="{C34CCE27-BCC5-4A85-B460-69DD6C594E7D}" dt="2021-04-25T08:39:01.677" v="62" actId="1035"/>
          <ac:spMkLst>
            <pc:docMk/>
            <pc:sldMk cId="4127656194" sldId="500"/>
            <ac:spMk id="16" creationId="{583FAA93-F4B9-4A9C-AE9A-8D47776655D7}"/>
          </ac:spMkLst>
        </pc:spChg>
        <pc:spChg chg="mod">
          <ac:chgData name="Derei Wu" userId="935b1b74ff2f2987" providerId="LiveId" clId="{C34CCE27-BCC5-4A85-B460-69DD6C594E7D}" dt="2021-04-25T08:39:01.677" v="62" actId="1035"/>
          <ac:spMkLst>
            <pc:docMk/>
            <pc:sldMk cId="4127656194" sldId="500"/>
            <ac:spMk id="17" creationId="{A5235B9F-B0BD-4D4A-A6D2-6E525593F67C}"/>
          </ac:spMkLst>
        </pc:spChg>
        <pc:picChg chg="mod">
          <ac:chgData name="Derei Wu" userId="935b1b74ff2f2987" providerId="LiveId" clId="{C34CCE27-BCC5-4A85-B460-69DD6C594E7D}" dt="2021-04-25T08:39:01.677" v="62" actId="1035"/>
          <ac:picMkLst>
            <pc:docMk/>
            <pc:sldMk cId="4127656194" sldId="500"/>
            <ac:picMk id="8" creationId="{1AA3361E-A4F8-4522-8C94-0345F1668E9D}"/>
          </ac:picMkLst>
        </pc:picChg>
        <pc:picChg chg="mod">
          <ac:chgData name="Derei Wu" userId="935b1b74ff2f2987" providerId="LiveId" clId="{C34CCE27-BCC5-4A85-B460-69DD6C594E7D}" dt="2021-04-25T08:39:01.677" v="62" actId="1035"/>
          <ac:picMkLst>
            <pc:docMk/>
            <pc:sldMk cId="4127656194" sldId="500"/>
            <ac:picMk id="9" creationId="{C672FCDA-FAAC-4CEE-B78C-BD9D4188F436}"/>
          </ac:picMkLst>
        </pc:picChg>
        <pc:picChg chg="mod">
          <ac:chgData name="Derei Wu" userId="935b1b74ff2f2987" providerId="LiveId" clId="{C34CCE27-BCC5-4A85-B460-69DD6C594E7D}" dt="2021-04-25T08:39:01.677" v="62" actId="1035"/>
          <ac:picMkLst>
            <pc:docMk/>
            <pc:sldMk cId="4127656194" sldId="500"/>
            <ac:picMk id="10" creationId="{B7B27E1E-5141-40C1-A1D7-88A024370D37}"/>
          </ac:picMkLst>
        </pc:picChg>
      </pc:sldChg>
      <pc:sldChg chg="addSp delSp modSp mod">
        <pc:chgData name="Derei Wu" userId="935b1b74ff2f2987" providerId="LiveId" clId="{C34CCE27-BCC5-4A85-B460-69DD6C594E7D}" dt="2021-04-25T11:01:14.610" v="262" actId="403"/>
        <pc:sldMkLst>
          <pc:docMk/>
          <pc:sldMk cId="192042371" sldId="501"/>
        </pc:sldMkLst>
        <pc:spChg chg="del mod">
          <ac:chgData name="Derei Wu" userId="935b1b74ff2f2987" providerId="LiveId" clId="{C34CCE27-BCC5-4A85-B460-69DD6C594E7D}" dt="2021-04-25T08:39:39.119" v="68" actId="478"/>
          <ac:spMkLst>
            <pc:docMk/>
            <pc:sldMk cId="192042371" sldId="501"/>
            <ac:spMk id="4" creationId="{675F998C-5D87-4B27-922F-E68AB5C34CAB}"/>
          </ac:spMkLst>
        </pc:spChg>
        <pc:spChg chg="mod">
          <ac:chgData name="Derei Wu" userId="935b1b74ff2f2987" providerId="LiveId" clId="{C34CCE27-BCC5-4A85-B460-69DD6C594E7D}" dt="2021-04-25T10:55:01.929" v="124" actId="1076"/>
          <ac:spMkLst>
            <pc:docMk/>
            <pc:sldMk cId="192042371" sldId="501"/>
            <ac:spMk id="6" creationId="{D7B9413C-74CA-464E-BB8F-648F6C0D1664}"/>
          </ac:spMkLst>
        </pc:spChg>
        <pc:spChg chg="add del mod">
          <ac:chgData name="Derei Wu" userId="935b1b74ff2f2987" providerId="LiveId" clId="{C34CCE27-BCC5-4A85-B460-69DD6C594E7D}" dt="2021-04-25T08:39:32.510" v="64"/>
          <ac:spMkLst>
            <pc:docMk/>
            <pc:sldMk cId="192042371" sldId="501"/>
            <ac:spMk id="7" creationId="{BA2A02A9-FA0F-4736-96A2-43E618BE9968}"/>
          </ac:spMkLst>
        </pc:spChg>
        <pc:spChg chg="add mod">
          <ac:chgData name="Derei Wu" userId="935b1b74ff2f2987" providerId="LiveId" clId="{C34CCE27-BCC5-4A85-B460-69DD6C594E7D}" dt="2021-04-25T11:01:14.610" v="262" actId="403"/>
          <ac:spMkLst>
            <pc:docMk/>
            <pc:sldMk cId="192042371" sldId="501"/>
            <ac:spMk id="8" creationId="{05B0F1FD-D170-4D7B-8280-03E9121D1C33}"/>
          </ac:spMkLst>
        </pc:spChg>
        <pc:spChg chg="add mod">
          <ac:chgData name="Derei Wu" userId="935b1b74ff2f2987" providerId="LiveId" clId="{C34CCE27-BCC5-4A85-B460-69DD6C594E7D}" dt="2021-04-25T10:56:42.953" v="164" actId="1076"/>
          <ac:spMkLst>
            <pc:docMk/>
            <pc:sldMk cId="192042371" sldId="501"/>
            <ac:spMk id="11" creationId="{DAFB637B-6A35-40B9-84FE-28152E7B7A12}"/>
          </ac:spMkLst>
        </pc:spChg>
        <pc:spChg chg="add mod">
          <ac:chgData name="Derei Wu" userId="935b1b74ff2f2987" providerId="LiveId" clId="{C34CCE27-BCC5-4A85-B460-69DD6C594E7D}" dt="2021-04-25T10:57:17.456" v="208" actId="1076"/>
          <ac:spMkLst>
            <pc:docMk/>
            <pc:sldMk cId="192042371" sldId="501"/>
            <ac:spMk id="14" creationId="{982847DB-761F-43F3-A684-17C526229793}"/>
          </ac:spMkLst>
        </pc:spChg>
        <pc:picChg chg="mod modCrop">
          <ac:chgData name="Derei Wu" userId="935b1b74ff2f2987" providerId="LiveId" clId="{C34CCE27-BCC5-4A85-B460-69DD6C594E7D}" dt="2021-04-25T10:56:52.553" v="181" actId="1036"/>
          <ac:picMkLst>
            <pc:docMk/>
            <pc:sldMk cId="192042371" sldId="501"/>
            <ac:picMk id="5" creationId="{3FF8B78C-5A4A-4BDB-8DA6-251C44F1853B}"/>
          </ac:picMkLst>
        </pc:picChg>
        <pc:picChg chg="add mod modCrop">
          <ac:chgData name="Derei Wu" userId="935b1b74ff2f2987" providerId="LiveId" clId="{C34CCE27-BCC5-4A85-B460-69DD6C594E7D}" dt="2021-04-25T10:56:09.685" v="135" actId="1076"/>
          <ac:picMkLst>
            <pc:docMk/>
            <pc:sldMk cId="192042371" sldId="501"/>
            <ac:picMk id="9" creationId="{A70E8168-7459-43F1-B1ED-8823C975BA64}"/>
          </ac:picMkLst>
        </pc:picChg>
        <pc:picChg chg="add mod modCrop">
          <ac:chgData name="Derei Wu" userId="935b1b74ff2f2987" providerId="LiveId" clId="{C34CCE27-BCC5-4A85-B460-69DD6C594E7D}" dt="2021-04-25T10:56:56.830" v="192" actId="1035"/>
          <ac:picMkLst>
            <pc:docMk/>
            <pc:sldMk cId="192042371" sldId="501"/>
            <ac:picMk id="10" creationId="{68F2F066-1E6B-4C5C-898D-380B249E1A14}"/>
          </ac:picMkLst>
        </pc:picChg>
        <pc:cxnChg chg="add mod">
          <ac:chgData name="Derei Wu" userId="935b1b74ff2f2987" providerId="LiveId" clId="{C34CCE27-BCC5-4A85-B460-69DD6C594E7D}" dt="2021-04-25T10:57:06.188" v="202" actId="1035"/>
          <ac:cxnSpMkLst>
            <pc:docMk/>
            <pc:sldMk cId="192042371" sldId="501"/>
            <ac:cxnSpMk id="3" creationId="{09118AF4-03F0-4897-9ACB-3E95A45ABC1F}"/>
          </ac:cxnSpMkLst>
        </pc:cxnChg>
        <pc:cxnChg chg="add mod">
          <ac:chgData name="Derei Wu" userId="935b1b74ff2f2987" providerId="LiveId" clId="{C34CCE27-BCC5-4A85-B460-69DD6C594E7D}" dt="2021-04-25T10:57:13.534" v="207" actId="14100"/>
          <ac:cxnSpMkLst>
            <pc:docMk/>
            <pc:sldMk cId="192042371" sldId="501"/>
            <ac:cxnSpMk id="13" creationId="{B05BE382-E8C3-4408-88F1-E285E7DE9058}"/>
          </ac:cxnSpMkLst>
        </pc:cxnChg>
      </pc:sldChg>
      <pc:sldChg chg="addSp delSp modSp mod">
        <pc:chgData name="Derei Wu" userId="935b1b74ff2f2987" providerId="LiveId" clId="{C34CCE27-BCC5-4A85-B460-69DD6C594E7D}" dt="2021-04-25T11:01:09.807" v="260" actId="403"/>
        <pc:sldMkLst>
          <pc:docMk/>
          <pc:sldMk cId="813633081" sldId="509"/>
        </pc:sldMkLst>
        <pc:spChg chg="del mod">
          <ac:chgData name="Derei Wu" userId="935b1b74ff2f2987" providerId="LiveId" clId="{C34CCE27-BCC5-4A85-B460-69DD6C594E7D}" dt="2021-04-25T08:37:57.024" v="17" actId="478"/>
          <ac:spMkLst>
            <pc:docMk/>
            <pc:sldMk cId="813633081" sldId="509"/>
            <ac:spMk id="9" creationId="{42C5B0CC-C526-4089-A2D9-A93BAA2D5672}"/>
          </ac:spMkLst>
        </pc:spChg>
        <pc:spChg chg="add mod">
          <ac:chgData name="Derei Wu" userId="935b1b74ff2f2987" providerId="LiveId" clId="{C34CCE27-BCC5-4A85-B460-69DD6C594E7D}" dt="2021-04-25T11:01:09.807" v="260" actId="403"/>
          <ac:spMkLst>
            <pc:docMk/>
            <pc:sldMk cId="813633081" sldId="509"/>
            <ac:spMk id="16" creationId="{6DB06359-E012-49B5-AB6C-43911B332EF7}"/>
          </ac:spMkLst>
        </pc:spChg>
        <pc:spChg chg="add mod">
          <ac:chgData name="Derei Wu" userId="935b1b74ff2f2987" providerId="LiveId" clId="{C34CCE27-BCC5-4A85-B460-69DD6C594E7D}" dt="2021-04-25T08:38:24.407" v="19" actId="1076"/>
          <ac:spMkLst>
            <pc:docMk/>
            <pc:sldMk cId="813633081" sldId="509"/>
            <ac:spMk id="18" creationId="{3BBE9420-9653-401F-B56D-2B6796EBF23B}"/>
          </ac:spMkLst>
        </pc:spChg>
      </pc:sldChg>
      <pc:sldChg chg="addSp modSp mod">
        <pc:chgData name="Derei Wu" userId="935b1b74ff2f2987" providerId="LiveId" clId="{C34CCE27-BCC5-4A85-B460-69DD6C594E7D}" dt="2021-04-25T08:38:30.670" v="21" actId="20577"/>
        <pc:sldMkLst>
          <pc:docMk/>
          <pc:sldMk cId="777699264" sldId="511"/>
        </pc:sldMkLst>
        <pc:spChg chg="add mod">
          <ac:chgData name="Derei Wu" userId="935b1b74ff2f2987" providerId="LiveId" clId="{C34CCE27-BCC5-4A85-B460-69DD6C594E7D}" dt="2021-04-25T08:38:30.670" v="21" actId="20577"/>
          <ac:spMkLst>
            <pc:docMk/>
            <pc:sldMk cId="777699264" sldId="511"/>
            <ac:spMk id="7" creationId="{EAE911D9-684B-4BE2-ACB3-E275C59FD852}"/>
          </ac:spMkLst>
        </pc:spChg>
      </pc:sldChg>
    </pc:docChg>
  </pc:docChgLst>
  <pc:docChgLst>
    <pc:chgData name="Derei Wu" userId="935b1b74ff2f2987" providerId="LiveId" clId="{DD6F1DB3-55D6-4344-A5CD-F9938E42967D}"/>
    <pc:docChg chg="undo custSel addSld delSld modSld sldOrd">
      <pc:chgData name="Derei Wu" userId="935b1b74ff2f2987" providerId="LiveId" clId="{DD6F1DB3-55D6-4344-A5CD-F9938E42967D}" dt="2021-05-29T06:50:57.101" v="63" actId="1076"/>
      <pc:docMkLst>
        <pc:docMk/>
      </pc:docMkLst>
      <pc:sldChg chg="del">
        <pc:chgData name="Derei Wu" userId="935b1b74ff2f2987" providerId="LiveId" clId="{DD6F1DB3-55D6-4344-A5CD-F9938E42967D}" dt="2021-05-08T05:27:20.346" v="13" actId="2696"/>
        <pc:sldMkLst>
          <pc:docMk/>
          <pc:sldMk cId="1808353223" sldId="281"/>
        </pc:sldMkLst>
      </pc:sldChg>
      <pc:sldChg chg="modSp add mod">
        <pc:chgData name="Derei Wu" userId="935b1b74ff2f2987" providerId="LiveId" clId="{DD6F1DB3-55D6-4344-A5CD-F9938E42967D}" dt="2021-05-08T05:27:34.164" v="15" actId="20577"/>
        <pc:sldMkLst>
          <pc:docMk/>
          <pc:sldMk cId="1852453233" sldId="281"/>
        </pc:sldMkLst>
        <pc:spChg chg="mod">
          <ac:chgData name="Derei Wu" userId="935b1b74ff2f2987" providerId="LiveId" clId="{DD6F1DB3-55D6-4344-A5CD-F9938E42967D}" dt="2021-05-08T05:27:34.164" v="15" actId="20577"/>
          <ac:spMkLst>
            <pc:docMk/>
            <pc:sldMk cId="1852453233" sldId="281"/>
            <ac:spMk id="18" creationId="{46F7BC8F-D926-4C72-9CE9-55FDFDDB3C17}"/>
          </ac:spMkLst>
        </pc:spChg>
      </pc:sldChg>
      <pc:sldChg chg="ord">
        <pc:chgData name="Derei Wu" userId="935b1b74ff2f2987" providerId="LiveId" clId="{DD6F1DB3-55D6-4344-A5CD-F9938E42967D}" dt="2021-05-08T04:14:26.280" v="7"/>
        <pc:sldMkLst>
          <pc:docMk/>
          <pc:sldMk cId="2526091792" sldId="282"/>
        </pc:sldMkLst>
      </pc:sldChg>
      <pc:sldChg chg="addSp modSp mod">
        <pc:chgData name="Derei Wu" userId="935b1b74ff2f2987" providerId="LiveId" clId="{DD6F1DB3-55D6-4344-A5CD-F9938E42967D}" dt="2021-05-08T04:14:44.628" v="11" actId="20577"/>
        <pc:sldMkLst>
          <pc:docMk/>
          <pc:sldMk cId="4127656194" sldId="500"/>
        </pc:sldMkLst>
        <pc:spChg chg="add mod">
          <ac:chgData name="Derei Wu" userId="935b1b74ff2f2987" providerId="LiveId" clId="{DD6F1DB3-55D6-4344-A5CD-F9938E42967D}" dt="2021-05-08T04:14:44.628" v="11" actId="20577"/>
          <ac:spMkLst>
            <pc:docMk/>
            <pc:sldMk cId="4127656194" sldId="500"/>
            <ac:spMk id="11" creationId="{BF50B14A-9F87-4A7A-AE9C-AD52BBD8DBB4}"/>
          </ac:spMkLst>
        </pc:spChg>
        <pc:spChg chg="mod">
          <ac:chgData name="Derei Wu" userId="935b1b74ff2f2987" providerId="LiveId" clId="{DD6F1DB3-55D6-4344-A5CD-F9938E42967D}" dt="2021-05-08T04:14:42.363" v="10" actId="20577"/>
          <ac:spMkLst>
            <pc:docMk/>
            <pc:sldMk cId="4127656194" sldId="500"/>
            <ac:spMk id="14" creationId="{936FA1D3-5B45-40AB-A225-E4C97C912477}"/>
          </ac:spMkLst>
        </pc:spChg>
      </pc:sldChg>
      <pc:sldChg chg="del">
        <pc:chgData name="Derei Wu" userId="935b1b74ff2f2987" providerId="LiveId" clId="{DD6F1DB3-55D6-4344-A5CD-F9938E42967D}" dt="2021-05-08T03:57:30.536" v="0" actId="2696"/>
        <pc:sldMkLst>
          <pc:docMk/>
          <pc:sldMk cId="192042371" sldId="501"/>
        </pc:sldMkLst>
      </pc:sldChg>
      <pc:sldChg chg="modSp add mod">
        <pc:chgData name="Derei Wu" userId="935b1b74ff2f2987" providerId="LiveId" clId="{DD6F1DB3-55D6-4344-A5CD-F9938E42967D}" dt="2021-05-08T04:14:50.760" v="12" actId="20577"/>
        <pc:sldMkLst>
          <pc:docMk/>
          <pc:sldMk cId="903283632" sldId="501"/>
        </pc:sldMkLst>
        <pc:spChg chg="mod">
          <ac:chgData name="Derei Wu" userId="935b1b74ff2f2987" providerId="LiveId" clId="{DD6F1DB3-55D6-4344-A5CD-F9938E42967D}" dt="2021-05-08T04:14:50.760" v="12" actId="20577"/>
          <ac:spMkLst>
            <pc:docMk/>
            <pc:sldMk cId="903283632" sldId="501"/>
            <ac:spMk id="8" creationId="{05B0F1FD-D170-4D7B-8280-03E9121D1C33}"/>
          </ac:spMkLst>
        </pc:spChg>
      </pc:sldChg>
      <pc:sldChg chg="modSp add mod">
        <pc:chgData name="Derei Wu" userId="935b1b74ff2f2987" providerId="LiveId" clId="{DD6F1DB3-55D6-4344-A5CD-F9938E42967D}" dt="2021-05-08T07:28:26.211" v="18" actId="20577"/>
        <pc:sldMkLst>
          <pc:docMk/>
          <pc:sldMk cId="177023995" sldId="509"/>
        </pc:sldMkLst>
        <pc:spChg chg="mod">
          <ac:chgData name="Derei Wu" userId="935b1b74ff2f2987" providerId="LiveId" clId="{DD6F1DB3-55D6-4344-A5CD-F9938E42967D}" dt="2021-05-08T07:28:26.211" v="18" actId="20577"/>
          <ac:spMkLst>
            <pc:docMk/>
            <pc:sldMk cId="177023995" sldId="509"/>
            <ac:spMk id="16" creationId="{6DB06359-E012-49B5-AB6C-43911B332EF7}"/>
          </ac:spMkLst>
        </pc:spChg>
      </pc:sldChg>
      <pc:sldChg chg="del">
        <pc:chgData name="Derei Wu" userId="935b1b74ff2f2987" providerId="LiveId" clId="{DD6F1DB3-55D6-4344-A5CD-F9938E42967D}" dt="2021-05-08T07:28:10.940" v="16" actId="2696"/>
        <pc:sldMkLst>
          <pc:docMk/>
          <pc:sldMk cId="813633081" sldId="509"/>
        </pc:sldMkLst>
      </pc:sldChg>
      <pc:sldChg chg="ord">
        <pc:chgData name="Derei Wu" userId="935b1b74ff2f2987" providerId="LiveId" clId="{DD6F1DB3-55D6-4344-A5CD-F9938E42967D}" dt="2021-05-29T05:34:48.399" v="46"/>
        <pc:sldMkLst>
          <pc:docMk/>
          <pc:sldMk cId="1754662003" sldId="509"/>
        </pc:sldMkLst>
      </pc:sldChg>
      <pc:sldChg chg="addSp modSp mod">
        <pc:chgData name="Derei Wu" userId="935b1b74ff2f2987" providerId="LiveId" clId="{DD6F1DB3-55D6-4344-A5CD-F9938E42967D}" dt="2021-05-19T07:39:02.133" v="42" actId="1076"/>
        <pc:sldMkLst>
          <pc:docMk/>
          <pc:sldMk cId="2292570021" sldId="512"/>
        </pc:sldMkLst>
        <pc:spChg chg="mod">
          <ac:chgData name="Derei Wu" userId="935b1b74ff2f2987" providerId="LiveId" clId="{DD6F1DB3-55D6-4344-A5CD-F9938E42967D}" dt="2021-05-19T07:39:02.133" v="42" actId="1076"/>
          <ac:spMkLst>
            <pc:docMk/>
            <pc:sldMk cId="2292570021" sldId="512"/>
            <ac:spMk id="13" creationId="{49420599-CEE9-412D-AE2E-F6EAC3525F8A}"/>
          </ac:spMkLst>
        </pc:spChg>
        <pc:picChg chg="add mod modCrop">
          <ac:chgData name="Derei Wu" userId="935b1b74ff2f2987" providerId="LiveId" clId="{DD6F1DB3-55D6-4344-A5CD-F9938E42967D}" dt="2021-05-19T07:38:48.717" v="38" actId="732"/>
          <ac:picMkLst>
            <pc:docMk/>
            <pc:sldMk cId="2292570021" sldId="512"/>
            <ac:picMk id="3" creationId="{2AF651F2-01C5-46B5-AF3A-9430260F9800}"/>
          </ac:picMkLst>
        </pc:picChg>
        <pc:picChg chg="mod">
          <ac:chgData name="Derei Wu" userId="935b1b74ff2f2987" providerId="LiveId" clId="{DD6F1DB3-55D6-4344-A5CD-F9938E42967D}" dt="2021-05-19T07:38:11.859" v="21" actId="14100"/>
          <ac:picMkLst>
            <pc:docMk/>
            <pc:sldMk cId="2292570021" sldId="512"/>
            <ac:picMk id="11" creationId="{B614A086-D9CE-40F1-A52D-BAE159F74BFB}"/>
          </ac:picMkLst>
        </pc:picChg>
        <pc:picChg chg="mod">
          <ac:chgData name="Derei Wu" userId="935b1b74ff2f2987" providerId="LiveId" clId="{DD6F1DB3-55D6-4344-A5CD-F9938E42967D}" dt="2021-05-19T07:38:22.844" v="23" actId="14100"/>
          <ac:picMkLst>
            <pc:docMk/>
            <pc:sldMk cId="2292570021" sldId="512"/>
            <ac:picMk id="12" creationId="{BBA10156-3E40-4D68-99E0-832A3C793077}"/>
          </ac:picMkLst>
        </pc:picChg>
      </pc:sldChg>
      <pc:sldChg chg="addSp delSp modSp mod">
        <pc:chgData name="Derei Wu" userId="935b1b74ff2f2987" providerId="LiveId" clId="{DD6F1DB3-55D6-4344-A5CD-F9938E42967D}" dt="2021-05-29T06:50:57.101" v="63" actId="1076"/>
        <pc:sldMkLst>
          <pc:docMk/>
          <pc:sldMk cId="1203018646" sldId="513"/>
        </pc:sldMkLst>
        <pc:spChg chg="mod">
          <ac:chgData name="Derei Wu" userId="935b1b74ff2f2987" providerId="LiveId" clId="{DD6F1DB3-55D6-4344-A5CD-F9938E42967D}" dt="2021-05-29T06:38:26.143" v="59" actId="1076"/>
          <ac:spMkLst>
            <pc:docMk/>
            <pc:sldMk cId="1203018646" sldId="513"/>
            <ac:spMk id="11" creationId="{2D95BDFC-E002-4EAB-866E-30E1BA22251B}"/>
          </ac:spMkLst>
        </pc:spChg>
        <pc:spChg chg="mod">
          <ac:chgData name="Derei Wu" userId="935b1b74ff2f2987" providerId="LiveId" clId="{DD6F1DB3-55D6-4344-A5CD-F9938E42967D}" dt="2021-05-29T06:50:57.101" v="63" actId="1076"/>
          <ac:spMkLst>
            <pc:docMk/>
            <pc:sldMk cId="1203018646" sldId="513"/>
            <ac:spMk id="12" creationId="{3B42DFE1-76CB-44E5-9210-78402F544CBB}"/>
          </ac:spMkLst>
        </pc:spChg>
        <pc:spChg chg="mod">
          <ac:chgData name="Derei Wu" userId="935b1b74ff2f2987" providerId="LiveId" clId="{DD6F1DB3-55D6-4344-A5CD-F9938E42967D}" dt="2021-05-29T06:50:54.276" v="62" actId="1076"/>
          <ac:spMkLst>
            <pc:docMk/>
            <pc:sldMk cId="1203018646" sldId="513"/>
            <ac:spMk id="13" creationId="{A4567671-6FD6-4AE0-A71A-3BA3C9AC8071}"/>
          </ac:spMkLst>
        </pc:spChg>
        <pc:spChg chg="mod">
          <ac:chgData name="Derei Wu" userId="935b1b74ff2f2987" providerId="LiveId" clId="{DD6F1DB3-55D6-4344-A5CD-F9938E42967D}" dt="2021-05-29T06:38:18.301" v="57"/>
          <ac:spMkLst>
            <pc:docMk/>
            <pc:sldMk cId="1203018646" sldId="513"/>
            <ac:spMk id="31" creationId="{6251D3DA-B79A-46A5-8531-EE7F10197287}"/>
          </ac:spMkLst>
        </pc:spChg>
        <pc:spChg chg="mod">
          <ac:chgData name="Derei Wu" userId="935b1b74ff2f2987" providerId="LiveId" clId="{DD6F1DB3-55D6-4344-A5CD-F9938E42967D}" dt="2021-05-29T06:38:18.301" v="57"/>
          <ac:spMkLst>
            <pc:docMk/>
            <pc:sldMk cId="1203018646" sldId="513"/>
            <ac:spMk id="32" creationId="{252A22DB-2B81-46FF-8936-35A5842585AC}"/>
          </ac:spMkLst>
        </pc:spChg>
        <pc:spChg chg="mod">
          <ac:chgData name="Derei Wu" userId="935b1b74ff2f2987" providerId="LiveId" clId="{DD6F1DB3-55D6-4344-A5CD-F9938E42967D}" dt="2021-05-29T06:38:18.301" v="57"/>
          <ac:spMkLst>
            <pc:docMk/>
            <pc:sldMk cId="1203018646" sldId="513"/>
            <ac:spMk id="33" creationId="{08FFC25C-1EBC-43C4-8CA4-001EAFF020D0}"/>
          </ac:spMkLst>
        </pc:spChg>
        <pc:spChg chg="mod">
          <ac:chgData name="Derei Wu" userId="935b1b74ff2f2987" providerId="LiveId" clId="{DD6F1DB3-55D6-4344-A5CD-F9938E42967D}" dt="2021-05-29T06:38:18.301" v="57"/>
          <ac:spMkLst>
            <pc:docMk/>
            <pc:sldMk cId="1203018646" sldId="513"/>
            <ac:spMk id="35" creationId="{C9F52D57-BAD1-4D89-A773-5BBB9F162567}"/>
          </ac:spMkLst>
        </pc:spChg>
        <pc:spChg chg="mod">
          <ac:chgData name="Derei Wu" userId="935b1b74ff2f2987" providerId="LiveId" clId="{DD6F1DB3-55D6-4344-A5CD-F9938E42967D}" dt="2021-05-29T06:38:18.301" v="57"/>
          <ac:spMkLst>
            <pc:docMk/>
            <pc:sldMk cId="1203018646" sldId="513"/>
            <ac:spMk id="36" creationId="{05E612D1-E3E1-4863-AAA1-3E27D9AEACA9}"/>
          </ac:spMkLst>
        </pc:spChg>
        <pc:grpChg chg="add mod">
          <ac:chgData name="Derei Wu" userId="935b1b74ff2f2987" providerId="LiveId" clId="{DD6F1DB3-55D6-4344-A5CD-F9938E42967D}" dt="2021-05-29T06:38:22.675" v="58" actId="1076"/>
          <ac:grpSpMkLst>
            <pc:docMk/>
            <pc:sldMk cId="1203018646" sldId="513"/>
            <ac:grpSpMk id="14" creationId="{3628665B-BCF9-486A-9B4A-DA519E28789C}"/>
          </ac:grpSpMkLst>
        </pc:grpChg>
        <pc:grpChg chg="mod">
          <ac:chgData name="Derei Wu" userId="935b1b74ff2f2987" providerId="LiveId" clId="{DD6F1DB3-55D6-4344-A5CD-F9938E42967D}" dt="2021-05-29T06:38:18.301" v="57"/>
          <ac:grpSpMkLst>
            <pc:docMk/>
            <pc:sldMk cId="1203018646" sldId="513"/>
            <ac:grpSpMk id="15" creationId="{B8D4F4EE-C6ED-4602-A82A-D50A3AD6837C}"/>
          </ac:grpSpMkLst>
        </pc:grpChg>
        <pc:graphicFrameChg chg="mod">
          <ac:chgData name="Derei Wu" userId="935b1b74ff2f2987" providerId="LiveId" clId="{DD6F1DB3-55D6-4344-A5CD-F9938E42967D}" dt="2021-05-29T06:38:18.301" v="57"/>
          <ac:graphicFrameMkLst>
            <pc:docMk/>
            <pc:sldMk cId="1203018646" sldId="513"/>
            <ac:graphicFrameMk id="16" creationId="{02ED86B2-38DF-42A6-9965-C96F5285A239}"/>
          </ac:graphicFrameMkLst>
        </pc:graphicFrameChg>
        <pc:graphicFrameChg chg="mod">
          <ac:chgData name="Derei Wu" userId="935b1b74ff2f2987" providerId="LiveId" clId="{DD6F1DB3-55D6-4344-A5CD-F9938E42967D}" dt="2021-05-29T06:38:18.301" v="57"/>
          <ac:graphicFrameMkLst>
            <pc:docMk/>
            <pc:sldMk cId="1203018646" sldId="513"/>
            <ac:graphicFrameMk id="17" creationId="{01910D55-BE38-43ED-9B53-EA20D13A0C33}"/>
          </ac:graphicFrameMkLst>
        </pc:graphicFrameChg>
        <pc:graphicFrameChg chg="mod">
          <ac:chgData name="Derei Wu" userId="935b1b74ff2f2987" providerId="LiveId" clId="{DD6F1DB3-55D6-4344-A5CD-F9938E42967D}" dt="2021-05-29T06:38:18.301" v="57"/>
          <ac:graphicFrameMkLst>
            <pc:docMk/>
            <pc:sldMk cId="1203018646" sldId="513"/>
            <ac:graphicFrameMk id="18" creationId="{03230AD5-5F10-4E06-AC78-B697496CE130}"/>
          </ac:graphicFrameMkLst>
        </pc:graphicFrameChg>
        <pc:graphicFrameChg chg="mod">
          <ac:chgData name="Derei Wu" userId="935b1b74ff2f2987" providerId="LiveId" clId="{DD6F1DB3-55D6-4344-A5CD-F9938E42967D}" dt="2021-05-29T06:38:18.301" v="57"/>
          <ac:graphicFrameMkLst>
            <pc:docMk/>
            <pc:sldMk cId="1203018646" sldId="513"/>
            <ac:graphicFrameMk id="19" creationId="{504B2FCB-5873-4FCE-A827-E07DE114ACA2}"/>
          </ac:graphicFrameMkLst>
        </pc:graphicFrameChg>
        <pc:graphicFrameChg chg="mod">
          <ac:chgData name="Derei Wu" userId="935b1b74ff2f2987" providerId="LiveId" clId="{DD6F1DB3-55D6-4344-A5CD-F9938E42967D}" dt="2021-05-29T06:38:18.301" v="57"/>
          <ac:graphicFrameMkLst>
            <pc:docMk/>
            <pc:sldMk cId="1203018646" sldId="513"/>
            <ac:graphicFrameMk id="20" creationId="{FC529F9B-AF8B-4CC3-A6A8-2B0595A43EDA}"/>
          </ac:graphicFrameMkLst>
        </pc:graphicFrameChg>
        <pc:picChg chg="del">
          <ac:chgData name="Derei Wu" userId="935b1b74ff2f2987" providerId="LiveId" clId="{DD6F1DB3-55D6-4344-A5CD-F9938E42967D}" dt="2021-05-29T06:38:17.114" v="56" actId="478"/>
          <ac:picMkLst>
            <pc:docMk/>
            <pc:sldMk cId="1203018646" sldId="513"/>
            <ac:picMk id="5" creationId="{075FAACE-B6BC-4B07-BE7B-955F6083196D}"/>
          </ac:picMkLst>
        </pc:picChg>
        <pc:picChg chg="mod">
          <ac:chgData name="Derei Wu" userId="935b1b74ff2f2987" providerId="LiveId" clId="{DD6F1DB3-55D6-4344-A5CD-F9938E42967D}" dt="2021-05-29T06:38:18.301" v="57"/>
          <ac:picMkLst>
            <pc:docMk/>
            <pc:sldMk cId="1203018646" sldId="513"/>
            <ac:picMk id="30" creationId="{EA9A7CF9-B7FB-458A-819F-55D0B4100840}"/>
          </ac:picMkLst>
        </pc:picChg>
        <pc:cxnChg chg="mod">
          <ac:chgData name="Derei Wu" userId="935b1b74ff2f2987" providerId="LiveId" clId="{DD6F1DB3-55D6-4344-A5CD-F9938E42967D}" dt="2021-05-29T06:38:18.301" v="57"/>
          <ac:cxnSpMkLst>
            <pc:docMk/>
            <pc:sldMk cId="1203018646" sldId="513"/>
            <ac:cxnSpMk id="21" creationId="{A0B2F343-AE56-4569-8072-D062E8E00615}"/>
          </ac:cxnSpMkLst>
        </pc:cxnChg>
        <pc:cxnChg chg="mod">
          <ac:chgData name="Derei Wu" userId="935b1b74ff2f2987" providerId="LiveId" clId="{DD6F1DB3-55D6-4344-A5CD-F9938E42967D}" dt="2021-05-29T06:38:18.301" v="57"/>
          <ac:cxnSpMkLst>
            <pc:docMk/>
            <pc:sldMk cId="1203018646" sldId="513"/>
            <ac:cxnSpMk id="22" creationId="{2077EC57-E209-49CE-AEF9-091BCDBF1A04}"/>
          </ac:cxnSpMkLst>
        </pc:cxnChg>
        <pc:cxnChg chg="mod">
          <ac:chgData name="Derei Wu" userId="935b1b74ff2f2987" providerId="LiveId" clId="{DD6F1DB3-55D6-4344-A5CD-F9938E42967D}" dt="2021-05-29T06:38:18.301" v="57"/>
          <ac:cxnSpMkLst>
            <pc:docMk/>
            <pc:sldMk cId="1203018646" sldId="513"/>
            <ac:cxnSpMk id="23" creationId="{4AD337F9-D070-492C-88F7-2AFA77028C70}"/>
          </ac:cxnSpMkLst>
        </pc:cxnChg>
        <pc:cxnChg chg="mod">
          <ac:chgData name="Derei Wu" userId="935b1b74ff2f2987" providerId="LiveId" clId="{DD6F1DB3-55D6-4344-A5CD-F9938E42967D}" dt="2021-05-29T06:38:18.301" v="57"/>
          <ac:cxnSpMkLst>
            <pc:docMk/>
            <pc:sldMk cId="1203018646" sldId="513"/>
            <ac:cxnSpMk id="24" creationId="{8E51BA2F-3A68-4E4B-897B-B88F37471958}"/>
          </ac:cxnSpMkLst>
        </pc:cxnChg>
        <pc:cxnChg chg="mod">
          <ac:chgData name="Derei Wu" userId="935b1b74ff2f2987" providerId="LiveId" clId="{DD6F1DB3-55D6-4344-A5CD-F9938E42967D}" dt="2021-05-29T06:38:18.301" v="57"/>
          <ac:cxnSpMkLst>
            <pc:docMk/>
            <pc:sldMk cId="1203018646" sldId="513"/>
            <ac:cxnSpMk id="25" creationId="{6ECC9771-0702-4DD6-BC0A-951990C54455}"/>
          </ac:cxnSpMkLst>
        </pc:cxnChg>
        <pc:cxnChg chg="mod">
          <ac:chgData name="Derei Wu" userId="935b1b74ff2f2987" providerId="LiveId" clId="{DD6F1DB3-55D6-4344-A5CD-F9938E42967D}" dt="2021-05-29T06:38:18.301" v="57"/>
          <ac:cxnSpMkLst>
            <pc:docMk/>
            <pc:sldMk cId="1203018646" sldId="513"/>
            <ac:cxnSpMk id="26" creationId="{B4AEF410-F6FA-4290-BF99-BFC8A4C3CBAA}"/>
          </ac:cxnSpMkLst>
        </pc:cxnChg>
        <pc:cxnChg chg="mod">
          <ac:chgData name="Derei Wu" userId="935b1b74ff2f2987" providerId="LiveId" clId="{DD6F1DB3-55D6-4344-A5CD-F9938E42967D}" dt="2021-05-29T06:38:18.301" v="57"/>
          <ac:cxnSpMkLst>
            <pc:docMk/>
            <pc:sldMk cId="1203018646" sldId="513"/>
            <ac:cxnSpMk id="27" creationId="{0EB02D17-B850-419A-9276-96C06F48E279}"/>
          </ac:cxnSpMkLst>
        </pc:cxnChg>
        <pc:cxnChg chg="mod">
          <ac:chgData name="Derei Wu" userId="935b1b74ff2f2987" providerId="LiveId" clId="{DD6F1DB3-55D6-4344-A5CD-F9938E42967D}" dt="2021-05-29T06:38:18.301" v="57"/>
          <ac:cxnSpMkLst>
            <pc:docMk/>
            <pc:sldMk cId="1203018646" sldId="513"/>
            <ac:cxnSpMk id="28" creationId="{61EF3D56-3EFB-43AE-94A0-B35B62738EC7}"/>
          </ac:cxnSpMkLst>
        </pc:cxnChg>
        <pc:cxnChg chg="mod">
          <ac:chgData name="Derei Wu" userId="935b1b74ff2f2987" providerId="LiveId" clId="{DD6F1DB3-55D6-4344-A5CD-F9938E42967D}" dt="2021-05-29T06:38:18.301" v="57"/>
          <ac:cxnSpMkLst>
            <pc:docMk/>
            <pc:sldMk cId="1203018646" sldId="513"/>
            <ac:cxnSpMk id="29" creationId="{0CC2CAA8-2EF7-481A-A4D6-B8CB520BC455}"/>
          </ac:cxnSpMkLst>
        </pc:cxnChg>
        <pc:cxnChg chg="mod">
          <ac:chgData name="Derei Wu" userId="935b1b74ff2f2987" providerId="LiveId" clId="{DD6F1DB3-55D6-4344-A5CD-F9938E42967D}" dt="2021-05-29T06:38:18.301" v="57"/>
          <ac:cxnSpMkLst>
            <pc:docMk/>
            <pc:sldMk cId="1203018646" sldId="513"/>
            <ac:cxnSpMk id="34" creationId="{2A4612D3-39D5-435E-B1E4-08449276A528}"/>
          </ac:cxnSpMkLst>
        </pc:cxnChg>
      </pc:sldChg>
      <pc:sldChg chg="addSp delSp modSp new del mod">
        <pc:chgData name="Derei Wu" userId="935b1b74ff2f2987" providerId="LiveId" clId="{DD6F1DB3-55D6-4344-A5CD-F9938E42967D}" dt="2021-05-29T06:38:32.173" v="60" actId="47"/>
        <pc:sldMkLst>
          <pc:docMk/>
          <pc:sldMk cId="2602478369" sldId="514"/>
        </pc:sldMkLst>
        <pc:spChg chg="del">
          <ac:chgData name="Derei Wu" userId="935b1b74ff2f2987" providerId="LiveId" clId="{DD6F1DB3-55D6-4344-A5CD-F9938E42967D}" dt="2021-05-29T06:18:52.575" v="48" actId="478"/>
          <ac:spMkLst>
            <pc:docMk/>
            <pc:sldMk cId="2602478369" sldId="514"/>
            <ac:spMk id="2" creationId="{93F28B70-229E-4A6E-B6E1-ECD1059C2550}"/>
          </ac:spMkLst>
        </pc:spChg>
        <pc:spChg chg="del">
          <ac:chgData name="Derei Wu" userId="935b1b74ff2f2987" providerId="LiveId" clId="{DD6F1DB3-55D6-4344-A5CD-F9938E42967D}" dt="2021-05-29T06:18:52.575" v="48" actId="478"/>
          <ac:spMkLst>
            <pc:docMk/>
            <pc:sldMk cId="2602478369" sldId="514"/>
            <ac:spMk id="3" creationId="{B2D2212B-C1BE-47F6-A2F6-497A4A815156}"/>
          </ac:spMkLst>
        </pc:spChg>
        <pc:spChg chg="mod">
          <ac:chgData name="Derei Wu" userId="935b1b74ff2f2987" providerId="LiveId" clId="{DD6F1DB3-55D6-4344-A5CD-F9938E42967D}" dt="2021-05-29T06:19:03.051" v="49"/>
          <ac:spMkLst>
            <pc:docMk/>
            <pc:sldMk cId="2602478369" sldId="514"/>
            <ac:spMk id="21" creationId="{F205B57A-EA22-4F99-AAFD-3CB366C0B2F9}"/>
          </ac:spMkLst>
        </pc:spChg>
        <pc:spChg chg="mod">
          <ac:chgData name="Derei Wu" userId="935b1b74ff2f2987" providerId="LiveId" clId="{DD6F1DB3-55D6-4344-A5CD-F9938E42967D}" dt="2021-05-29T06:19:03.051" v="49"/>
          <ac:spMkLst>
            <pc:docMk/>
            <pc:sldMk cId="2602478369" sldId="514"/>
            <ac:spMk id="22" creationId="{B0064C3B-FCE3-490C-9D56-1FF314955021}"/>
          </ac:spMkLst>
        </pc:spChg>
        <pc:spChg chg="mod">
          <ac:chgData name="Derei Wu" userId="935b1b74ff2f2987" providerId="LiveId" clId="{DD6F1DB3-55D6-4344-A5CD-F9938E42967D}" dt="2021-05-29T06:19:03.051" v="49"/>
          <ac:spMkLst>
            <pc:docMk/>
            <pc:sldMk cId="2602478369" sldId="514"/>
            <ac:spMk id="23" creationId="{59B9A895-F5D9-4CA9-85A8-0F70CE9C3DEA}"/>
          </ac:spMkLst>
        </pc:spChg>
        <pc:spChg chg="mod">
          <ac:chgData name="Derei Wu" userId="935b1b74ff2f2987" providerId="LiveId" clId="{DD6F1DB3-55D6-4344-A5CD-F9938E42967D}" dt="2021-05-29T06:19:03.051" v="49"/>
          <ac:spMkLst>
            <pc:docMk/>
            <pc:sldMk cId="2602478369" sldId="514"/>
            <ac:spMk id="25" creationId="{79C41544-5519-4835-9604-28D21F7AAFC7}"/>
          </ac:spMkLst>
        </pc:spChg>
        <pc:spChg chg="mod">
          <ac:chgData name="Derei Wu" userId="935b1b74ff2f2987" providerId="LiveId" clId="{DD6F1DB3-55D6-4344-A5CD-F9938E42967D}" dt="2021-05-29T06:19:03.051" v="49"/>
          <ac:spMkLst>
            <pc:docMk/>
            <pc:sldMk cId="2602478369" sldId="514"/>
            <ac:spMk id="26" creationId="{1FB354E2-C316-40F4-B497-8287BFD25F17}"/>
          </ac:spMkLst>
        </pc:spChg>
        <pc:grpChg chg="add del mod">
          <ac:chgData name="Derei Wu" userId="935b1b74ff2f2987" providerId="LiveId" clId="{DD6F1DB3-55D6-4344-A5CD-F9938E42967D}" dt="2021-05-29T06:38:15.224" v="55" actId="21"/>
          <ac:grpSpMkLst>
            <pc:docMk/>
            <pc:sldMk cId="2602478369" sldId="514"/>
            <ac:grpSpMk id="4" creationId="{1BC7E4E7-0F50-46BF-BB4A-F4BFFD31F782}"/>
          </ac:grpSpMkLst>
        </pc:grpChg>
        <pc:grpChg chg="mod">
          <ac:chgData name="Derei Wu" userId="935b1b74ff2f2987" providerId="LiveId" clId="{DD6F1DB3-55D6-4344-A5CD-F9938E42967D}" dt="2021-05-29T06:19:03.051" v="49"/>
          <ac:grpSpMkLst>
            <pc:docMk/>
            <pc:sldMk cId="2602478369" sldId="514"/>
            <ac:grpSpMk id="5" creationId="{B75D41EE-9652-4DC5-AC51-95346B4F894F}"/>
          </ac:grpSpMkLst>
        </pc:grpChg>
        <pc:graphicFrameChg chg="mod">
          <ac:chgData name="Derei Wu" userId="935b1b74ff2f2987" providerId="LiveId" clId="{DD6F1DB3-55D6-4344-A5CD-F9938E42967D}" dt="2021-05-29T06:19:03.051" v="49"/>
          <ac:graphicFrameMkLst>
            <pc:docMk/>
            <pc:sldMk cId="2602478369" sldId="514"/>
            <ac:graphicFrameMk id="6" creationId="{44F3B736-0300-4029-A38C-0B282E8A15CB}"/>
          </ac:graphicFrameMkLst>
        </pc:graphicFrameChg>
        <pc:graphicFrameChg chg="mod">
          <ac:chgData name="Derei Wu" userId="935b1b74ff2f2987" providerId="LiveId" clId="{DD6F1DB3-55D6-4344-A5CD-F9938E42967D}" dt="2021-05-29T06:19:03.051" v="49"/>
          <ac:graphicFrameMkLst>
            <pc:docMk/>
            <pc:sldMk cId="2602478369" sldId="514"/>
            <ac:graphicFrameMk id="7" creationId="{CD0D12E8-3F94-49FB-9626-765F126044AD}"/>
          </ac:graphicFrameMkLst>
        </pc:graphicFrameChg>
        <pc:graphicFrameChg chg="mod">
          <ac:chgData name="Derei Wu" userId="935b1b74ff2f2987" providerId="LiveId" clId="{DD6F1DB3-55D6-4344-A5CD-F9938E42967D}" dt="2021-05-29T06:19:03.051" v="49"/>
          <ac:graphicFrameMkLst>
            <pc:docMk/>
            <pc:sldMk cId="2602478369" sldId="514"/>
            <ac:graphicFrameMk id="8" creationId="{8DFDA80C-71DB-4635-BE78-7C5D31EA853B}"/>
          </ac:graphicFrameMkLst>
        </pc:graphicFrameChg>
        <pc:graphicFrameChg chg="mod">
          <ac:chgData name="Derei Wu" userId="935b1b74ff2f2987" providerId="LiveId" clId="{DD6F1DB3-55D6-4344-A5CD-F9938E42967D}" dt="2021-05-29T06:19:03.051" v="49"/>
          <ac:graphicFrameMkLst>
            <pc:docMk/>
            <pc:sldMk cId="2602478369" sldId="514"/>
            <ac:graphicFrameMk id="9" creationId="{A138C89E-1C0D-44DD-8DF1-8BB423C2222B}"/>
          </ac:graphicFrameMkLst>
        </pc:graphicFrameChg>
        <pc:graphicFrameChg chg="mod">
          <ac:chgData name="Derei Wu" userId="935b1b74ff2f2987" providerId="LiveId" clId="{DD6F1DB3-55D6-4344-A5CD-F9938E42967D}" dt="2021-05-29T06:19:03.051" v="49"/>
          <ac:graphicFrameMkLst>
            <pc:docMk/>
            <pc:sldMk cId="2602478369" sldId="514"/>
            <ac:graphicFrameMk id="10" creationId="{9E668750-0F0B-47A5-88D7-79207F6F1DAE}"/>
          </ac:graphicFrameMkLst>
        </pc:graphicFrameChg>
        <pc:picChg chg="mod">
          <ac:chgData name="Derei Wu" userId="935b1b74ff2f2987" providerId="LiveId" clId="{DD6F1DB3-55D6-4344-A5CD-F9938E42967D}" dt="2021-05-29T06:19:03.051" v="49"/>
          <ac:picMkLst>
            <pc:docMk/>
            <pc:sldMk cId="2602478369" sldId="514"/>
            <ac:picMk id="20" creationId="{F402537F-DD48-46C5-8B77-BBFE77C1EF19}"/>
          </ac:picMkLst>
        </pc:picChg>
        <pc:cxnChg chg="mod">
          <ac:chgData name="Derei Wu" userId="935b1b74ff2f2987" providerId="LiveId" clId="{DD6F1DB3-55D6-4344-A5CD-F9938E42967D}" dt="2021-05-29T06:19:03.051" v="49"/>
          <ac:cxnSpMkLst>
            <pc:docMk/>
            <pc:sldMk cId="2602478369" sldId="514"/>
            <ac:cxnSpMk id="11" creationId="{6098915C-5758-46B0-BC02-E5A7EA66A341}"/>
          </ac:cxnSpMkLst>
        </pc:cxnChg>
        <pc:cxnChg chg="mod">
          <ac:chgData name="Derei Wu" userId="935b1b74ff2f2987" providerId="LiveId" clId="{DD6F1DB3-55D6-4344-A5CD-F9938E42967D}" dt="2021-05-29T06:19:03.051" v="49"/>
          <ac:cxnSpMkLst>
            <pc:docMk/>
            <pc:sldMk cId="2602478369" sldId="514"/>
            <ac:cxnSpMk id="12" creationId="{C7FB0CD7-B59D-4572-801D-EEFBAD590299}"/>
          </ac:cxnSpMkLst>
        </pc:cxnChg>
        <pc:cxnChg chg="mod">
          <ac:chgData name="Derei Wu" userId="935b1b74ff2f2987" providerId="LiveId" clId="{DD6F1DB3-55D6-4344-A5CD-F9938E42967D}" dt="2021-05-29T06:19:03.051" v="49"/>
          <ac:cxnSpMkLst>
            <pc:docMk/>
            <pc:sldMk cId="2602478369" sldId="514"/>
            <ac:cxnSpMk id="13" creationId="{C33AA686-9A5E-4F0D-AAEF-34E863CDB83E}"/>
          </ac:cxnSpMkLst>
        </pc:cxnChg>
        <pc:cxnChg chg="mod">
          <ac:chgData name="Derei Wu" userId="935b1b74ff2f2987" providerId="LiveId" clId="{DD6F1DB3-55D6-4344-A5CD-F9938E42967D}" dt="2021-05-29T06:19:03.051" v="49"/>
          <ac:cxnSpMkLst>
            <pc:docMk/>
            <pc:sldMk cId="2602478369" sldId="514"/>
            <ac:cxnSpMk id="14" creationId="{A2DD8C13-98CE-415D-B32E-47B31985A8C2}"/>
          </ac:cxnSpMkLst>
        </pc:cxnChg>
        <pc:cxnChg chg="mod">
          <ac:chgData name="Derei Wu" userId="935b1b74ff2f2987" providerId="LiveId" clId="{DD6F1DB3-55D6-4344-A5CD-F9938E42967D}" dt="2021-05-29T06:19:03.051" v="49"/>
          <ac:cxnSpMkLst>
            <pc:docMk/>
            <pc:sldMk cId="2602478369" sldId="514"/>
            <ac:cxnSpMk id="15" creationId="{D8F36D98-B594-4C0C-BB93-F6DD48E802AD}"/>
          </ac:cxnSpMkLst>
        </pc:cxnChg>
        <pc:cxnChg chg="mod">
          <ac:chgData name="Derei Wu" userId="935b1b74ff2f2987" providerId="LiveId" clId="{DD6F1DB3-55D6-4344-A5CD-F9938E42967D}" dt="2021-05-29T06:19:03.051" v="49"/>
          <ac:cxnSpMkLst>
            <pc:docMk/>
            <pc:sldMk cId="2602478369" sldId="514"/>
            <ac:cxnSpMk id="16" creationId="{6F6EBE0C-9AC1-43CC-B705-4768C58C46A3}"/>
          </ac:cxnSpMkLst>
        </pc:cxnChg>
        <pc:cxnChg chg="mod">
          <ac:chgData name="Derei Wu" userId="935b1b74ff2f2987" providerId="LiveId" clId="{DD6F1DB3-55D6-4344-A5CD-F9938E42967D}" dt="2021-05-29T06:19:03.051" v="49"/>
          <ac:cxnSpMkLst>
            <pc:docMk/>
            <pc:sldMk cId="2602478369" sldId="514"/>
            <ac:cxnSpMk id="17" creationId="{1F204E5E-7F11-44EC-BA8C-40D217358B47}"/>
          </ac:cxnSpMkLst>
        </pc:cxnChg>
        <pc:cxnChg chg="mod">
          <ac:chgData name="Derei Wu" userId="935b1b74ff2f2987" providerId="LiveId" clId="{DD6F1DB3-55D6-4344-A5CD-F9938E42967D}" dt="2021-05-29T06:19:03.051" v="49"/>
          <ac:cxnSpMkLst>
            <pc:docMk/>
            <pc:sldMk cId="2602478369" sldId="514"/>
            <ac:cxnSpMk id="18" creationId="{C2F44FE6-3677-42E1-BFC8-F571748EB14C}"/>
          </ac:cxnSpMkLst>
        </pc:cxnChg>
        <pc:cxnChg chg="mod">
          <ac:chgData name="Derei Wu" userId="935b1b74ff2f2987" providerId="LiveId" clId="{DD6F1DB3-55D6-4344-A5CD-F9938E42967D}" dt="2021-05-29T06:19:03.051" v="49"/>
          <ac:cxnSpMkLst>
            <pc:docMk/>
            <pc:sldMk cId="2602478369" sldId="514"/>
            <ac:cxnSpMk id="19" creationId="{D86DDB1F-8525-4474-A8CE-5083E73E74A2}"/>
          </ac:cxnSpMkLst>
        </pc:cxnChg>
        <pc:cxnChg chg="mod">
          <ac:chgData name="Derei Wu" userId="935b1b74ff2f2987" providerId="LiveId" clId="{DD6F1DB3-55D6-4344-A5CD-F9938E42967D}" dt="2021-05-29T06:19:03.051" v="49"/>
          <ac:cxnSpMkLst>
            <pc:docMk/>
            <pc:sldMk cId="2602478369" sldId="514"/>
            <ac:cxnSpMk id="24" creationId="{118D8BC2-58EA-4115-9D9B-0C0A650CC2BC}"/>
          </ac:cxnSpMkLst>
        </pc:cxnChg>
      </pc:sldChg>
    </pc:docChg>
  </pc:docChgLst>
  <pc:docChgLst>
    <pc:chgData name="Derei Wu" userId="935b1b74ff2f2987" providerId="LiveId" clId="{7314F847-4F81-4D57-9414-F91F95C203C4}"/>
    <pc:docChg chg="undo custSel addSld delSld modSld sldOrd">
      <pc:chgData name="Derei Wu" userId="935b1b74ff2f2987" providerId="LiveId" clId="{7314F847-4F81-4D57-9414-F91F95C203C4}" dt="2021-08-13T07:13:10.123" v="564" actId="20577"/>
      <pc:docMkLst>
        <pc:docMk/>
      </pc:docMkLst>
      <pc:sldChg chg="addSp delSp modSp mod">
        <pc:chgData name="Derei Wu" userId="935b1b74ff2f2987" providerId="LiveId" clId="{7314F847-4F81-4D57-9414-F91F95C203C4}" dt="2021-08-13T07:13:10.123" v="564" actId="20577"/>
        <pc:sldMkLst>
          <pc:docMk/>
          <pc:sldMk cId="1852453233" sldId="281"/>
        </pc:sldMkLst>
        <pc:spChg chg="mod">
          <ac:chgData name="Derei Wu" userId="935b1b74ff2f2987" providerId="LiveId" clId="{7314F847-4F81-4D57-9414-F91F95C203C4}" dt="2021-08-13T07:13:08.099" v="563" actId="20577"/>
          <ac:spMkLst>
            <pc:docMk/>
            <pc:sldMk cId="1852453233" sldId="281"/>
            <ac:spMk id="2" creationId="{A4B57805-CDFD-4943-8F27-B65F2C07FFD8}"/>
          </ac:spMkLst>
        </pc:spChg>
        <pc:spChg chg="mod">
          <ac:chgData name="Derei Wu" userId="935b1b74ff2f2987" providerId="LiveId" clId="{7314F847-4F81-4D57-9414-F91F95C203C4}" dt="2021-08-13T07:13:10.123" v="564" actId="20577"/>
          <ac:spMkLst>
            <pc:docMk/>
            <pc:sldMk cId="1852453233" sldId="281"/>
            <ac:spMk id="14" creationId="{6AEBF1A3-E155-4211-BD38-3B19B797930B}"/>
          </ac:spMkLst>
        </pc:spChg>
        <pc:spChg chg="add del mod">
          <ac:chgData name="Derei Wu" userId="935b1b74ff2f2987" providerId="LiveId" clId="{7314F847-4F81-4D57-9414-F91F95C203C4}" dt="2021-08-13T07:12:54.112" v="558" actId="21"/>
          <ac:spMkLst>
            <pc:docMk/>
            <pc:sldMk cId="1852453233" sldId="281"/>
            <ac:spMk id="16" creationId="{C0F0FEDF-2534-47C0-8CFA-0076F2D81F3D}"/>
          </ac:spMkLst>
        </pc:spChg>
        <pc:spChg chg="add mod">
          <ac:chgData name="Derei Wu" userId="935b1b74ff2f2987" providerId="LiveId" clId="{7314F847-4F81-4D57-9414-F91F95C203C4}" dt="2021-08-13T07:13:05.960" v="562" actId="20577"/>
          <ac:spMkLst>
            <pc:docMk/>
            <pc:sldMk cId="1852453233" sldId="281"/>
            <ac:spMk id="21" creationId="{75FB851A-3DFB-434E-BC3A-3197BF89820E}"/>
          </ac:spMkLst>
        </pc:spChg>
        <pc:graphicFrameChg chg="mod">
          <ac:chgData name="Derei Wu" userId="935b1b74ff2f2987" providerId="LiveId" clId="{7314F847-4F81-4D57-9414-F91F95C203C4}" dt="2021-08-13T07:12:58.453" v="559" actId="1076"/>
          <ac:graphicFrameMkLst>
            <pc:docMk/>
            <pc:sldMk cId="1852453233" sldId="281"/>
            <ac:graphicFrameMk id="3" creationId="{E33A36ED-7717-4CC0-90FA-C2DBD66D98DC}"/>
          </ac:graphicFrameMkLst>
        </pc:graphicFrameChg>
        <pc:graphicFrameChg chg="add del mod">
          <ac:chgData name="Derei Wu" userId="935b1b74ff2f2987" providerId="LiveId" clId="{7314F847-4F81-4D57-9414-F91F95C203C4}" dt="2021-08-13T07:12:54.112" v="558" actId="21"/>
          <ac:graphicFrameMkLst>
            <pc:docMk/>
            <pc:sldMk cId="1852453233" sldId="281"/>
            <ac:graphicFrameMk id="4" creationId="{93A8BCA7-9C7F-451F-8A63-D966A3540DB9}"/>
          </ac:graphicFrameMkLst>
        </pc:graphicFrameChg>
        <pc:graphicFrameChg chg="add del mod">
          <ac:chgData name="Derei Wu" userId="935b1b74ff2f2987" providerId="LiveId" clId="{7314F847-4F81-4D57-9414-F91F95C203C4}" dt="2021-08-13T07:12:54.112" v="558" actId="21"/>
          <ac:graphicFrameMkLst>
            <pc:docMk/>
            <pc:sldMk cId="1852453233" sldId="281"/>
            <ac:graphicFrameMk id="5" creationId="{36726A0D-5FF4-4A49-A4FF-E8129B61C5C3}"/>
          </ac:graphicFrameMkLst>
        </pc:graphicFrameChg>
        <pc:graphicFrameChg chg="mod">
          <ac:chgData name="Derei Wu" userId="935b1b74ff2f2987" providerId="LiveId" clId="{7314F847-4F81-4D57-9414-F91F95C203C4}" dt="2021-08-13T07:12:58.453" v="559" actId="1076"/>
          <ac:graphicFrameMkLst>
            <pc:docMk/>
            <pc:sldMk cId="1852453233" sldId="281"/>
            <ac:graphicFrameMk id="9" creationId="{5CD7DE07-1C36-45AF-ADDB-F2DDD3D6104D}"/>
          </ac:graphicFrameMkLst>
        </pc:graphicFrameChg>
        <pc:graphicFrameChg chg="mod">
          <ac:chgData name="Derei Wu" userId="935b1b74ff2f2987" providerId="LiveId" clId="{7314F847-4F81-4D57-9414-F91F95C203C4}" dt="2021-08-13T07:12:58.453" v="559" actId="1076"/>
          <ac:graphicFrameMkLst>
            <pc:docMk/>
            <pc:sldMk cId="1852453233" sldId="281"/>
            <ac:graphicFrameMk id="12" creationId="{1626B093-F7C8-4522-A35D-B6C5D93709D3}"/>
          </ac:graphicFrameMkLst>
        </pc:graphicFrameChg>
        <pc:graphicFrameChg chg="mod">
          <ac:chgData name="Derei Wu" userId="935b1b74ff2f2987" providerId="LiveId" clId="{7314F847-4F81-4D57-9414-F91F95C203C4}" dt="2021-08-13T07:12:58.453" v="559" actId="1076"/>
          <ac:graphicFrameMkLst>
            <pc:docMk/>
            <pc:sldMk cId="1852453233" sldId="281"/>
            <ac:graphicFrameMk id="13" creationId="{9845E477-FD1E-42FC-8F9C-7F65EC37D52D}"/>
          </ac:graphicFrameMkLst>
        </pc:graphicFrameChg>
        <pc:graphicFrameChg chg="add mod">
          <ac:chgData name="Derei Wu" userId="935b1b74ff2f2987" providerId="LiveId" clId="{7314F847-4F81-4D57-9414-F91F95C203C4}" dt="2021-08-13T07:13:03.274" v="561" actId="1076"/>
          <ac:graphicFrameMkLst>
            <pc:docMk/>
            <pc:sldMk cId="1852453233" sldId="281"/>
            <ac:graphicFrameMk id="18" creationId="{853C9307-2C7C-49FC-AAD2-3F690C04E356}"/>
          </ac:graphicFrameMkLst>
        </pc:graphicFrameChg>
        <pc:graphicFrameChg chg="add mod">
          <ac:chgData name="Derei Wu" userId="935b1b74ff2f2987" providerId="LiveId" clId="{7314F847-4F81-4D57-9414-F91F95C203C4}" dt="2021-08-13T07:13:03.274" v="561" actId="1076"/>
          <ac:graphicFrameMkLst>
            <pc:docMk/>
            <pc:sldMk cId="1852453233" sldId="281"/>
            <ac:graphicFrameMk id="19" creationId="{C0334613-3127-4336-8020-BBD0350686FE}"/>
          </ac:graphicFrameMkLst>
        </pc:graphicFrameChg>
        <pc:graphicFrameChg chg="mod">
          <ac:chgData name="Derei Wu" userId="935b1b74ff2f2987" providerId="LiveId" clId="{7314F847-4F81-4D57-9414-F91F95C203C4}" dt="2021-08-13T07:12:58.453" v="559" actId="1076"/>
          <ac:graphicFrameMkLst>
            <pc:docMk/>
            <pc:sldMk cId="1852453233" sldId="281"/>
            <ac:graphicFrameMk id="20" creationId="{233B2F3F-32DE-4853-AA42-AE4E1B6E6685}"/>
          </ac:graphicFrameMkLst>
        </pc:graphicFrameChg>
        <pc:graphicFrameChg chg="mod">
          <ac:chgData name="Derei Wu" userId="935b1b74ff2f2987" providerId="LiveId" clId="{7314F847-4F81-4D57-9414-F91F95C203C4}" dt="2021-08-13T07:12:58.453" v="559" actId="1076"/>
          <ac:graphicFrameMkLst>
            <pc:docMk/>
            <pc:sldMk cId="1852453233" sldId="281"/>
            <ac:graphicFrameMk id="23" creationId="{5EEE791A-E255-4196-9141-8116471CEA50}"/>
          </ac:graphicFrameMkLst>
        </pc:graphicFrameChg>
        <pc:graphicFrameChg chg="mod">
          <ac:chgData name="Derei Wu" userId="935b1b74ff2f2987" providerId="LiveId" clId="{7314F847-4F81-4D57-9414-F91F95C203C4}" dt="2021-08-13T07:12:58.453" v="559" actId="1076"/>
          <ac:graphicFrameMkLst>
            <pc:docMk/>
            <pc:sldMk cId="1852453233" sldId="281"/>
            <ac:graphicFrameMk id="24" creationId="{4B263A78-133C-41B2-B763-6CD097A92E05}"/>
          </ac:graphicFrameMkLst>
        </pc:graphicFrameChg>
      </pc:sldChg>
      <pc:sldChg chg="addSp modSp mod">
        <pc:chgData name="Derei Wu" userId="935b1b74ff2f2987" providerId="LiveId" clId="{7314F847-4F81-4D57-9414-F91F95C203C4}" dt="2021-08-13T01:35:22.947" v="266" actId="6549"/>
        <pc:sldMkLst>
          <pc:docMk/>
          <pc:sldMk cId="4127656194" sldId="500"/>
        </pc:sldMkLst>
        <pc:spChg chg="add mod">
          <ac:chgData name="Derei Wu" userId="935b1b74ff2f2987" providerId="LiveId" clId="{7314F847-4F81-4D57-9414-F91F95C203C4}" dt="2021-08-13T01:35:08.814" v="262"/>
          <ac:spMkLst>
            <pc:docMk/>
            <pc:sldMk cId="4127656194" sldId="500"/>
            <ac:spMk id="11" creationId="{011FF37A-3DC0-4001-88A2-750165559D6C}"/>
          </ac:spMkLst>
        </pc:spChg>
        <pc:spChg chg="mod">
          <ac:chgData name="Derei Wu" userId="935b1b74ff2f2987" providerId="LiveId" clId="{7314F847-4F81-4D57-9414-F91F95C203C4}" dt="2021-08-13T01:35:22.947" v="266" actId="6549"/>
          <ac:spMkLst>
            <pc:docMk/>
            <pc:sldMk cId="4127656194" sldId="500"/>
            <ac:spMk id="14" creationId="{936FA1D3-5B45-40AB-A225-E4C97C912477}"/>
          </ac:spMkLst>
        </pc:spChg>
      </pc:sldChg>
      <pc:sldChg chg="addSp delSp modSp del mod">
        <pc:chgData name="Derei Wu" userId="935b1b74ff2f2987" providerId="LiveId" clId="{7314F847-4F81-4D57-9414-F91F95C203C4}" dt="2021-08-13T01:35:15.347" v="264" actId="47"/>
        <pc:sldMkLst>
          <pc:docMk/>
          <pc:sldMk cId="903283632" sldId="501"/>
        </pc:sldMkLst>
        <pc:spChg chg="add del mod">
          <ac:chgData name="Derei Wu" userId="935b1b74ff2f2987" providerId="LiveId" clId="{7314F847-4F81-4D57-9414-F91F95C203C4}" dt="2021-08-13T01:35:12.227" v="263" actId="478"/>
          <ac:spMkLst>
            <pc:docMk/>
            <pc:sldMk cId="903283632" sldId="501"/>
            <ac:spMk id="4" creationId="{6A251C1B-9051-4CC2-9132-68999A3C9F7C}"/>
          </ac:spMkLst>
        </pc:spChg>
        <pc:spChg chg="del">
          <ac:chgData name="Derei Wu" userId="935b1b74ff2f2987" providerId="LiveId" clId="{7314F847-4F81-4D57-9414-F91F95C203C4}" dt="2021-08-13T01:35:07.103" v="261" actId="21"/>
          <ac:spMkLst>
            <pc:docMk/>
            <pc:sldMk cId="903283632" sldId="501"/>
            <ac:spMk id="8" creationId="{05B0F1FD-D170-4D7B-8280-03E9121D1C33}"/>
          </ac:spMkLst>
        </pc:spChg>
      </pc:sldChg>
      <pc:sldChg chg="addSp delSp modSp mod">
        <pc:chgData name="Derei Wu" userId="935b1b74ff2f2987" providerId="LiveId" clId="{7314F847-4F81-4D57-9414-F91F95C203C4}" dt="2021-08-13T01:47:06.792" v="539" actId="20577"/>
        <pc:sldMkLst>
          <pc:docMk/>
          <pc:sldMk cId="1203018646" sldId="513"/>
        </pc:sldMkLst>
        <pc:spChg chg="add del mod">
          <ac:chgData name="Derei Wu" userId="935b1b74ff2f2987" providerId="LiveId" clId="{7314F847-4F81-4D57-9414-F91F95C203C4}" dt="2021-08-13T01:36:13.281" v="271" actId="478"/>
          <ac:spMkLst>
            <pc:docMk/>
            <pc:sldMk cId="1203018646" sldId="513"/>
            <ac:spMk id="4" creationId="{7003D88B-B1B3-4460-92BB-545145101193}"/>
          </ac:spMkLst>
        </pc:spChg>
        <pc:spChg chg="del">
          <ac:chgData name="Derei Wu" userId="935b1b74ff2f2987" providerId="LiveId" clId="{7314F847-4F81-4D57-9414-F91F95C203C4}" dt="2021-08-13T01:36:12.012" v="270" actId="478"/>
          <ac:spMkLst>
            <pc:docMk/>
            <pc:sldMk cId="1203018646" sldId="513"/>
            <ac:spMk id="7" creationId="{A7C5FE25-3BB6-469A-AB20-9EAFF2E64461}"/>
          </ac:spMkLst>
        </pc:spChg>
        <pc:spChg chg="add mod">
          <ac:chgData name="Derei Wu" userId="935b1b74ff2f2987" providerId="LiveId" clId="{7314F847-4F81-4D57-9414-F91F95C203C4}" dt="2021-08-13T01:47:06.792" v="539" actId="20577"/>
          <ac:spMkLst>
            <pc:docMk/>
            <pc:sldMk cId="1203018646" sldId="513"/>
            <ac:spMk id="11" creationId="{9FE102CF-EF5E-4DDB-935B-D44511C27B57}"/>
          </ac:spMkLst>
        </pc:spChg>
        <pc:picChg chg="add mod">
          <ac:chgData name="Derei Wu" userId="935b1b74ff2f2987" providerId="LiveId" clId="{7314F847-4F81-4D57-9414-F91F95C203C4}" dt="2021-08-13T01:36:32.908" v="296" actId="1076"/>
          <ac:picMkLst>
            <pc:docMk/>
            <pc:sldMk cId="1203018646" sldId="513"/>
            <ac:picMk id="3" creationId="{BF1E4021-2525-46D1-AA2E-9E005E036425}"/>
          </ac:picMkLst>
        </pc:picChg>
        <pc:picChg chg="add mod">
          <ac:chgData name="Derei Wu" userId="935b1b74ff2f2987" providerId="LiveId" clId="{7314F847-4F81-4D57-9414-F91F95C203C4}" dt="2021-08-13T01:36:32.908" v="296" actId="1076"/>
          <ac:picMkLst>
            <pc:docMk/>
            <pc:sldMk cId="1203018646" sldId="513"/>
            <ac:picMk id="5" creationId="{0E66C1CA-0285-4785-BEF1-04F64927118C}"/>
          </ac:picMkLst>
        </pc:picChg>
        <pc:picChg chg="add mod">
          <ac:chgData name="Derei Wu" userId="935b1b74ff2f2987" providerId="LiveId" clId="{7314F847-4F81-4D57-9414-F91F95C203C4}" dt="2021-08-13T01:36:32.908" v="296" actId="1076"/>
          <ac:picMkLst>
            <pc:docMk/>
            <pc:sldMk cId="1203018646" sldId="513"/>
            <ac:picMk id="8" creationId="{DEFAD34B-3800-4850-9EA6-C5251BB5A3CC}"/>
          </ac:picMkLst>
        </pc:picChg>
        <pc:picChg chg="add del mod">
          <ac:chgData name="Derei Wu" userId="935b1b74ff2f2987" providerId="LiveId" clId="{7314F847-4F81-4D57-9414-F91F95C203C4}" dt="2021-08-12T06:57:35.746" v="225" actId="478"/>
          <ac:picMkLst>
            <pc:docMk/>
            <pc:sldMk cId="1203018646" sldId="513"/>
            <ac:picMk id="10" creationId="{AEE7F272-3135-4C4B-9F31-54CC7A479956}"/>
          </ac:picMkLst>
        </pc:picChg>
        <pc:picChg chg="add mod">
          <ac:chgData name="Derei Wu" userId="935b1b74ff2f2987" providerId="LiveId" clId="{7314F847-4F81-4D57-9414-F91F95C203C4}" dt="2021-08-13T01:36:32.908" v="296" actId="1076"/>
          <ac:picMkLst>
            <pc:docMk/>
            <pc:sldMk cId="1203018646" sldId="513"/>
            <ac:picMk id="12" creationId="{096B2D58-71A4-4167-906E-D6B80F5D2585}"/>
          </ac:picMkLst>
        </pc:picChg>
        <pc:picChg chg="add mod">
          <ac:chgData name="Derei Wu" userId="935b1b74ff2f2987" providerId="LiveId" clId="{7314F847-4F81-4D57-9414-F91F95C203C4}" dt="2021-08-13T01:36:32.908" v="296" actId="1076"/>
          <ac:picMkLst>
            <pc:docMk/>
            <pc:sldMk cId="1203018646" sldId="513"/>
            <ac:picMk id="14" creationId="{5213B82E-48B5-405C-9509-6C4B523F73C3}"/>
          </ac:picMkLst>
        </pc:picChg>
        <pc:picChg chg="add mod">
          <ac:chgData name="Derei Wu" userId="935b1b74ff2f2987" providerId="LiveId" clId="{7314F847-4F81-4D57-9414-F91F95C203C4}" dt="2021-08-13T01:36:32.908" v="296" actId="1076"/>
          <ac:picMkLst>
            <pc:docMk/>
            <pc:sldMk cId="1203018646" sldId="513"/>
            <ac:picMk id="16" creationId="{A3233FB8-89A9-4B82-8F16-659C0E869357}"/>
          </ac:picMkLst>
        </pc:picChg>
      </pc:sldChg>
      <pc:sldChg chg="addSp delSp modSp add mod">
        <pc:chgData name="Derei Wu" userId="935b1b74ff2f2987" providerId="LiveId" clId="{7314F847-4F81-4D57-9414-F91F95C203C4}" dt="2021-08-12T06:36:21.046" v="210" actId="20577"/>
        <pc:sldMkLst>
          <pc:docMk/>
          <pc:sldMk cId="646338076" sldId="514"/>
        </pc:sldMkLst>
        <pc:spChg chg="mod">
          <ac:chgData name="Derei Wu" userId="935b1b74ff2f2987" providerId="LiveId" clId="{7314F847-4F81-4D57-9414-F91F95C203C4}" dt="2021-08-12T06:19:47.808" v="1" actId="20577"/>
          <ac:spMkLst>
            <pc:docMk/>
            <pc:sldMk cId="646338076" sldId="514"/>
            <ac:spMk id="7" creationId="{A7C5FE25-3BB6-469A-AB20-9EAFF2E64461}"/>
          </ac:spMkLst>
        </pc:spChg>
        <pc:spChg chg="add mod">
          <ac:chgData name="Derei Wu" userId="935b1b74ff2f2987" providerId="LiveId" clId="{7314F847-4F81-4D57-9414-F91F95C203C4}" dt="2021-08-12T06:35:03.331" v="181" actId="1035"/>
          <ac:spMkLst>
            <pc:docMk/>
            <pc:sldMk cId="646338076" sldId="514"/>
            <ac:spMk id="11" creationId="{B16FD76B-1D87-42AD-95C0-B94EF52686FB}"/>
          </ac:spMkLst>
        </pc:spChg>
        <pc:spChg chg="add mod">
          <ac:chgData name="Derei Wu" userId="935b1b74ff2f2987" providerId="LiveId" clId="{7314F847-4F81-4D57-9414-F91F95C203C4}" dt="2021-08-12T06:35:40.068" v="196" actId="1037"/>
          <ac:spMkLst>
            <pc:docMk/>
            <pc:sldMk cId="646338076" sldId="514"/>
            <ac:spMk id="12" creationId="{9F4D00E2-A587-4E3B-A220-EB0798C65571}"/>
          </ac:spMkLst>
        </pc:spChg>
        <pc:spChg chg="add mod">
          <ac:chgData name="Derei Wu" userId="935b1b74ff2f2987" providerId="LiveId" clId="{7314F847-4F81-4D57-9414-F91F95C203C4}" dt="2021-08-12T06:35:48.707" v="198" actId="1036"/>
          <ac:spMkLst>
            <pc:docMk/>
            <pc:sldMk cId="646338076" sldId="514"/>
            <ac:spMk id="13" creationId="{02BCA94A-D745-4F48-81AD-C1D41F9EB8BA}"/>
          </ac:spMkLst>
        </pc:spChg>
        <pc:spChg chg="add mod">
          <ac:chgData name="Derei Wu" userId="935b1b74ff2f2987" providerId="LiveId" clId="{7314F847-4F81-4D57-9414-F91F95C203C4}" dt="2021-08-12T06:35:53.508" v="200" actId="1076"/>
          <ac:spMkLst>
            <pc:docMk/>
            <pc:sldMk cId="646338076" sldId="514"/>
            <ac:spMk id="14" creationId="{9BCE58DD-8000-447F-A236-F14C26550057}"/>
          </ac:spMkLst>
        </pc:spChg>
        <pc:spChg chg="add del mod">
          <ac:chgData name="Derei Wu" userId="935b1b74ff2f2987" providerId="LiveId" clId="{7314F847-4F81-4D57-9414-F91F95C203C4}" dt="2021-08-12T06:23:53.829" v="46" actId="478"/>
          <ac:spMkLst>
            <pc:docMk/>
            <pc:sldMk cId="646338076" sldId="514"/>
            <ac:spMk id="15" creationId="{F0838B13-8F7F-4C22-8550-1B348BD25E41}"/>
          </ac:spMkLst>
        </pc:spChg>
        <pc:spChg chg="add mod">
          <ac:chgData name="Derei Wu" userId="935b1b74ff2f2987" providerId="LiveId" clId="{7314F847-4F81-4D57-9414-F91F95C203C4}" dt="2021-08-12T06:35:50.914" v="199" actId="1076"/>
          <ac:spMkLst>
            <pc:docMk/>
            <pc:sldMk cId="646338076" sldId="514"/>
            <ac:spMk id="16" creationId="{55EED01C-CAAA-4306-94B6-2549D4AC244C}"/>
          </ac:spMkLst>
        </pc:spChg>
        <pc:spChg chg="add mod">
          <ac:chgData name="Derei Wu" userId="935b1b74ff2f2987" providerId="LiveId" clId="{7314F847-4F81-4D57-9414-F91F95C203C4}" dt="2021-08-12T06:35:19.332" v="190" actId="20577"/>
          <ac:spMkLst>
            <pc:docMk/>
            <pc:sldMk cId="646338076" sldId="514"/>
            <ac:spMk id="43" creationId="{DD5E79D7-C341-4E75-A72D-041D90B3FD14}"/>
          </ac:spMkLst>
        </pc:spChg>
        <pc:spChg chg="add mod">
          <ac:chgData name="Derei Wu" userId="935b1b74ff2f2987" providerId="LiveId" clId="{7314F847-4F81-4D57-9414-F91F95C203C4}" dt="2021-08-12T06:36:03.873" v="203" actId="20577"/>
          <ac:spMkLst>
            <pc:docMk/>
            <pc:sldMk cId="646338076" sldId="514"/>
            <ac:spMk id="44" creationId="{CB2E2AD9-19D4-4601-9E2A-8B36C7E4BF56}"/>
          </ac:spMkLst>
        </pc:spChg>
        <pc:spChg chg="add mod">
          <ac:chgData name="Derei Wu" userId="935b1b74ff2f2987" providerId="LiveId" clId="{7314F847-4F81-4D57-9414-F91F95C203C4}" dt="2021-08-12T06:36:01.422" v="202" actId="1076"/>
          <ac:spMkLst>
            <pc:docMk/>
            <pc:sldMk cId="646338076" sldId="514"/>
            <ac:spMk id="45" creationId="{F4607028-7C75-4EAD-8560-26BA5223E6C0}"/>
          </ac:spMkLst>
        </pc:spChg>
        <pc:spChg chg="add mod">
          <ac:chgData name="Derei Wu" userId="935b1b74ff2f2987" providerId="LiveId" clId="{7314F847-4F81-4D57-9414-F91F95C203C4}" dt="2021-08-12T06:36:01.422" v="202" actId="1076"/>
          <ac:spMkLst>
            <pc:docMk/>
            <pc:sldMk cId="646338076" sldId="514"/>
            <ac:spMk id="46" creationId="{1FCC2F8D-0586-47CF-948A-91722DCE9141}"/>
          </ac:spMkLst>
        </pc:spChg>
        <pc:spChg chg="add mod">
          <ac:chgData name="Derei Wu" userId="935b1b74ff2f2987" providerId="LiveId" clId="{7314F847-4F81-4D57-9414-F91F95C203C4}" dt="2021-08-12T06:36:01.422" v="202" actId="1076"/>
          <ac:spMkLst>
            <pc:docMk/>
            <pc:sldMk cId="646338076" sldId="514"/>
            <ac:spMk id="47" creationId="{A433FA74-03A2-418F-9D27-2413B7209B99}"/>
          </ac:spMkLst>
        </pc:spChg>
        <pc:spChg chg="add mod">
          <ac:chgData name="Derei Wu" userId="935b1b74ff2f2987" providerId="LiveId" clId="{7314F847-4F81-4D57-9414-F91F95C203C4}" dt="2021-08-12T06:36:11.328" v="205" actId="1076"/>
          <ac:spMkLst>
            <pc:docMk/>
            <pc:sldMk cId="646338076" sldId="514"/>
            <ac:spMk id="48" creationId="{B001708D-8846-4F2C-AAF3-0F71239558D9}"/>
          </ac:spMkLst>
        </pc:spChg>
        <pc:spChg chg="add mod">
          <ac:chgData name="Derei Wu" userId="935b1b74ff2f2987" providerId="LiveId" clId="{7314F847-4F81-4D57-9414-F91F95C203C4}" dt="2021-08-12T06:36:11.328" v="205" actId="1076"/>
          <ac:spMkLst>
            <pc:docMk/>
            <pc:sldMk cId="646338076" sldId="514"/>
            <ac:spMk id="49" creationId="{4D0A9AB2-C8BF-43D7-A5A6-9FDDC5BCDBE2}"/>
          </ac:spMkLst>
        </pc:spChg>
        <pc:spChg chg="add mod">
          <ac:chgData name="Derei Wu" userId="935b1b74ff2f2987" providerId="LiveId" clId="{7314F847-4F81-4D57-9414-F91F95C203C4}" dt="2021-08-12T06:36:11.328" v="205" actId="1076"/>
          <ac:spMkLst>
            <pc:docMk/>
            <pc:sldMk cId="646338076" sldId="514"/>
            <ac:spMk id="50" creationId="{94B4BA36-B31D-4E76-9EEB-F424962D234A}"/>
          </ac:spMkLst>
        </pc:spChg>
        <pc:spChg chg="add mod">
          <ac:chgData name="Derei Wu" userId="935b1b74ff2f2987" providerId="LiveId" clId="{7314F847-4F81-4D57-9414-F91F95C203C4}" dt="2021-08-12T06:36:11.328" v="205" actId="1076"/>
          <ac:spMkLst>
            <pc:docMk/>
            <pc:sldMk cId="646338076" sldId="514"/>
            <ac:spMk id="51" creationId="{A1411AB2-D59F-4EF4-ADBD-0A95792AC741}"/>
          </ac:spMkLst>
        </pc:spChg>
        <pc:spChg chg="add mod">
          <ac:chgData name="Derei Wu" userId="935b1b74ff2f2987" providerId="LiveId" clId="{7314F847-4F81-4D57-9414-F91F95C203C4}" dt="2021-08-12T06:36:21.046" v="210" actId="20577"/>
          <ac:spMkLst>
            <pc:docMk/>
            <pc:sldMk cId="646338076" sldId="514"/>
            <ac:spMk id="52" creationId="{6848BCA7-56CE-40AB-B3BC-767CD2248AC4}"/>
          </ac:spMkLst>
        </pc:spChg>
        <pc:spChg chg="add mod">
          <ac:chgData name="Derei Wu" userId="935b1b74ff2f2987" providerId="LiveId" clId="{7314F847-4F81-4D57-9414-F91F95C203C4}" dt="2021-08-12T06:36:19.108" v="209" actId="1035"/>
          <ac:spMkLst>
            <pc:docMk/>
            <pc:sldMk cId="646338076" sldId="514"/>
            <ac:spMk id="53" creationId="{400031BA-E7E9-4EC9-94EF-B0FEA7D0E599}"/>
          </ac:spMkLst>
        </pc:spChg>
        <pc:spChg chg="add mod">
          <ac:chgData name="Derei Wu" userId="935b1b74ff2f2987" providerId="LiveId" clId="{7314F847-4F81-4D57-9414-F91F95C203C4}" dt="2021-08-12T06:36:19.108" v="209" actId="1035"/>
          <ac:spMkLst>
            <pc:docMk/>
            <pc:sldMk cId="646338076" sldId="514"/>
            <ac:spMk id="54" creationId="{1848463D-F51F-40C5-B6C8-44EBA0B7C352}"/>
          </ac:spMkLst>
        </pc:spChg>
        <pc:spChg chg="add mod">
          <ac:chgData name="Derei Wu" userId="935b1b74ff2f2987" providerId="LiveId" clId="{7314F847-4F81-4D57-9414-F91F95C203C4}" dt="2021-08-12T06:36:19.108" v="209" actId="1035"/>
          <ac:spMkLst>
            <pc:docMk/>
            <pc:sldMk cId="646338076" sldId="514"/>
            <ac:spMk id="55" creationId="{5F3BB461-1E35-437D-A7A2-CED4B90F5ACF}"/>
          </ac:spMkLst>
        </pc:spChg>
        <pc:picChg chg="add mod">
          <ac:chgData name="Derei Wu" userId="935b1b74ff2f2987" providerId="LiveId" clId="{7314F847-4F81-4D57-9414-F91F95C203C4}" dt="2021-08-12T06:22:29.850" v="36" actId="1076"/>
          <ac:picMkLst>
            <pc:docMk/>
            <pc:sldMk cId="646338076" sldId="514"/>
            <ac:picMk id="3" creationId="{31B5A6F9-7F05-4737-99B5-97B95B2DD5FC}"/>
          </ac:picMkLst>
        </pc:picChg>
        <pc:picChg chg="add mod">
          <ac:chgData name="Derei Wu" userId="935b1b74ff2f2987" providerId="LiveId" clId="{7314F847-4F81-4D57-9414-F91F95C203C4}" dt="2021-08-12T06:33:44.724" v="139" actId="1037"/>
          <ac:picMkLst>
            <pc:docMk/>
            <pc:sldMk cId="646338076" sldId="514"/>
            <ac:picMk id="5" creationId="{F0771007-D5BB-4781-B03D-4CF723EB29EF}"/>
          </ac:picMkLst>
        </pc:picChg>
        <pc:picChg chg="add mod">
          <ac:chgData name="Derei Wu" userId="935b1b74ff2f2987" providerId="LiveId" clId="{7314F847-4F81-4D57-9414-F91F95C203C4}" dt="2021-08-12T06:33:52.164" v="156" actId="1037"/>
          <ac:picMkLst>
            <pc:docMk/>
            <pc:sldMk cId="646338076" sldId="514"/>
            <ac:picMk id="8" creationId="{91DFAA15-3B16-4CB3-B58C-F79DEF5757C4}"/>
          </ac:picMkLst>
        </pc:picChg>
        <pc:picChg chg="add mod">
          <ac:chgData name="Derei Wu" userId="935b1b74ff2f2987" providerId="LiveId" clId="{7314F847-4F81-4D57-9414-F91F95C203C4}" dt="2021-08-12T06:33:48.780" v="147" actId="1037"/>
          <ac:picMkLst>
            <pc:docMk/>
            <pc:sldMk cId="646338076" sldId="514"/>
            <ac:picMk id="10" creationId="{A8DF6966-A2B7-4F1C-9D54-0458FD6C3BB1}"/>
          </ac:picMkLst>
        </pc:picChg>
        <pc:picChg chg="add mod">
          <ac:chgData name="Derei Wu" userId="935b1b74ff2f2987" providerId="LiveId" clId="{7314F847-4F81-4D57-9414-F91F95C203C4}" dt="2021-08-12T06:27:01.027" v="74" actId="1076"/>
          <ac:picMkLst>
            <pc:docMk/>
            <pc:sldMk cId="646338076" sldId="514"/>
            <ac:picMk id="18" creationId="{F0D380A0-DC9A-4B2A-B960-1784B1F8DB91}"/>
          </ac:picMkLst>
        </pc:picChg>
        <pc:picChg chg="add mod">
          <ac:chgData name="Derei Wu" userId="935b1b74ff2f2987" providerId="LiveId" clId="{7314F847-4F81-4D57-9414-F91F95C203C4}" dt="2021-08-12T06:33:44.724" v="139" actId="1037"/>
          <ac:picMkLst>
            <pc:docMk/>
            <pc:sldMk cId="646338076" sldId="514"/>
            <ac:picMk id="20" creationId="{CED97638-3590-4F6E-8A0A-F89D36902992}"/>
          </ac:picMkLst>
        </pc:picChg>
        <pc:picChg chg="add mod">
          <ac:chgData name="Derei Wu" userId="935b1b74ff2f2987" providerId="LiveId" clId="{7314F847-4F81-4D57-9414-F91F95C203C4}" dt="2021-08-12T06:33:48.780" v="147" actId="1037"/>
          <ac:picMkLst>
            <pc:docMk/>
            <pc:sldMk cId="646338076" sldId="514"/>
            <ac:picMk id="22" creationId="{AF15EBEE-1B57-404E-92D2-811F02919C3A}"/>
          </ac:picMkLst>
        </pc:picChg>
        <pc:picChg chg="add mod">
          <ac:chgData name="Derei Wu" userId="935b1b74ff2f2987" providerId="LiveId" clId="{7314F847-4F81-4D57-9414-F91F95C203C4}" dt="2021-08-12T06:33:52.164" v="156" actId="1037"/>
          <ac:picMkLst>
            <pc:docMk/>
            <pc:sldMk cId="646338076" sldId="514"/>
            <ac:picMk id="24" creationId="{18F8C305-F076-4276-84FD-3EAC45621407}"/>
          </ac:picMkLst>
        </pc:picChg>
        <pc:picChg chg="add del mod">
          <ac:chgData name="Derei Wu" userId="935b1b74ff2f2987" providerId="LiveId" clId="{7314F847-4F81-4D57-9414-F91F95C203C4}" dt="2021-08-12T06:29:03.028" v="86" actId="478"/>
          <ac:picMkLst>
            <pc:docMk/>
            <pc:sldMk cId="646338076" sldId="514"/>
            <ac:picMk id="26" creationId="{A9AEB4FD-EBB7-4396-AC49-FE03CB9F935B}"/>
          </ac:picMkLst>
        </pc:picChg>
        <pc:picChg chg="add mod">
          <ac:chgData name="Derei Wu" userId="935b1b74ff2f2987" providerId="LiveId" clId="{7314F847-4F81-4D57-9414-F91F95C203C4}" dt="2021-08-12T06:34:41.724" v="172" actId="1076"/>
          <ac:picMkLst>
            <pc:docMk/>
            <pc:sldMk cId="646338076" sldId="514"/>
            <ac:picMk id="28" creationId="{5ED6DE11-4D72-498F-83CB-42CA08053029}"/>
          </ac:picMkLst>
        </pc:picChg>
        <pc:picChg chg="add mod">
          <ac:chgData name="Derei Wu" userId="935b1b74ff2f2987" providerId="LiveId" clId="{7314F847-4F81-4D57-9414-F91F95C203C4}" dt="2021-08-12T06:34:32.733" v="170" actId="1037"/>
          <ac:picMkLst>
            <pc:docMk/>
            <pc:sldMk cId="646338076" sldId="514"/>
            <ac:picMk id="30" creationId="{C8D47F04-574A-49B8-8A13-214F73138C51}"/>
          </ac:picMkLst>
        </pc:picChg>
        <pc:picChg chg="add mod">
          <ac:chgData name="Derei Wu" userId="935b1b74ff2f2987" providerId="LiveId" clId="{7314F847-4F81-4D57-9414-F91F95C203C4}" dt="2021-08-12T06:34:19.372" v="166" actId="1036"/>
          <ac:picMkLst>
            <pc:docMk/>
            <pc:sldMk cId="646338076" sldId="514"/>
            <ac:picMk id="32" creationId="{BFB39504-ABFD-4D9C-AE9C-1B3842676802}"/>
          </ac:picMkLst>
        </pc:picChg>
        <pc:picChg chg="add mod">
          <ac:chgData name="Derei Wu" userId="935b1b74ff2f2987" providerId="LiveId" clId="{7314F847-4F81-4D57-9414-F91F95C203C4}" dt="2021-08-12T06:34:38.376" v="171" actId="1076"/>
          <ac:picMkLst>
            <pc:docMk/>
            <pc:sldMk cId="646338076" sldId="514"/>
            <ac:picMk id="34" creationId="{E9AA91F9-4D26-4CCC-A337-22BDBFEFC33F}"/>
          </ac:picMkLst>
        </pc:picChg>
        <pc:picChg chg="add mod">
          <ac:chgData name="Derei Wu" userId="935b1b74ff2f2987" providerId="LiveId" clId="{7314F847-4F81-4D57-9414-F91F95C203C4}" dt="2021-08-12T06:34:00.279" v="157" actId="1076"/>
          <ac:picMkLst>
            <pc:docMk/>
            <pc:sldMk cId="646338076" sldId="514"/>
            <ac:picMk id="36" creationId="{3C99556D-7C24-4147-8937-535B898B7701}"/>
          </ac:picMkLst>
        </pc:picChg>
        <pc:picChg chg="add mod">
          <ac:chgData name="Derei Wu" userId="935b1b74ff2f2987" providerId="LiveId" clId="{7314F847-4F81-4D57-9414-F91F95C203C4}" dt="2021-08-12T06:34:03.728" v="158" actId="1076"/>
          <ac:picMkLst>
            <pc:docMk/>
            <pc:sldMk cId="646338076" sldId="514"/>
            <ac:picMk id="38" creationId="{39B87CD7-4300-493F-BCAE-648D94A8210A}"/>
          </ac:picMkLst>
        </pc:picChg>
        <pc:picChg chg="add mod">
          <ac:chgData name="Derei Wu" userId="935b1b74ff2f2987" providerId="LiveId" clId="{7314F847-4F81-4D57-9414-F91F95C203C4}" dt="2021-08-12T06:34:06.232" v="159" actId="1076"/>
          <ac:picMkLst>
            <pc:docMk/>
            <pc:sldMk cId="646338076" sldId="514"/>
            <ac:picMk id="40" creationId="{C39172D0-9CF4-4756-BF09-2D536145A30A}"/>
          </ac:picMkLst>
        </pc:picChg>
        <pc:picChg chg="add mod">
          <ac:chgData name="Derei Wu" userId="935b1b74ff2f2987" providerId="LiveId" clId="{7314F847-4F81-4D57-9414-F91F95C203C4}" dt="2021-08-12T06:34:10.534" v="160" actId="1076"/>
          <ac:picMkLst>
            <pc:docMk/>
            <pc:sldMk cId="646338076" sldId="514"/>
            <ac:picMk id="42" creationId="{7B348DA4-89D6-480B-86BB-D450DE3310A0}"/>
          </ac:picMkLst>
        </pc:picChg>
      </pc:sldChg>
      <pc:sldChg chg="modSp add mod ord">
        <pc:chgData name="Derei Wu" userId="935b1b74ff2f2987" providerId="LiveId" clId="{7314F847-4F81-4D57-9414-F91F95C203C4}" dt="2021-08-13T01:35:50.535" v="269" actId="20577"/>
        <pc:sldMkLst>
          <pc:docMk/>
          <pc:sldMk cId="2882435515" sldId="515"/>
        </pc:sldMkLst>
        <pc:spChg chg="mod">
          <ac:chgData name="Derei Wu" userId="935b1b74ff2f2987" providerId="LiveId" clId="{7314F847-4F81-4D57-9414-F91F95C203C4}" dt="2021-08-13T01:35:50.535" v="269" actId="20577"/>
          <ac:spMkLst>
            <pc:docMk/>
            <pc:sldMk cId="2882435515" sldId="515"/>
            <ac:spMk id="8" creationId="{05B0F1FD-D170-4D7B-8280-03E9121D1C33}"/>
          </ac:spMkLst>
        </pc:spChg>
      </pc:sldChg>
      <pc:sldChg chg="addSp delSp modSp new mod">
        <pc:chgData name="Derei Wu" userId="935b1b74ff2f2987" providerId="LiveId" clId="{7314F847-4F81-4D57-9414-F91F95C203C4}" dt="2021-08-13T01:45:11.872" v="461" actId="1076"/>
        <pc:sldMkLst>
          <pc:docMk/>
          <pc:sldMk cId="3930183057" sldId="516"/>
        </pc:sldMkLst>
        <pc:spChg chg="del">
          <ac:chgData name="Derei Wu" userId="935b1b74ff2f2987" providerId="LiveId" clId="{7314F847-4F81-4D57-9414-F91F95C203C4}" dt="2021-08-13T01:44:00.106" v="452" actId="478"/>
          <ac:spMkLst>
            <pc:docMk/>
            <pc:sldMk cId="3930183057" sldId="516"/>
            <ac:spMk id="2" creationId="{70BA0432-CBFC-4B74-B671-D97582AB2113}"/>
          </ac:spMkLst>
        </pc:spChg>
        <pc:spChg chg="del">
          <ac:chgData name="Derei Wu" userId="935b1b74ff2f2987" providerId="LiveId" clId="{7314F847-4F81-4D57-9414-F91F95C203C4}" dt="2021-08-13T01:44:01.066" v="453" actId="478"/>
          <ac:spMkLst>
            <pc:docMk/>
            <pc:sldMk cId="3930183057" sldId="516"/>
            <ac:spMk id="3" creationId="{385DEFBD-CC77-4B8F-9BD3-005EAB88229E}"/>
          </ac:spMkLst>
        </pc:spChg>
        <pc:spChg chg="mod">
          <ac:chgData name="Derei Wu" userId="935b1b74ff2f2987" providerId="LiveId" clId="{7314F847-4F81-4D57-9414-F91F95C203C4}" dt="2021-08-13T01:44:02.285" v="454"/>
          <ac:spMkLst>
            <pc:docMk/>
            <pc:sldMk cId="3930183057" sldId="516"/>
            <ac:spMk id="6" creationId="{5B93F441-D5B6-4460-B074-999F9CE1A178}"/>
          </ac:spMkLst>
        </pc:spChg>
        <pc:spChg chg="mod">
          <ac:chgData name="Derei Wu" userId="935b1b74ff2f2987" providerId="LiveId" clId="{7314F847-4F81-4D57-9414-F91F95C203C4}" dt="2021-08-13T01:44:02.285" v="454"/>
          <ac:spMkLst>
            <pc:docMk/>
            <pc:sldMk cId="3930183057" sldId="516"/>
            <ac:spMk id="7" creationId="{C7747915-8C4D-4551-AD5B-74A8D0231C64}"/>
          </ac:spMkLst>
        </pc:spChg>
        <pc:spChg chg="mod">
          <ac:chgData name="Derei Wu" userId="935b1b74ff2f2987" providerId="LiveId" clId="{7314F847-4F81-4D57-9414-F91F95C203C4}" dt="2021-08-13T01:44:02.285" v="454"/>
          <ac:spMkLst>
            <pc:docMk/>
            <pc:sldMk cId="3930183057" sldId="516"/>
            <ac:spMk id="8" creationId="{7ED7D5A6-1177-4CFC-A2A8-D2EF384D644D}"/>
          </ac:spMkLst>
        </pc:spChg>
        <pc:spChg chg="mod">
          <ac:chgData name="Derei Wu" userId="935b1b74ff2f2987" providerId="LiveId" clId="{7314F847-4F81-4D57-9414-F91F95C203C4}" dt="2021-08-13T01:44:02.285" v="454"/>
          <ac:spMkLst>
            <pc:docMk/>
            <pc:sldMk cId="3930183057" sldId="516"/>
            <ac:spMk id="9" creationId="{2A027BDC-8FBC-4C72-A24B-D002FF9CAA48}"/>
          </ac:spMkLst>
        </pc:spChg>
        <pc:spChg chg="mod">
          <ac:chgData name="Derei Wu" userId="935b1b74ff2f2987" providerId="LiveId" clId="{7314F847-4F81-4D57-9414-F91F95C203C4}" dt="2021-08-13T01:44:02.285" v="454"/>
          <ac:spMkLst>
            <pc:docMk/>
            <pc:sldMk cId="3930183057" sldId="516"/>
            <ac:spMk id="10" creationId="{F4B00868-240A-44E5-AD59-15EEA284872C}"/>
          </ac:spMkLst>
        </pc:spChg>
        <pc:spChg chg="mod">
          <ac:chgData name="Derei Wu" userId="935b1b74ff2f2987" providerId="LiveId" clId="{7314F847-4F81-4D57-9414-F91F95C203C4}" dt="2021-08-13T01:44:02.285" v="454"/>
          <ac:spMkLst>
            <pc:docMk/>
            <pc:sldMk cId="3930183057" sldId="516"/>
            <ac:spMk id="11" creationId="{AC904987-E5D9-4B31-A696-A1209C3464D2}"/>
          </ac:spMkLst>
        </pc:spChg>
        <pc:spChg chg="mod">
          <ac:chgData name="Derei Wu" userId="935b1b74ff2f2987" providerId="LiveId" clId="{7314F847-4F81-4D57-9414-F91F95C203C4}" dt="2021-08-13T01:44:02.285" v="454"/>
          <ac:spMkLst>
            <pc:docMk/>
            <pc:sldMk cId="3930183057" sldId="516"/>
            <ac:spMk id="12" creationId="{72E8754D-414D-4F82-8B96-5E1A8508633B}"/>
          </ac:spMkLst>
        </pc:spChg>
        <pc:spChg chg="mod">
          <ac:chgData name="Derei Wu" userId="935b1b74ff2f2987" providerId="LiveId" clId="{7314F847-4F81-4D57-9414-F91F95C203C4}" dt="2021-08-13T01:44:02.285" v="454"/>
          <ac:spMkLst>
            <pc:docMk/>
            <pc:sldMk cId="3930183057" sldId="516"/>
            <ac:spMk id="13" creationId="{6994DF75-B3DF-43B7-AA1E-206F8BFCA1DF}"/>
          </ac:spMkLst>
        </pc:spChg>
        <pc:spChg chg="mod">
          <ac:chgData name="Derei Wu" userId="935b1b74ff2f2987" providerId="LiveId" clId="{7314F847-4F81-4D57-9414-F91F95C203C4}" dt="2021-08-13T01:44:02.285" v="454"/>
          <ac:spMkLst>
            <pc:docMk/>
            <pc:sldMk cId="3930183057" sldId="516"/>
            <ac:spMk id="14" creationId="{BEE1FD33-DE54-410A-AEA6-5D0476004FC1}"/>
          </ac:spMkLst>
        </pc:spChg>
        <pc:spChg chg="mod">
          <ac:chgData name="Derei Wu" userId="935b1b74ff2f2987" providerId="LiveId" clId="{7314F847-4F81-4D57-9414-F91F95C203C4}" dt="2021-08-13T01:44:02.285" v="454"/>
          <ac:spMkLst>
            <pc:docMk/>
            <pc:sldMk cId="3930183057" sldId="516"/>
            <ac:spMk id="15" creationId="{0B955648-A1B7-46F5-A23C-D783313CD079}"/>
          </ac:spMkLst>
        </pc:spChg>
        <pc:spChg chg="mod">
          <ac:chgData name="Derei Wu" userId="935b1b74ff2f2987" providerId="LiveId" clId="{7314F847-4F81-4D57-9414-F91F95C203C4}" dt="2021-08-13T01:44:02.285" v="454"/>
          <ac:spMkLst>
            <pc:docMk/>
            <pc:sldMk cId="3930183057" sldId="516"/>
            <ac:spMk id="16" creationId="{48B694FC-47E1-4FE0-B9EE-12EB173E7758}"/>
          </ac:spMkLst>
        </pc:spChg>
        <pc:grpChg chg="add del mod">
          <ac:chgData name="Derei Wu" userId="935b1b74ff2f2987" providerId="LiveId" clId="{7314F847-4F81-4D57-9414-F91F95C203C4}" dt="2021-08-13T01:44:08.144" v="457"/>
          <ac:grpSpMkLst>
            <pc:docMk/>
            <pc:sldMk cId="3930183057" sldId="516"/>
            <ac:grpSpMk id="4" creationId="{E8D189C2-F318-4180-8807-774C4F4D0966}"/>
          </ac:grpSpMkLst>
        </pc:grpChg>
        <pc:picChg chg="mod">
          <ac:chgData name="Derei Wu" userId="935b1b74ff2f2987" providerId="LiveId" clId="{7314F847-4F81-4D57-9414-F91F95C203C4}" dt="2021-08-13T01:44:02.285" v="454"/>
          <ac:picMkLst>
            <pc:docMk/>
            <pc:sldMk cId="3930183057" sldId="516"/>
            <ac:picMk id="5" creationId="{C3A3E8AA-B35C-483E-84A9-1C16BD739C0E}"/>
          </ac:picMkLst>
        </pc:picChg>
        <pc:picChg chg="add mod">
          <ac:chgData name="Derei Wu" userId="935b1b74ff2f2987" providerId="LiveId" clId="{7314F847-4F81-4D57-9414-F91F95C203C4}" dt="2021-08-13T01:45:11.872" v="461" actId="1076"/>
          <ac:picMkLst>
            <pc:docMk/>
            <pc:sldMk cId="3930183057" sldId="516"/>
            <ac:picMk id="18" creationId="{4C2B8912-E8A1-4217-A81B-BC7E28F07AC7}"/>
          </ac:picMkLst>
        </pc:picChg>
      </pc:sldChg>
    </pc:docChg>
  </pc:docChgLst>
</pc:chgInfo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image" Target="../media/image7.e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11.emf"/><Relationship Id="rId2" Type="http://schemas.openxmlformats.org/officeDocument/2006/relationships/image" Target="../media/image10.emf"/><Relationship Id="rId1" Type="http://schemas.openxmlformats.org/officeDocument/2006/relationships/image" Target="../media/image9.emf"/><Relationship Id="rId4" Type="http://schemas.openxmlformats.org/officeDocument/2006/relationships/image" Target="../media/image12.emf"/></Relationships>
</file>

<file path=ppt/drawings/_rels/vmlDrawing3.vml.rels><?xml version="1.0" encoding="UTF-8" standalone="yes"?>
<Relationships xmlns="http://schemas.openxmlformats.org/package/2006/relationships"><Relationship Id="rId3" Type="http://schemas.openxmlformats.org/officeDocument/2006/relationships/image" Target="../media/image15.emf"/><Relationship Id="rId2" Type="http://schemas.openxmlformats.org/officeDocument/2006/relationships/image" Target="../media/image14.emf"/><Relationship Id="rId1" Type="http://schemas.openxmlformats.org/officeDocument/2006/relationships/image" Target="../media/image13.emf"/></Relationships>
</file>

<file path=ppt/drawings/_rels/vmlDrawing4.vml.rels><?xml version="1.0" encoding="UTF-8" standalone="yes"?>
<Relationships xmlns="http://schemas.openxmlformats.org/package/2006/relationships"><Relationship Id="rId8" Type="http://schemas.openxmlformats.org/officeDocument/2006/relationships/image" Target="../media/image42.emf"/><Relationship Id="rId3" Type="http://schemas.openxmlformats.org/officeDocument/2006/relationships/image" Target="../media/image37.emf"/><Relationship Id="rId7" Type="http://schemas.openxmlformats.org/officeDocument/2006/relationships/image" Target="../media/image41.emf"/><Relationship Id="rId2" Type="http://schemas.openxmlformats.org/officeDocument/2006/relationships/image" Target="../media/image36.emf"/><Relationship Id="rId1" Type="http://schemas.openxmlformats.org/officeDocument/2006/relationships/image" Target="../media/image35.emf"/><Relationship Id="rId6" Type="http://schemas.openxmlformats.org/officeDocument/2006/relationships/image" Target="../media/image40.emf"/><Relationship Id="rId5" Type="http://schemas.openxmlformats.org/officeDocument/2006/relationships/image" Target="../media/image39.emf"/><Relationship Id="rId4" Type="http://schemas.openxmlformats.org/officeDocument/2006/relationships/image" Target="../media/image38.emf"/></Relationships>
</file>

<file path=ppt/drawings/_rels/vmlDrawing5.vml.rels><?xml version="1.0" encoding="UTF-8" standalone="yes"?>
<Relationships xmlns="http://schemas.openxmlformats.org/package/2006/relationships"><Relationship Id="rId3" Type="http://schemas.openxmlformats.org/officeDocument/2006/relationships/image" Target="../media/image45.emf"/><Relationship Id="rId2" Type="http://schemas.openxmlformats.org/officeDocument/2006/relationships/image" Target="../media/image44.emf"/><Relationship Id="rId1" Type="http://schemas.openxmlformats.org/officeDocument/2006/relationships/image" Target="../media/image43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3A85FD2-6E8D-46A4-9C75-078492A26927}" type="datetimeFigureOut">
              <a:rPr lang="en-US" smtClean="0"/>
              <a:t>1/25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08CC675-3BC4-43EA-AE17-AE4023F972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75360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287482-A728-49C8-A215-42B091CCF38E}" type="datetimeFigureOut">
              <a:rPr lang="en-US" smtClean="0"/>
              <a:t>1/2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30F19-6B9C-4648-8916-9A2909F8DD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17272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287482-A728-49C8-A215-42B091CCF38E}" type="datetimeFigureOut">
              <a:rPr lang="en-US" smtClean="0"/>
              <a:t>1/2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30F19-6B9C-4648-8916-9A2909F8DD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40773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287482-A728-49C8-A215-42B091CCF38E}" type="datetimeFigureOut">
              <a:rPr lang="en-US" smtClean="0"/>
              <a:t>1/2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30F19-6B9C-4648-8916-9A2909F8DD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43873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287482-A728-49C8-A215-42B091CCF38E}" type="datetimeFigureOut">
              <a:rPr lang="en-US" smtClean="0"/>
              <a:t>1/2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30F19-6B9C-4648-8916-9A2909F8DD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94847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287482-A728-49C8-A215-42B091CCF38E}" type="datetimeFigureOut">
              <a:rPr lang="en-US" smtClean="0"/>
              <a:t>1/2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30F19-6B9C-4648-8916-9A2909F8DD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32679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287482-A728-49C8-A215-42B091CCF38E}" type="datetimeFigureOut">
              <a:rPr lang="en-US" smtClean="0"/>
              <a:t>1/25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30F19-6B9C-4648-8916-9A2909F8DD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93105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287482-A728-49C8-A215-42B091CCF38E}" type="datetimeFigureOut">
              <a:rPr lang="en-US" smtClean="0"/>
              <a:t>1/25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30F19-6B9C-4648-8916-9A2909F8DD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00753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287482-A728-49C8-A215-42B091CCF38E}" type="datetimeFigureOut">
              <a:rPr lang="en-US" smtClean="0"/>
              <a:t>1/25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30F19-6B9C-4648-8916-9A2909F8DD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17828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287482-A728-49C8-A215-42B091CCF38E}" type="datetimeFigureOut">
              <a:rPr lang="en-US" smtClean="0"/>
              <a:t>1/25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30F19-6B9C-4648-8916-9A2909F8DD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33704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287482-A728-49C8-A215-42B091CCF38E}" type="datetimeFigureOut">
              <a:rPr lang="en-US" smtClean="0"/>
              <a:t>1/25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30F19-6B9C-4648-8916-9A2909F8DD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11155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287482-A728-49C8-A215-42B091CCF38E}" type="datetimeFigureOut">
              <a:rPr lang="en-US" smtClean="0"/>
              <a:t>1/25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30F19-6B9C-4648-8916-9A2909F8DD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89379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87482-A728-49C8-A215-42B091CCF38E}" type="datetimeFigureOut">
              <a:rPr lang="en-US" smtClean="0"/>
              <a:t>1/2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330F19-6B9C-4648-8916-9A2909F8DD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72437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25.png"/><Relationship Id="rId13" Type="http://schemas.openxmlformats.org/officeDocument/2006/relationships/image" Target="../media/image30.png"/><Relationship Id="rId18" Type="http://schemas.openxmlformats.org/officeDocument/2006/relationships/image" Target="../media/image33.png"/><Relationship Id="rId3" Type="http://schemas.openxmlformats.org/officeDocument/2006/relationships/image" Target="../media/image20.png"/><Relationship Id="rId7" Type="http://schemas.openxmlformats.org/officeDocument/2006/relationships/image" Target="../media/image24.png"/><Relationship Id="rId12" Type="http://schemas.openxmlformats.org/officeDocument/2006/relationships/image" Target="../media/image29.png"/><Relationship Id="rId17" Type="http://schemas.microsoft.com/office/2007/relationships/hdphoto" Target="../media/hdphoto2.wdp"/><Relationship Id="rId2" Type="http://schemas.openxmlformats.org/officeDocument/2006/relationships/image" Target="../media/image19.png"/><Relationship Id="rId16" Type="http://schemas.openxmlformats.org/officeDocument/2006/relationships/image" Target="../media/image3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3.png"/><Relationship Id="rId11" Type="http://schemas.openxmlformats.org/officeDocument/2006/relationships/image" Target="../media/image28.png"/><Relationship Id="rId5" Type="http://schemas.openxmlformats.org/officeDocument/2006/relationships/image" Target="../media/image22.png"/><Relationship Id="rId15" Type="http://schemas.microsoft.com/office/2007/relationships/hdphoto" Target="../media/hdphoto1.wdp"/><Relationship Id="rId10" Type="http://schemas.openxmlformats.org/officeDocument/2006/relationships/image" Target="../media/image27.png"/><Relationship Id="rId19" Type="http://schemas.openxmlformats.org/officeDocument/2006/relationships/image" Target="../media/image34.png"/><Relationship Id="rId4" Type="http://schemas.openxmlformats.org/officeDocument/2006/relationships/image" Target="../media/image21.png"/><Relationship Id="rId9" Type="http://schemas.openxmlformats.org/officeDocument/2006/relationships/image" Target="../media/image26.png"/><Relationship Id="rId14" Type="http://schemas.openxmlformats.org/officeDocument/2006/relationships/image" Target="../media/image31.png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7.emf"/><Relationship Id="rId13" Type="http://schemas.openxmlformats.org/officeDocument/2006/relationships/oleObject" Target="../embeddings/oleObject15.bin"/><Relationship Id="rId18" Type="http://schemas.openxmlformats.org/officeDocument/2006/relationships/image" Target="../media/image42.emf"/><Relationship Id="rId3" Type="http://schemas.openxmlformats.org/officeDocument/2006/relationships/oleObject" Target="../embeddings/oleObject10.bin"/><Relationship Id="rId7" Type="http://schemas.openxmlformats.org/officeDocument/2006/relationships/oleObject" Target="../embeddings/oleObject12.bin"/><Relationship Id="rId12" Type="http://schemas.openxmlformats.org/officeDocument/2006/relationships/image" Target="../media/image39.emf"/><Relationship Id="rId17" Type="http://schemas.openxmlformats.org/officeDocument/2006/relationships/oleObject" Target="../embeddings/oleObject17.bin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41.emf"/><Relationship Id="rId1" Type="http://schemas.openxmlformats.org/officeDocument/2006/relationships/vmlDrawing" Target="../drawings/vmlDrawing4.vml"/><Relationship Id="rId6" Type="http://schemas.openxmlformats.org/officeDocument/2006/relationships/image" Target="../media/image36.emf"/><Relationship Id="rId11" Type="http://schemas.openxmlformats.org/officeDocument/2006/relationships/oleObject" Target="../embeddings/oleObject14.bin"/><Relationship Id="rId5" Type="http://schemas.openxmlformats.org/officeDocument/2006/relationships/oleObject" Target="../embeddings/oleObject11.bin"/><Relationship Id="rId15" Type="http://schemas.openxmlformats.org/officeDocument/2006/relationships/oleObject" Target="../embeddings/oleObject16.bin"/><Relationship Id="rId10" Type="http://schemas.openxmlformats.org/officeDocument/2006/relationships/image" Target="../media/image38.emf"/><Relationship Id="rId4" Type="http://schemas.openxmlformats.org/officeDocument/2006/relationships/image" Target="../media/image35.emf"/><Relationship Id="rId9" Type="http://schemas.openxmlformats.org/officeDocument/2006/relationships/oleObject" Target="../embeddings/oleObject13.bin"/><Relationship Id="rId14" Type="http://schemas.openxmlformats.org/officeDocument/2006/relationships/image" Target="../media/image40.emf"/></Relationships>
</file>

<file path=ppt/slides/_rels/slide12.xml.rels><?xml version="1.0" encoding="UTF-8" standalone="yes"?>
<Relationships xmlns="http://schemas.openxmlformats.org/package/2006/relationships"><Relationship Id="rId8" Type="http://schemas.openxmlformats.org/officeDocument/2006/relationships/image" Target="../media/image45.emf"/><Relationship Id="rId3" Type="http://schemas.openxmlformats.org/officeDocument/2006/relationships/oleObject" Target="../embeddings/oleObject18.bin"/><Relationship Id="rId7" Type="http://schemas.openxmlformats.org/officeDocument/2006/relationships/oleObject" Target="../embeddings/oleObject20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5.vml"/><Relationship Id="rId6" Type="http://schemas.openxmlformats.org/officeDocument/2006/relationships/image" Target="../media/image44.emf"/><Relationship Id="rId5" Type="http://schemas.openxmlformats.org/officeDocument/2006/relationships/oleObject" Target="../embeddings/oleObject19.bin"/><Relationship Id="rId4" Type="http://schemas.openxmlformats.org/officeDocument/2006/relationships/image" Target="../media/image43.emf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6.pn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8.png"/><Relationship Id="rId7" Type="http://schemas.openxmlformats.org/officeDocument/2006/relationships/image" Target="../media/image52.png"/><Relationship Id="rId2" Type="http://schemas.openxmlformats.org/officeDocument/2006/relationships/image" Target="../media/image4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1.png"/><Relationship Id="rId5" Type="http://schemas.openxmlformats.org/officeDocument/2006/relationships/image" Target="../media/image50.png"/><Relationship Id="rId4" Type="http://schemas.openxmlformats.org/officeDocument/2006/relationships/image" Target="../media/image49.png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3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8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7.em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emf"/><Relationship Id="rId3" Type="http://schemas.openxmlformats.org/officeDocument/2006/relationships/oleObject" Target="../embeddings/oleObject3.bin"/><Relationship Id="rId7" Type="http://schemas.openxmlformats.org/officeDocument/2006/relationships/oleObject" Target="../embeddings/oleObject5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10.emf"/><Relationship Id="rId5" Type="http://schemas.openxmlformats.org/officeDocument/2006/relationships/oleObject" Target="../embeddings/oleObject4.bin"/><Relationship Id="rId10" Type="http://schemas.openxmlformats.org/officeDocument/2006/relationships/image" Target="../media/image12.emf"/><Relationship Id="rId4" Type="http://schemas.openxmlformats.org/officeDocument/2006/relationships/image" Target="../media/image9.emf"/><Relationship Id="rId9" Type="http://schemas.openxmlformats.org/officeDocument/2006/relationships/oleObject" Target="../embeddings/oleObject6.bin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emf"/><Relationship Id="rId3" Type="http://schemas.openxmlformats.org/officeDocument/2006/relationships/oleObject" Target="../embeddings/oleObject7.bin"/><Relationship Id="rId7" Type="http://schemas.openxmlformats.org/officeDocument/2006/relationships/oleObject" Target="../embeddings/oleObject9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14.emf"/><Relationship Id="rId5" Type="http://schemas.openxmlformats.org/officeDocument/2006/relationships/oleObject" Target="../embeddings/oleObject8.bin"/><Relationship Id="rId4" Type="http://schemas.openxmlformats.org/officeDocument/2006/relationships/image" Target="../media/image13.emf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13740C7-D1FB-435B-B2E3-6644167D14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7" y="2043403"/>
            <a:ext cx="5915025" cy="2542043"/>
          </a:xfrm>
        </p:spPr>
        <p:txBody>
          <a:bodyPr>
            <a:normAutofit/>
          </a:bodyPr>
          <a:lstStyle/>
          <a:p>
            <a:pPr>
              <a:lnSpc>
                <a:spcPct val="150000"/>
              </a:lnSpc>
            </a:pPr>
            <a:r>
              <a:rPr lang="en-US" altLang="zh-CN" sz="4400" b="1" kern="100" dirty="0">
                <a:latin typeface="Arial" panose="020B0604020202020204" pitchFamily="34" charset="0"/>
                <a:cs typeface="Times New Roman" panose="02020603050405020304" pitchFamily="18" charset="0"/>
              </a:rPr>
              <a:t>Extended Data for</a:t>
            </a:r>
            <a:br>
              <a:rPr lang="en-US" altLang="zh-CN" sz="4400" b="1" kern="100" dirty="0">
                <a:latin typeface="Arial" panose="020B0604020202020204" pitchFamily="34" charset="0"/>
                <a:cs typeface="Times New Roman" panose="02020603050405020304" pitchFamily="18" charset="0"/>
              </a:rPr>
            </a:br>
            <a:r>
              <a:rPr lang="en-US" altLang="zh-CN" sz="4400" b="1" kern="100" dirty="0">
                <a:latin typeface="Arial" panose="020B0604020202020204" pitchFamily="34" charset="0"/>
                <a:cs typeface="Times New Roman" panose="02020603050405020304" pitchFamily="18" charset="0"/>
              </a:rPr>
              <a:t>Figures </a:t>
            </a:r>
            <a:endParaRPr lang="zh-CN" altLang="en-US" sz="4000" dirty="0"/>
          </a:p>
        </p:txBody>
      </p:sp>
    </p:spTree>
    <p:extLst>
      <p:ext uri="{BB962C8B-B14F-4D97-AF65-F5344CB8AC3E}">
        <p14:creationId xmlns:p14="http://schemas.microsoft.com/office/powerpoint/2010/main" val="135965750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标题 1">
            <a:extLst>
              <a:ext uri="{FF2B5EF4-FFF2-40B4-BE49-F238E27FC236}">
                <a16:creationId xmlns:a16="http://schemas.microsoft.com/office/drawing/2014/main" id="{A7C5FE25-3BB6-469A-AB20-9EAFF2E644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99845" y="169819"/>
            <a:ext cx="5655496" cy="1345472"/>
          </a:xfrm>
        </p:spPr>
        <p:txBody>
          <a:bodyPr>
            <a:normAutofit/>
          </a:bodyPr>
          <a:lstStyle/>
          <a:p>
            <a:pPr>
              <a:lnSpc>
                <a:spcPct val="100000"/>
              </a:lnSpc>
            </a:pPr>
            <a:r>
              <a:rPr lang="en-US" altLang="zh-CN" sz="2800" b="1" kern="100" dirty="0">
                <a:latin typeface="Arial" panose="020B0604020202020204" pitchFamily="34" charset="0"/>
                <a:cs typeface="Times New Roman" panose="02020603050405020304" pitchFamily="18" charset="0"/>
              </a:rPr>
              <a:t>Extended data for Figure 5. </a:t>
            </a:r>
            <a:endParaRPr lang="zh-CN" altLang="en-US" sz="2800" dirty="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31B5A6F9-7F05-4737-99B5-97B95B2DD5F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53563" y="3444946"/>
            <a:ext cx="1368000" cy="1368000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F0771007-D5BB-4781-B03D-4CF723EB29E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45686" y="3444946"/>
            <a:ext cx="1368000" cy="1368000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91DFAA15-3B16-4CB3-B58C-F79DEF5757C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755334" y="3444946"/>
            <a:ext cx="1368000" cy="1368000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A8DF6966-A2B7-4F1C-9D54-0458FD6C3BB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347616" y="3444946"/>
            <a:ext cx="1368000" cy="1368000"/>
          </a:xfrm>
          <a:prstGeom prst="rect">
            <a:avLst/>
          </a:prstGeom>
        </p:spPr>
      </p:pic>
      <p:sp>
        <p:nvSpPr>
          <p:cNvPr id="11" name="文本框 10">
            <a:extLst>
              <a:ext uri="{FF2B5EF4-FFF2-40B4-BE49-F238E27FC236}">
                <a16:creationId xmlns:a16="http://schemas.microsoft.com/office/drawing/2014/main" id="{B16FD76B-1D87-42AD-95C0-B94EF52686FB}"/>
              </a:ext>
            </a:extLst>
          </p:cNvPr>
          <p:cNvSpPr txBox="1"/>
          <p:nvPr/>
        </p:nvSpPr>
        <p:spPr>
          <a:xfrm>
            <a:off x="529440" y="3160625"/>
            <a:ext cx="10134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Peri-tumor: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9F4D00E2-A587-4E3B-A220-EB0798C65571}"/>
              </a:ext>
            </a:extLst>
          </p:cNvPr>
          <p:cNvSpPr txBox="1"/>
          <p:nvPr/>
        </p:nvSpPr>
        <p:spPr>
          <a:xfrm>
            <a:off x="544038" y="3476222"/>
            <a:ext cx="649881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100" b="1" dirty="0">
                <a:solidFill>
                  <a:srgbClr val="00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</a:t>
            </a:r>
            <a:r>
              <a:rPr lang="el-GR" altLang="zh-CN" sz="1100" b="1" dirty="0">
                <a:solidFill>
                  <a:srgbClr val="00FF00"/>
                </a:solidFill>
                <a:latin typeface="Arial" panose="020B0604020202020204" pitchFamily="34" charset="0"/>
                <a:ea typeface="FangSong" panose="02010609060101010101" pitchFamily="49" charset="-122"/>
                <a:cs typeface="Arial" panose="020B0604020202020204" pitchFamily="34" charset="0"/>
                <a:sym typeface="Symbol" panose="05050102010706020507" pitchFamily="18" charset="2"/>
              </a:rPr>
              <a:t>δ</a:t>
            </a:r>
            <a:r>
              <a:rPr lang="en-US" altLang="zh-CN" sz="1100" b="1" dirty="0">
                <a:solidFill>
                  <a:srgbClr val="00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zh-CN" altLang="en-US" sz="1100" dirty="0">
              <a:solidFill>
                <a:srgbClr val="00FF00"/>
              </a:solidFill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02BCA94A-D745-4F48-81AD-C1D41F9EB8BA}"/>
              </a:ext>
            </a:extLst>
          </p:cNvPr>
          <p:cNvSpPr txBox="1"/>
          <p:nvPr/>
        </p:nvSpPr>
        <p:spPr>
          <a:xfrm>
            <a:off x="1933114" y="3454471"/>
            <a:ext cx="801205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1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AG3</a:t>
            </a:r>
            <a:endParaRPr lang="zh-CN" altLang="en-US" sz="1100" dirty="0">
              <a:solidFill>
                <a:srgbClr val="FF0000"/>
              </a:solidFill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9BCE58DD-8000-447F-A236-F14C26550057}"/>
              </a:ext>
            </a:extLst>
          </p:cNvPr>
          <p:cNvSpPr txBox="1"/>
          <p:nvPr/>
        </p:nvSpPr>
        <p:spPr>
          <a:xfrm>
            <a:off x="4749546" y="3476222"/>
            <a:ext cx="801205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100" b="1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verlay</a:t>
            </a:r>
            <a:endParaRPr lang="zh-CN" altLang="en-US" sz="1100" dirty="0">
              <a:solidFill>
                <a:srgbClr val="FFFF00"/>
              </a:solidFill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55EED01C-CAAA-4306-94B6-2549D4AC244C}"/>
              </a:ext>
            </a:extLst>
          </p:cNvPr>
          <p:cNvSpPr txBox="1"/>
          <p:nvPr/>
        </p:nvSpPr>
        <p:spPr>
          <a:xfrm>
            <a:off x="3347616" y="3476222"/>
            <a:ext cx="801205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100" b="1" dirty="0">
                <a:solidFill>
                  <a:srgbClr val="00FF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D1</a:t>
            </a:r>
            <a:endParaRPr lang="zh-CN" altLang="en-US" sz="1100" dirty="0">
              <a:solidFill>
                <a:srgbClr val="00FFFF"/>
              </a:solidFill>
            </a:endParaRPr>
          </a:p>
        </p:txBody>
      </p:sp>
      <p:pic>
        <p:nvPicPr>
          <p:cNvPr id="18" name="图片 17">
            <a:extLst>
              <a:ext uri="{FF2B5EF4-FFF2-40B4-BE49-F238E27FC236}">
                <a16:creationId xmlns:a16="http://schemas.microsoft.com/office/drawing/2014/main" id="{F0D380A0-DC9A-4B2A-B960-1784B1F8DB9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53563" y="4953000"/>
            <a:ext cx="1368000" cy="1368000"/>
          </a:xfrm>
          <a:prstGeom prst="rect">
            <a:avLst/>
          </a:prstGeom>
        </p:spPr>
      </p:pic>
      <p:pic>
        <p:nvPicPr>
          <p:cNvPr id="20" name="图片 19">
            <a:extLst>
              <a:ext uri="{FF2B5EF4-FFF2-40B4-BE49-F238E27FC236}">
                <a16:creationId xmlns:a16="http://schemas.microsoft.com/office/drawing/2014/main" id="{CED97638-3590-4F6E-8A0A-F89D36902992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945686" y="4953000"/>
            <a:ext cx="1368000" cy="1368000"/>
          </a:xfrm>
          <a:prstGeom prst="rect">
            <a:avLst/>
          </a:prstGeom>
        </p:spPr>
      </p:pic>
      <p:pic>
        <p:nvPicPr>
          <p:cNvPr id="22" name="图片 21">
            <a:extLst>
              <a:ext uri="{FF2B5EF4-FFF2-40B4-BE49-F238E27FC236}">
                <a16:creationId xmlns:a16="http://schemas.microsoft.com/office/drawing/2014/main" id="{AF15EBEE-1B57-404E-92D2-811F02919C3A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347616" y="4953000"/>
            <a:ext cx="1368000" cy="1368000"/>
          </a:xfrm>
          <a:prstGeom prst="rect">
            <a:avLst/>
          </a:prstGeom>
        </p:spPr>
      </p:pic>
      <p:pic>
        <p:nvPicPr>
          <p:cNvPr id="24" name="图片 23">
            <a:extLst>
              <a:ext uri="{FF2B5EF4-FFF2-40B4-BE49-F238E27FC236}">
                <a16:creationId xmlns:a16="http://schemas.microsoft.com/office/drawing/2014/main" id="{18F8C305-F076-4276-84FD-3EAC45621407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755334" y="4953000"/>
            <a:ext cx="1368000" cy="1368000"/>
          </a:xfrm>
          <a:prstGeom prst="rect">
            <a:avLst/>
          </a:prstGeom>
        </p:spPr>
      </p:pic>
      <p:pic>
        <p:nvPicPr>
          <p:cNvPr id="28" name="图片 27">
            <a:extLst>
              <a:ext uri="{FF2B5EF4-FFF2-40B4-BE49-F238E27FC236}">
                <a16:creationId xmlns:a16="http://schemas.microsoft.com/office/drawing/2014/main" id="{5ED6DE11-4D72-498F-83CB-42CA08053029}"/>
              </a:ext>
            </a:extLst>
          </p:cNvPr>
          <p:cNvPicPr>
            <a:picLocks/>
          </p:cNvPicPr>
          <p:nvPr/>
        </p:nvPicPr>
        <p:blipFill>
          <a:blip r:embed="rId10"/>
          <a:stretch>
            <a:fillRect/>
          </a:stretch>
        </p:blipFill>
        <p:spPr>
          <a:xfrm>
            <a:off x="4755334" y="8315990"/>
            <a:ext cx="1368000" cy="1368000"/>
          </a:xfrm>
          <a:prstGeom prst="rect">
            <a:avLst/>
          </a:prstGeom>
        </p:spPr>
      </p:pic>
      <p:pic>
        <p:nvPicPr>
          <p:cNvPr id="30" name="图片 29">
            <a:extLst>
              <a:ext uri="{FF2B5EF4-FFF2-40B4-BE49-F238E27FC236}">
                <a16:creationId xmlns:a16="http://schemas.microsoft.com/office/drawing/2014/main" id="{C8D47F04-574A-49B8-8A13-214F73138C51}"/>
              </a:ext>
            </a:extLst>
          </p:cNvPr>
          <p:cNvPicPr>
            <a:picLocks/>
          </p:cNvPicPr>
          <p:nvPr/>
        </p:nvPicPr>
        <p:blipFill>
          <a:blip r:embed="rId11"/>
          <a:stretch>
            <a:fillRect/>
          </a:stretch>
        </p:blipFill>
        <p:spPr>
          <a:xfrm>
            <a:off x="1947327" y="8315990"/>
            <a:ext cx="1368000" cy="1368000"/>
          </a:xfrm>
          <a:prstGeom prst="rect">
            <a:avLst/>
          </a:prstGeom>
        </p:spPr>
      </p:pic>
      <p:pic>
        <p:nvPicPr>
          <p:cNvPr id="32" name="图片 31">
            <a:extLst>
              <a:ext uri="{FF2B5EF4-FFF2-40B4-BE49-F238E27FC236}">
                <a16:creationId xmlns:a16="http://schemas.microsoft.com/office/drawing/2014/main" id="{BFB39504-ABFD-4D9C-AE9C-1B3842676802}"/>
              </a:ext>
            </a:extLst>
          </p:cNvPr>
          <p:cNvPicPr>
            <a:picLocks/>
          </p:cNvPicPr>
          <p:nvPr/>
        </p:nvPicPr>
        <p:blipFill>
          <a:blip r:embed="rId12"/>
          <a:stretch>
            <a:fillRect/>
          </a:stretch>
        </p:blipFill>
        <p:spPr>
          <a:xfrm>
            <a:off x="553563" y="8315990"/>
            <a:ext cx="1368000" cy="1368000"/>
          </a:xfrm>
          <a:prstGeom prst="rect">
            <a:avLst/>
          </a:prstGeom>
        </p:spPr>
      </p:pic>
      <p:pic>
        <p:nvPicPr>
          <p:cNvPr id="34" name="图片 33">
            <a:extLst>
              <a:ext uri="{FF2B5EF4-FFF2-40B4-BE49-F238E27FC236}">
                <a16:creationId xmlns:a16="http://schemas.microsoft.com/office/drawing/2014/main" id="{E9AA91F9-4D26-4CCC-A337-22BDBFEFC33F}"/>
              </a:ext>
            </a:extLst>
          </p:cNvPr>
          <p:cNvPicPr>
            <a:picLocks/>
          </p:cNvPicPr>
          <p:nvPr/>
        </p:nvPicPr>
        <p:blipFill>
          <a:blip r:embed="rId13"/>
          <a:stretch>
            <a:fillRect/>
          </a:stretch>
        </p:blipFill>
        <p:spPr>
          <a:xfrm>
            <a:off x="3347616" y="8315990"/>
            <a:ext cx="1368000" cy="1368000"/>
          </a:xfrm>
          <a:prstGeom prst="rect">
            <a:avLst/>
          </a:prstGeom>
        </p:spPr>
      </p:pic>
      <p:pic>
        <p:nvPicPr>
          <p:cNvPr id="36" name="图片 35">
            <a:extLst>
              <a:ext uri="{FF2B5EF4-FFF2-40B4-BE49-F238E27FC236}">
                <a16:creationId xmlns:a16="http://schemas.microsoft.com/office/drawing/2014/main" id="{3C99556D-7C24-4147-8937-535B898B7701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40000" contrast="-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553563" y="6882655"/>
            <a:ext cx="1368000" cy="1368000"/>
          </a:xfrm>
          <a:prstGeom prst="rect">
            <a:avLst/>
          </a:prstGeom>
        </p:spPr>
      </p:pic>
      <p:pic>
        <p:nvPicPr>
          <p:cNvPr id="38" name="图片 37">
            <a:extLst>
              <a:ext uri="{FF2B5EF4-FFF2-40B4-BE49-F238E27FC236}">
                <a16:creationId xmlns:a16="http://schemas.microsoft.com/office/drawing/2014/main" id="{39B87CD7-4300-493F-BCAE-648D94A8210A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bright="40000" contrast="-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945686" y="6882655"/>
            <a:ext cx="1368000" cy="1368000"/>
          </a:xfrm>
          <a:prstGeom prst="rect">
            <a:avLst/>
          </a:prstGeom>
        </p:spPr>
      </p:pic>
      <p:pic>
        <p:nvPicPr>
          <p:cNvPr id="40" name="图片 39">
            <a:extLst>
              <a:ext uri="{FF2B5EF4-FFF2-40B4-BE49-F238E27FC236}">
                <a16:creationId xmlns:a16="http://schemas.microsoft.com/office/drawing/2014/main" id="{C39172D0-9CF4-4756-BF09-2D536145A30A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3347616" y="6882655"/>
            <a:ext cx="1368000" cy="1368000"/>
          </a:xfrm>
          <a:prstGeom prst="rect">
            <a:avLst/>
          </a:prstGeom>
        </p:spPr>
      </p:pic>
      <p:pic>
        <p:nvPicPr>
          <p:cNvPr id="42" name="图片 41">
            <a:extLst>
              <a:ext uri="{FF2B5EF4-FFF2-40B4-BE49-F238E27FC236}">
                <a16:creationId xmlns:a16="http://schemas.microsoft.com/office/drawing/2014/main" id="{7B348DA4-89D6-480B-86BB-D450DE3310A0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4755334" y="6882655"/>
            <a:ext cx="1368000" cy="1368000"/>
          </a:xfrm>
          <a:prstGeom prst="rect">
            <a:avLst/>
          </a:prstGeom>
        </p:spPr>
      </p:pic>
      <p:sp>
        <p:nvSpPr>
          <p:cNvPr id="43" name="文本框 42">
            <a:extLst>
              <a:ext uri="{FF2B5EF4-FFF2-40B4-BE49-F238E27FC236}">
                <a16:creationId xmlns:a16="http://schemas.microsoft.com/office/drawing/2014/main" id="{DD5E79D7-C341-4E75-A72D-041D90B3FD14}"/>
              </a:ext>
            </a:extLst>
          </p:cNvPr>
          <p:cNvSpPr txBox="1"/>
          <p:nvPr/>
        </p:nvSpPr>
        <p:spPr>
          <a:xfrm>
            <a:off x="513845" y="6605656"/>
            <a:ext cx="10789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HCC Tumor: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CB2E2AD9-19D4-4601-9E2A-8B36C7E4BF56}"/>
              </a:ext>
            </a:extLst>
          </p:cNvPr>
          <p:cNvSpPr txBox="1"/>
          <p:nvPr/>
        </p:nvSpPr>
        <p:spPr>
          <a:xfrm>
            <a:off x="510108" y="4970745"/>
            <a:ext cx="649881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100" b="1" dirty="0">
                <a:solidFill>
                  <a:srgbClr val="00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</a:t>
            </a:r>
            <a:r>
              <a:rPr lang="el-GR" altLang="zh-CN" sz="1100" b="1" dirty="0">
                <a:solidFill>
                  <a:srgbClr val="00FF00"/>
                </a:solidFill>
                <a:latin typeface="Arial" panose="020B0604020202020204" pitchFamily="34" charset="0"/>
                <a:ea typeface="FangSong" panose="02010609060101010101" pitchFamily="49" charset="-122"/>
                <a:cs typeface="Arial" panose="020B0604020202020204" pitchFamily="34" charset="0"/>
                <a:sym typeface="Symbol" panose="05050102010706020507" pitchFamily="18" charset="2"/>
              </a:rPr>
              <a:t>δ</a:t>
            </a:r>
            <a:r>
              <a:rPr lang="en-US" altLang="zh-CN" sz="1100" b="1" dirty="0">
                <a:solidFill>
                  <a:srgbClr val="00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zh-CN" altLang="en-US" sz="1100" dirty="0">
              <a:solidFill>
                <a:srgbClr val="00FF00"/>
              </a:solidFill>
            </a:endParaRPr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F4607028-7C75-4EAD-8560-26BA5223E6C0}"/>
              </a:ext>
            </a:extLst>
          </p:cNvPr>
          <p:cNvSpPr txBox="1"/>
          <p:nvPr/>
        </p:nvSpPr>
        <p:spPr>
          <a:xfrm>
            <a:off x="1899184" y="4948994"/>
            <a:ext cx="801205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1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AG3</a:t>
            </a:r>
            <a:endParaRPr lang="zh-CN" altLang="en-US" sz="1100" dirty="0">
              <a:solidFill>
                <a:srgbClr val="FF0000"/>
              </a:solidFill>
            </a:endParaRP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1FCC2F8D-0586-47CF-948A-91722DCE9141}"/>
              </a:ext>
            </a:extLst>
          </p:cNvPr>
          <p:cNvSpPr txBox="1"/>
          <p:nvPr/>
        </p:nvSpPr>
        <p:spPr>
          <a:xfrm>
            <a:off x="4715616" y="4970745"/>
            <a:ext cx="801205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100" b="1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verlay</a:t>
            </a:r>
            <a:endParaRPr lang="zh-CN" altLang="en-US" sz="1100" dirty="0">
              <a:solidFill>
                <a:srgbClr val="FFFF00"/>
              </a:solidFill>
            </a:endParaRPr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A433FA74-03A2-418F-9D27-2413B7209B99}"/>
              </a:ext>
            </a:extLst>
          </p:cNvPr>
          <p:cNvSpPr txBox="1"/>
          <p:nvPr/>
        </p:nvSpPr>
        <p:spPr>
          <a:xfrm>
            <a:off x="3313686" y="4970745"/>
            <a:ext cx="801205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100" b="1" dirty="0">
                <a:solidFill>
                  <a:srgbClr val="00FF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D1</a:t>
            </a:r>
            <a:endParaRPr lang="zh-CN" altLang="en-US" sz="1100" dirty="0">
              <a:solidFill>
                <a:srgbClr val="00FFFF"/>
              </a:solidFill>
            </a:endParaRP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B001708D-8846-4F2C-AAF3-0F71239558D9}"/>
              </a:ext>
            </a:extLst>
          </p:cNvPr>
          <p:cNvSpPr txBox="1"/>
          <p:nvPr/>
        </p:nvSpPr>
        <p:spPr>
          <a:xfrm>
            <a:off x="513183" y="6895415"/>
            <a:ext cx="649881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100" b="1" dirty="0">
                <a:solidFill>
                  <a:srgbClr val="00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</a:t>
            </a:r>
            <a:r>
              <a:rPr lang="el-GR" altLang="zh-CN" sz="1100" b="1" dirty="0">
                <a:solidFill>
                  <a:srgbClr val="00FF00"/>
                </a:solidFill>
                <a:latin typeface="Arial" panose="020B0604020202020204" pitchFamily="34" charset="0"/>
                <a:ea typeface="FangSong" panose="02010609060101010101" pitchFamily="49" charset="-122"/>
                <a:cs typeface="Arial" panose="020B0604020202020204" pitchFamily="34" charset="0"/>
                <a:sym typeface="Symbol" panose="05050102010706020507" pitchFamily="18" charset="2"/>
              </a:rPr>
              <a:t>δ</a:t>
            </a:r>
            <a:r>
              <a:rPr lang="en-US" altLang="zh-CN" sz="1100" b="1" dirty="0">
                <a:solidFill>
                  <a:srgbClr val="00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zh-CN" altLang="en-US" sz="1100" dirty="0">
              <a:solidFill>
                <a:srgbClr val="00FF00"/>
              </a:solidFill>
            </a:endParaRP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4D0A9AB2-C8BF-43D7-A5A6-9FDDC5BCDBE2}"/>
              </a:ext>
            </a:extLst>
          </p:cNvPr>
          <p:cNvSpPr txBox="1"/>
          <p:nvPr/>
        </p:nvSpPr>
        <p:spPr>
          <a:xfrm>
            <a:off x="1902259" y="6873664"/>
            <a:ext cx="801205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1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AG3</a:t>
            </a:r>
            <a:endParaRPr lang="zh-CN" altLang="en-US" sz="1100" dirty="0">
              <a:solidFill>
                <a:srgbClr val="FF0000"/>
              </a:solidFill>
            </a:endParaRPr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94B4BA36-B31D-4E76-9EEB-F424962D234A}"/>
              </a:ext>
            </a:extLst>
          </p:cNvPr>
          <p:cNvSpPr txBox="1"/>
          <p:nvPr/>
        </p:nvSpPr>
        <p:spPr>
          <a:xfrm>
            <a:off x="4718691" y="6895415"/>
            <a:ext cx="801205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100" b="1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verlay</a:t>
            </a:r>
            <a:endParaRPr lang="zh-CN" altLang="en-US" sz="1100" dirty="0">
              <a:solidFill>
                <a:srgbClr val="FFFF00"/>
              </a:solidFill>
            </a:endParaRPr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A1411AB2-D59F-4EF4-ADBD-0A95792AC741}"/>
              </a:ext>
            </a:extLst>
          </p:cNvPr>
          <p:cNvSpPr txBox="1"/>
          <p:nvPr/>
        </p:nvSpPr>
        <p:spPr>
          <a:xfrm>
            <a:off x="3316761" y="6895415"/>
            <a:ext cx="801205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100" b="1" dirty="0">
                <a:solidFill>
                  <a:srgbClr val="00FF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D1</a:t>
            </a:r>
            <a:endParaRPr lang="zh-CN" altLang="en-US" sz="1100" dirty="0">
              <a:solidFill>
                <a:srgbClr val="00FFFF"/>
              </a:solidFill>
            </a:endParaRPr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6848BCA7-56CE-40AB-B3BC-767CD2248AC4}"/>
              </a:ext>
            </a:extLst>
          </p:cNvPr>
          <p:cNvSpPr txBox="1"/>
          <p:nvPr/>
        </p:nvSpPr>
        <p:spPr>
          <a:xfrm>
            <a:off x="510108" y="8327868"/>
            <a:ext cx="649881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100" b="1" dirty="0">
                <a:solidFill>
                  <a:srgbClr val="00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</a:t>
            </a:r>
            <a:r>
              <a:rPr lang="el-GR" altLang="zh-CN" sz="1100" b="1" dirty="0">
                <a:solidFill>
                  <a:srgbClr val="00FF00"/>
                </a:solidFill>
                <a:latin typeface="Arial" panose="020B0604020202020204" pitchFamily="34" charset="0"/>
                <a:ea typeface="FangSong" panose="02010609060101010101" pitchFamily="49" charset="-122"/>
                <a:cs typeface="Arial" panose="020B0604020202020204" pitchFamily="34" charset="0"/>
                <a:sym typeface="Symbol" panose="05050102010706020507" pitchFamily="18" charset="2"/>
              </a:rPr>
              <a:t>δ</a:t>
            </a:r>
            <a:r>
              <a:rPr lang="en-US" altLang="zh-CN" sz="1100" b="1" dirty="0">
                <a:solidFill>
                  <a:srgbClr val="00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zh-CN" altLang="en-US" sz="1100" dirty="0">
              <a:solidFill>
                <a:srgbClr val="00FF00"/>
              </a:solidFill>
            </a:endParaRPr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400031BA-E7E9-4EC9-94EF-B0FEA7D0E599}"/>
              </a:ext>
            </a:extLst>
          </p:cNvPr>
          <p:cNvSpPr txBox="1"/>
          <p:nvPr/>
        </p:nvSpPr>
        <p:spPr>
          <a:xfrm>
            <a:off x="1899184" y="8306117"/>
            <a:ext cx="801205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1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AG3</a:t>
            </a:r>
            <a:endParaRPr lang="zh-CN" altLang="en-US" sz="1100" dirty="0">
              <a:solidFill>
                <a:srgbClr val="FF0000"/>
              </a:solidFill>
            </a:endParaRPr>
          </a:p>
        </p:txBody>
      </p:sp>
      <p:sp>
        <p:nvSpPr>
          <p:cNvPr id="54" name="文本框 53">
            <a:extLst>
              <a:ext uri="{FF2B5EF4-FFF2-40B4-BE49-F238E27FC236}">
                <a16:creationId xmlns:a16="http://schemas.microsoft.com/office/drawing/2014/main" id="{1848463D-F51F-40C5-B6C8-44EBA0B7C352}"/>
              </a:ext>
            </a:extLst>
          </p:cNvPr>
          <p:cNvSpPr txBox="1"/>
          <p:nvPr/>
        </p:nvSpPr>
        <p:spPr>
          <a:xfrm>
            <a:off x="4715616" y="8327868"/>
            <a:ext cx="801205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100" b="1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verlay</a:t>
            </a:r>
            <a:endParaRPr lang="zh-CN" altLang="en-US" sz="1100" dirty="0">
              <a:solidFill>
                <a:srgbClr val="FFFF00"/>
              </a:solidFill>
            </a:endParaRPr>
          </a:p>
        </p:txBody>
      </p:sp>
      <p:sp>
        <p:nvSpPr>
          <p:cNvPr id="55" name="文本框 54">
            <a:extLst>
              <a:ext uri="{FF2B5EF4-FFF2-40B4-BE49-F238E27FC236}">
                <a16:creationId xmlns:a16="http://schemas.microsoft.com/office/drawing/2014/main" id="{5F3BB461-1E35-437D-A7A2-CED4B90F5ACF}"/>
              </a:ext>
            </a:extLst>
          </p:cNvPr>
          <p:cNvSpPr txBox="1"/>
          <p:nvPr/>
        </p:nvSpPr>
        <p:spPr>
          <a:xfrm>
            <a:off x="3313686" y="8327868"/>
            <a:ext cx="801205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100" b="1" dirty="0">
                <a:solidFill>
                  <a:srgbClr val="00FF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D1</a:t>
            </a:r>
            <a:endParaRPr lang="zh-CN" altLang="en-US" sz="1100" dirty="0">
              <a:solidFill>
                <a:srgbClr val="00FFFF"/>
              </a:solidFill>
            </a:endParaRP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4E8F5C8C-A29D-435F-B67E-1314F73CCC81}"/>
              </a:ext>
            </a:extLst>
          </p:cNvPr>
          <p:cNvSpPr txBox="1"/>
          <p:nvPr/>
        </p:nvSpPr>
        <p:spPr>
          <a:xfrm>
            <a:off x="307663" y="1199351"/>
            <a:ext cx="6550337" cy="129465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>
              <a:lnSpc>
                <a:spcPct val="150000"/>
              </a:lnSpc>
            </a:pPr>
            <a:r>
              <a:rPr lang="en-GB" altLang="zh-CN" sz="18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Confocal microscope visualisation of PD1 expression on Vδ1 and Vδ2 T cells in hepatocellular carcinoma tumour and peri-tumour tissue.</a:t>
            </a:r>
            <a:endParaRPr lang="zh-CN" altLang="zh-CN" sz="14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46338076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TextBox 3">
            <a:extLst>
              <a:ext uri="{FF2B5EF4-FFF2-40B4-BE49-F238E27FC236}">
                <a16:creationId xmlns:a16="http://schemas.microsoft.com/office/drawing/2014/main" id="{06FE688C-23FE-4026-B48F-CF2F49AA760F}"/>
              </a:ext>
            </a:extLst>
          </p:cNvPr>
          <p:cNvSpPr txBox="1"/>
          <p:nvPr/>
        </p:nvSpPr>
        <p:spPr>
          <a:xfrm>
            <a:off x="322118" y="2882585"/>
            <a:ext cx="623606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kern="100" dirty="0">
                <a:latin typeface="Arial" panose="020B0604020202020204" pitchFamily="34" charset="0"/>
                <a:cs typeface="Times New Roman" panose="02020603050405020304" pitchFamily="18" charset="0"/>
              </a:rPr>
              <a:t>(A) </a:t>
            </a:r>
            <a:r>
              <a:rPr lang="en-US" altLang="zh-CN" sz="2000" b="1" i="1" kern="100" dirty="0">
                <a:latin typeface="Arial" panose="020B0604020202020204" pitchFamily="34" charset="0"/>
                <a:cs typeface="Times New Roman" panose="02020603050405020304" pitchFamily="18" charset="0"/>
              </a:rPr>
              <a:t>Expressions of PD-1, TIM3, </a:t>
            </a:r>
            <a:r>
              <a:rPr lang="en-US" altLang="zh-CN" sz="2000" b="1" i="1" kern="100" dirty="0" err="1">
                <a:latin typeface="Arial" panose="020B0604020202020204" pitchFamily="34" charset="0"/>
                <a:cs typeface="Times New Roman" panose="02020603050405020304" pitchFamily="18" charset="0"/>
              </a:rPr>
              <a:t>GzB</a:t>
            </a:r>
            <a:r>
              <a:rPr lang="en-US" altLang="zh-CN" sz="2000" b="1" i="1" kern="100" dirty="0">
                <a:latin typeface="Arial" panose="020B0604020202020204" pitchFamily="34" charset="0"/>
                <a:cs typeface="Times New Roman" panose="02020603050405020304" pitchFamily="18" charset="0"/>
              </a:rPr>
              <a:t>, and CD107a on V</a:t>
            </a:r>
            <a:r>
              <a:rPr lang="el-GR" altLang="zh-CN" sz="2000" b="1" i="1" kern="100" dirty="0">
                <a:latin typeface="Arial" panose="020B0604020202020204" pitchFamily="34" charset="0"/>
                <a:cs typeface="Times New Roman" panose="02020603050405020304" pitchFamily="18" charset="0"/>
              </a:rPr>
              <a:t>δ</a:t>
            </a:r>
            <a:r>
              <a:rPr lang="en-US" altLang="zh-CN" sz="2000" b="1" i="1" kern="100" dirty="0">
                <a:latin typeface="Arial" panose="020B0604020202020204" pitchFamily="34" charset="0"/>
                <a:cs typeface="Times New Roman" panose="02020603050405020304" pitchFamily="18" charset="0"/>
              </a:rPr>
              <a:t>2+</a:t>
            </a:r>
            <a:r>
              <a:rPr lang="el-GR" altLang="zh-CN" sz="2000" b="1" i="1" kern="100" dirty="0">
                <a:latin typeface="Arial" panose="020B0604020202020204" pitchFamily="34" charset="0"/>
                <a:cs typeface="Times New Roman" panose="02020603050405020304" pitchFamily="18" charset="0"/>
              </a:rPr>
              <a:t>γδ</a:t>
            </a:r>
            <a:r>
              <a:rPr lang="en-US" altLang="zh-CN" sz="2000" b="1" i="1" kern="100" dirty="0">
                <a:latin typeface="Arial" panose="020B0604020202020204" pitchFamily="34" charset="0"/>
                <a:cs typeface="Times New Roman" panose="02020603050405020304" pitchFamily="18" charset="0"/>
              </a:rPr>
              <a:t>T cells in the condition of Glu</a:t>
            </a:r>
            <a:r>
              <a:rPr lang="en-US" altLang="zh-CN" sz="2000" b="1" i="1" kern="100" baseline="30000" dirty="0">
                <a:latin typeface="Arial" panose="020B0604020202020204" pitchFamily="34" charset="0"/>
                <a:cs typeface="Times New Roman" panose="02020603050405020304" pitchFamily="18" charset="0"/>
              </a:rPr>
              <a:t>-</a:t>
            </a:r>
            <a:r>
              <a:rPr lang="en-US" altLang="zh-CN" sz="2000" b="1" i="1" kern="100" dirty="0">
                <a:latin typeface="Arial" panose="020B0604020202020204" pitchFamily="34" charset="0"/>
                <a:cs typeface="Times New Roman" panose="02020603050405020304" pitchFamily="18" charset="0"/>
              </a:rPr>
              <a:t> medium.</a:t>
            </a:r>
            <a:endParaRPr 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标题 1">
            <a:extLst>
              <a:ext uri="{FF2B5EF4-FFF2-40B4-BE49-F238E27FC236}">
                <a16:creationId xmlns:a16="http://schemas.microsoft.com/office/drawing/2014/main" id="{E6C0F36F-C33D-40C4-ACD5-F7979E3FFF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99845" y="169819"/>
            <a:ext cx="4916292" cy="588919"/>
          </a:xfrm>
        </p:spPr>
        <p:txBody>
          <a:bodyPr>
            <a:normAutofit/>
          </a:bodyPr>
          <a:lstStyle/>
          <a:p>
            <a:pPr>
              <a:lnSpc>
                <a:spcPct val="100000"/>
              </a:lnSpc>
            </a:pPr>
            <a:r>
              <a:rPr lang="en-US" altLang="zh-CN" sz="2800" b="1" kern="100" dirty="0">
                <a:latin typeface="Arial" panose="020B0604020202020204" pitchFamily="34" charset="0"/>
                <a:cs typeface="Times New Roman" panose="02020603050405020304" pitchFamily="18" charset="0"/>
              </a:rPr>
              <a:t>Extended data for Figure 6. </a:t>
            </a:r>
            <a:endParaRPr lang="zh-CN" altLang="en-US" sz="2800" dirty="0"/>
          </a:p>
        </p:txBody>
      </p:sp>
      <p:graphicFrame>
        <p:nvGraphicFramePr>
          <p:cNvPr id="16" name="Object 40">
            <a:extLst>
              <a:ext uri="{FF2B5EF4-FFF2-40B4-BE49-F238E27FC236}">
                <a16:creationId xmlns:a16="http://schemas.microsoft.com/office/drawing/2014/main" id="{1B4D30A3-402E-4ACA-9361-DA47AFDDC73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53817926"/>
              </p:ext>
            </p:extLst>
          </p:nvPr>
        </p:nvGraphicFramePr>
        <p:xfrm>
          <a:off x="395806" y="3622551"/>
          <a:ext cx="1591913" cy="144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74" name="Prism 9" r:id="rId3" imgW="3193472" imgH="2889309" progId="Prism9.Document">
                  <p:embed/>
                </p:oleObj>
              </mc:Choice>
              <mc:Fallback>
                <p:oleObj name="Prism 9" r:id="rId3" imgW="3193472" imgH="2889309" progId="Prism9.Document">
                  <p:embed/>
                  <p:pic>
                    <p:nvPicPr>
                      <p:cNvPr id="41" name="Object 40">
                        <a:extLst>
                          <a:ext uri="{FF2B5EF4-FFF2-40B4-BE49-F238E27FC236}">
                            <a16:creationId xmlns:a16="http://schemas.microsoft.com/office/drawing/2014/main" id="{05A61CF5-E54F-478C-B314-EFAF22E75B7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95806" y="3622551"/>
                        <a:ext cx="1591913" cy="144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" name="Object 41">
            <a:extLst>
              <a:ext uri="{FF2B5EF4-FFF2-40B4-BE49-F238E27FC236}">
                <a16:creationId xmlns:a16="http://schemas.microsoft.com/office/drawing/2014/main" id="{1E5F22CB-06AC-437B-BAE1-CFE8F39A4DE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84229930"/>
              </p:ext>
            </p:extLst>
          </p:nvPr>
        </p:nvGraphicFramePr>
        <p:xfrm>
          <a:off x="3202693" y="3644107"/>
          <a:ext cx="1596125" cy="144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75" name="Prism 9" r:id="rId5" imgW="3196711" imgH="2884989" progId="Prism9.Document">
                  <p:embed/>
                </p:oleObj>
              </mc:Choice>
              <mc:Fallback>
                <p:oleObj name="Prism 9" r:id="rId5" imgW="3196711" imgH="2884989" progId="Prism9.Document">
                  <p:embed/>
                  <p:pic>
                    <p:nvPicPr>
                      <p:cNvPr id="42" name="Object 41">
                        <a:extLst>
                          <a:ext uri="{FF2B5EF4-FFF2-40B4-BE49-F238E27FC236}">
                            <a16:creationId xmlns:a16="http://schemas.microsoft.com/office/drawing/2014/main" id="{7A70DA1A-74B1-4646-A629-59712413861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202693" y="3644107"/>
                        <a:ext cx="1596125" cy="144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1" name="Object 44">
            <a:extLst>
              <a:ext uri="{FF2B5EF4-FFF2-40B4-BE49-F238E27FC236}">
                <a16:creationId xmlns:a16="http://schemas.microsoft.com/office/drawing/2014/main" id="{51A90204-D005-4434-9A9A-24D40B11910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4306557"/>
              </p:ext>
            </p:extLst>
          </p:nvPr>
        </p:nvGraphicFramePr>
        <p:xfrm>
          <a:off x="4632708" y="3622551"/>
          <a:ext cx="1590082" cy="144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76" name="Prism 9" r:id="rId7" imgW="3194912" imgH="2893989" progId="Prism9.Document">
                  <p:embed/>
                </p:oleObj>
              </mc:Choice>
              <mc:Fallback>
                <p:oleObj name="Prism 9" r:id="rId7" imgW="3194912" imgH="2893989" progId="Prism9.Document">
                  <p:embed/>
                  <p:pic>
                    <p:nvPicPr>
                      <p:cNvPr id="45" name="Object 44">
                        <a:extLst>
                          <a:ext uri="{FF2B5EF4-FFF2-40B4-BE49-F238E27FC236}">
                            <a16:creationId xmlns:a16="http://schemas.microsoft.com/office/drawing/2014/main" id="{C4D78D15-735B-4F26-A83D-647008825A0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4632708" y="3622551"/>
                        <a:ext cx="1590082" cy="144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2" name="Object 45">
            <a:extLst>
              <a:ext uri="{FF2B5EF4-FFF2-40B4-BE49-F238E27FC236}">
                <a16:creationId xmlns:a16="http://schemas.microsoft.com/office/drawing/2014/main" id="{55E4D0AB-3D13-4F7D-AE85-EF91667154A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0621511"/>
              </p:ext>
            </p:extLst>
          </p:nvPr>
        </p:nvGraphicFramePr>
        <p:xfrm>
          <a:off x="1778307" y="3612027"/>
          <a:ext cx="1572623" cy="144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77" name="Prism 9" r:id="rId9" imgW="3181235" imgH="2912349" progId="Prism9.Document">
                  <p:embed/>
                </p:oleObj>
              </mc:Choice>
              <mc:Fallback>
                <p:oleObj name="Prism 9" r:id="rId9" imgW="3181235" imgH="2912349" progId="Prism9.Document">
                  <p:embed/>
                  <p:pic>
                    <p:nvPicPr>
                      <p:cNvPr id="46" name="Object 45">
                        <a:extLst>
                          <a:ext uri="{FF2B5EF4-FFF2-40B4-BE49-F238E27FC236}">
                            <a16:creationId xmlns:a16="http://schemas.microsoft.com/office/drawing/2014/main" id="{1A5E012F-4846-40A5-AB34-082E9D16892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1778307" y="3612027"/>
                        <a:ext cx="1572623" cy="144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3" name="Object 39">
            <a:extLst>
              <a:ext uri="{FF2B5EF4-FFF2-40B4-BE49-F238E27FC236}">
                <a16:creationId xmlns:a16="http://schemas.microsoft.com/office/drawing/2014/main" id="{BB70AF7B-254F-46B5-872A-AA211D226A9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64555340"/>
              </p:ext>
            </p:extLst>
          </p:nvPr>
        </p:nvGraphicFramePr>
        <p:xfrm>
          <a:off x="3170101" y="7017836"/>
          <a:ext cx="1503083" cy="144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78" name="Prism 9" r:id="rId11" imgW="3063905" imgH="2935029" progId="Prism9.Document">
                  <p:embed/>
                </p:oleObj>
              </mc:Choice>
              <mc:Fallback>
                <p:oleObj name="Prism 9" r:id="rId11" imgW="3063905" imgH="2935029" progId="Prism9.Document">
                  <p:embed/>
                  <p:pic>
                    <p:nvPicPr>
                      <p:cNvPr id="40" name="Object 39">
                        <a:extLst>
                          <a:ext uri="{FF2B5EF4-FFF2-40B4-BE49-F238E27FC236}">
                            <a16:creationId xmlns:a16="http://schemas.microsoft.com/office/drawing/2014/main" id="{1D9E3473-9F76-42B0-AB44-7DD0C265E98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3170101" y="7017836"/>
                        <a:ext cx="1503083" cy="144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4" name="Object 47">
            <a:extLst>
              <a:ext uri="{FF2B5EF4-FFF2-40B4-BE49-F238E27FC236}">
                <a16:creationId xmlns:a16="http://schemas.microsoft.com/office/drawing/2014/main" id="{D727777B-C66B-4492-8BF2-D0486ED1AA6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45487410"/>
              </p:ext>
            </p:extLst>
          </p:nvPr>
        </p:nvGraphicFramePr>
        <p:xfrm>
          <a:off x="4467376" y="6996280"/>
          <a:ext cx="1558771" cy="144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79" name="Prism 9" r:id="rId13" imgW="3187353" imgH="2944388" progId="Prism9.Document">
                  <p:embed/>
                </p:oleObj>
              </mc:Choice>
              <mc:Fallback>
                <p:oleObj name="Prism 9" r:id="rId13" imgW="3187353" imgH="2944388" progId="Prism9.Document">
                  <p:embed/>
                  <p:pic>
                    <p:nvPicPr>
                      <p:cNvPr id="48" name="Object 47">
                        <a:extLst>
                          <a:ext uri="{FF2B5EF4-FFF2-40B4-BE49-F238E27FC236}">
                            <a16:creationId xmlns:a16="http://schemas.microsoft.com/office/drawing/2014/main" id="{D2D564EF-3F3C-49F9-941C-80C608A4A82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4467376" y="6996280"/>
                        <a:ext cx="1558771" cy="144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5" name="Object 54">
            <a:extLst>
              <a:ext uri="{FF2B5EF4-FFF2-40B4-BE49-F238E27FC236}">
                <a16:creationId xmlns:a16="http://schemas.microsoft.com/office/drawing/2014/main" id="{D77F3B69-37E7-4057-927F-C3D5E0A3E69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91342838"/>
              </p:ext>
            </p:extLst>
          </p:nvPr>
        </p:nvGraphicFramePr>
        <p:xfrm>
          <a:off x="1778307" y="7017836"/>
          <a:ext cx="1629864" cy="144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80" name="Prism 9" r:id="rId15" imgW="3312242" imgH="2926029" progId="Prism9.Document">
                  <p:embed/>
                </p:oleObj>
              </mc:Choice>
              <mc:Fallback>
                <p:oleObj name="Prism 9" r:id="rId15" imgW="3312242" imgH="2926029" progId="Prism9.Document">
                  <p:embed/>
                  <p:pic>
                    <p:nvPicPr>
                      <p:cNvPr id="55" name="Object 54">
                        <a:extLst>
                          <a:ext uri="{FF2B5EF4-FFF2-40B4-BE49-F238E27FC236}">
                            <a16:creationId xmlns:a16="http://schemas.microsoft.com/office/drawing/2014/main" id="{F5AF9DE7-2401-432F-8FFA-97136B29C42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1778307" y="7017836"/>
                        <a:ext cx="1629864" cy="144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6" name="Object 55">
            <a:extLst>
              <a:ext uri="{FF2B5EF4-FFF2-40B4-BE49-F238E27FC236}">
                <a16:creationId xmlns:a16="http://schemas.microsoft.com/office/drawing/2014/main" id="{EE328CF6-F3C3-469F-8FA0-1DDEDC6BEA9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33594497"/>
              </p:ext>
            </p:extLst>
          </p:nvPr>
        </p:nvGraphicFramePr>
        <p:xfrm>
          <a:off x="449132" y="6996280"/>
          <a:ext cx="1545064" cy="144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81" name="Prism 9" r:id="rId17" imgW="3175117" imgH="2959508" progId="Prism9.Document">
                  <p:embed/>
                </p:oleObj>
              </mc:Choice>
              <mc:Fallback>
                <p:oleObj name="Prism 9" r:id="rId17" imgW="3175117" imgH="2959508" progId="Prism9.Document">
                  <p:embed/>
                  <p:pic>
                    <p:nvPicPr>
                      <p:cNvPr id="56" name="Object 55">
                        <a:extLst>
                          <a:ext uri="{FF2B5EF4-FFF2-40B4-BE49-F238E27FC236}">
                            <a16:creationId xmlns:a16="http://schemas.microsoft.com/office/drawing/2014/main" id="{A88B4A24-423C-448D-B5DF-DA3DB6AE4DB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449132" y="6996280"/>
                        <a:ext cx="1545064" cy="144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7" name="TextBox 3">
            <a:extLst>
              <a:ext uri="{FF2B5EF4-FFF2-40B4-BE49-F238E27FC236}">
                <a16:creationId xmlns:a16="http://schemas.microsoft.com/office/drawing/2014/main" id="{2E86FA15-E481-4AC5-BFA5-C28850D6BF79}"/>
              </a:ext>
            </a:extLst>
          </p:cNvPr>
          <p:cNvSpPr txBox="1"/>
          <p:nvPr/>
        </p:nvSpPr>
        <p:spPr>
          <a:xfrm>
            <a:off x="322118" y="5766610"/>
            <a:ext cx="6236063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kern="100" dirty="0">
                <a:latin typeface="Arial" panose="020B0604020202020204" pitchFamily="34" charset="0"/>
                <a:cs typeface="Times New Roman" panose="02020603050405020304" pitchFamily="18" charset="0"/>
              </a:rPr>
              <a:t>(B) </a:t>
            </a:r>
            <a:r>
              <a:rPr lang="en-US" altLang="zh-CN" sz="2000" b="1" i="1" kern="100" dirty="0">
                <a:latin typeface="Arial" panose="020B0604020202020204" pitchFamily="34" charset="0"/>
                <a:cs typeface="Times New Roman" panose="02020603050405020304" pitchFamily="18" charset="0"/>
              </a:rPr>
              <a:t>Expressions of INF-</a:t>
            </a:r>
            <a:r>
              <a:rPr lang="el-GR" altLang="zh-CN" sz="2000" b="1" i="1" kern="100" dirty="0">
                <a:latin typeface="Arial" panose="020B0604020202020204" pitchFamily="34" charset="0"/>
                <a:cs typeface="Times New Roman" panose="02020603050405020304" pitchFamily="18" charset="0"/>
              </a:rPr>
              <a:t>γ</a:t>
            </a:r>
            <a:r>
              <a:rPr lang="en-US" altLang="zh-CN" sz="2000" b="1" i="1" kern="100" dirty="0">
                <a:latin typeface="Arial" panose="020B0604020202020204" pitchFamily="34" charset="0"/>
                <a:cs typeface="Times New Roman" panose="02020603050405020304" pitchFamily="18" charset="0"/>
              </a:rPr>
              <a:t>, TNF-</a:t>
            </a:r>
            <a:r>
              <a:rPr lang="el-GR" altLang="zh-CN" sz="2000" b="1" i="1" kern="100" dirty="0">
                <a:latin typeface="Arial" panose="020B0604020202020204" pitchFamily="34" charset="0"/>
                <a:cs typeface="Times New Roman" panose="02020603050405020304" pitchFamily="18" charset="0"/>
              </a:rPr>
              <a:t>α</a:t>
            </a:r>
            <a:r>
              <a:rPr lang="en-US" altLang="zh-CN" sz="2000" b="1" i="1" kern="100" dirty="0">
                <a:latin typeface="Arial" panose="020B0604020202020204" pitchFamily="34" charset="0"/>
                <a:cs typeface="Times New Roman" panose="02020603050405020304" pitchFamily="18" charset="0"/>
              </a:rPr>
              <a:t>, </a:t>
            </a:r>
            <a:r>
              <a:rPr lang="en-US" altLang="zh-CN" sz="2000" b="1" i="1" kern="100" dirty="0" err="1">
                <a:latin typeface="Arial" panose="020B0604020202020204" pitchFamily="34" charset="0"/>
                <a:cs typeface="Times New Roman" panose="02020603050405020304" pitchFamily="18" charset="0"/>
              </a:rPr>
              <a:t>GzB</a:t>
            </a:r>
            <a:r>
              <a:rPr lang="en-US" altLang="zh-CN" sz="2000" b="1" i="1" kern="100" dirty="0">
                <a:latin typeface="Arial" panose="020B0604020202020204" pitchFamily="34" charset="0"/>
                <a:cs typeface="Times New Roman" panose="02020603050405020304" pitchFamily="18" charset="0"/>
              </a:rPr>
              <a:t>, and CD107a on V</a:t>
            </a:r>
            <a:r>
              <a:rPr lang="el-GR" altLang="zh-CN" sz="2000" b="1" i="1" kern="100" dirty="0">
                <a:latin typeface="Arial" panose="020B0604020202020204" pitchFamily="34" charset="0"/>
                <a:cs typeface="Times New Roman" panose="02020603050405020304" pitchFamily="18" charset="0"/>
              </a:rPr>
              <a:t>δ</a:t>
            </a:r>
            <a:r>
              <a:rPr lang="en-US" altLang="zh-CN" sz="2000" b="1" i="1" kern="100" dirty="0">
                <a:latin typeface="Arial" panose="020B0604020202020204" pitchFamily="34" charset="0"/>
                <a:cs typeface="Times New Roman" panose="02020603050405020304" pitchFamily="18" charset="0"/>
              </a:rPr>
              <a:t>2+</a:t>
            </a:r>
            <a:r>
              <a:rPr lang="el-GR" altLang="zh-CN" sz="2000" b="1" i="1" kern="100" dirty="0">
                <a:latin typeface="Arial" panose="020B0604020202020204" pitchFamily="34" charset="0"/>
                <a:cs typeface="Times New Roman" panose="02020603050405020304" pitchFamily="18" charset="0"/>
              </a:rPr>
              <a:t>γδ</a:t>
            </a:r>
            <a:r>
              <a:rPr lang="en-US" altLang="zh-CN" sz="2000" b="1" i="1" kern="100" dirty="0">
                <a:latin typeface="Arial" panose="020B0604020202020204" pitchFamily="34" charset="0"/>
                <a:cs typeface="Times New Roman" panose="02020603050405020304" pitchFamily="18" charset="0"/>
              </a:rPr>
              <a:t>T cells under the HCC trans-well condition.</a:t>
            </a:r>
            <a:endParaRPr 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7DF51FA2-C6E2-4B2A-919F-D3A1E9C876F4}"/>
              </a:ext>
            </a:extLst>
          </p:cNvPr>
          <p:cNvSpPr txBox="1"/>
          <p:nvPr/>
        </p:nvSpPr>
        <p:spPr>
          <a:xfrm>
            <a:off x="322118" y="1006787"/>
            <a:ext cx="615141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zh-CN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Cytokines released by </a:t>
            </a:r>
            <a:r>
              <a:rPr lang="en-GB" altLang="zh-CN" kern="10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γδ</a:t>
            </a:r>
            <a:r>
              <a:rPr lang="en-GB" altLang="zh-CN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T cells cultured under normal conditions and in the glutamine-deficient culture medium.</a:t>
            </a:r>
            <a:endParaRPr lang="zh-CN" altLang="zh-CN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54662003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组合 16">
            <a:extLst>
              <a:ext uri="{FF2B5EF4-FFF2-40B4-BE49-F238E27FC236}">
                <a16:creationId xmlns:a16="http://schemas.microsoft.com/office/drawing/2014/main" id="{931D40D1-E39D-4C8B-ACF8-E62CEB20D197}"/>
              </a:ext>
            </a:extLst>
          </p:cNvPr>
          <p:cNvGrpSpPr/>
          <p:nvPr/>
        </p:nvGrpSpPr>
        <p:grpSpPr>
          <a:xfrm>
            <a:off x="592530" y="1350186"/>
            <a:ext cx="5294290" cy="7797076"/>
            <a:chOff x="417165" y="736410"/>
            <a:chExt cx="5294290" cy="7797076"/>
          </a:xfrm>
        </p:grpSpPr>
        <p:graphicFrame>
          <p:nvGraphicFramePr>
            <p:cNvPr id="12" name="对象 11">
              <a:extLst>
                <a:ext uri="{FF2B5EF4-FFF2-40B4-BE49-F238E27FC236}">
                  <a16:creationId xmlns:a16="http://schemas.microsoft.com/office/drawing/2014/main" id="{E02DFCD1-C13A-4D63-B2DA-5C3E9BA29022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3406405" y="1043661"/>
            <a:ext cx="2305050" cy="74866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4137" name="Prism 7" r:id="rId3" imgW="2305229" imgH="7486162" progId="Prism7.Document">
                    <p:embed/>
                  </p:oleObj>
                </mc:Choice>
                <mc:Fallback>
                  <p:oleObj name="Prism 7" r:id="rId3" imgW="2305229" imgH="7486162" progId="Prism7.Document">
                    <p:embed/>
                    <p:pic>
                      <p:nvPicPr>
                        <p:cNvPr id="12" name="对象 11">
                          <a:extLst>
                            <a:ext uri="{FF2B5EF4-FFF2-40B4-BE49-F238E27FC236}">
                              <a16:creationId xmlns:a16="http://schemas.microsoft.com/office/drawing/2014/main" id="{E02DFCD1-C13A-4D63-B2DA-5C3E9BA29022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3406405" y="1043661"/>
                          <a:ext cx="2305050" cy="748665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1" name="对象 10">
              <a:extLst>
                <a:ext uri="{FF2B5EF4-FFF2-40B4-BE49-F238E27FC236}">
                  <a16:creationId xmlns:a16="http://schemas.microsoft.com/office/drawing/2014/main" id="{90B6A220-E915-46D9-A8BF-51A781B9A49E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1934119" y="1043661"/>
            <a:ext cx="2276475" cy="74898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4138" name="Prism 7" r:id="rId5" imgW="2276058" imgH="7490484" progId="Prism7.Document">
                    <p:embed/>
                  </p:oleObj>
                </mc:Choice>
                <mc:Fallback>
                  <p:oleObj name="Prism 7" r:id="rId5" imgW="2276058" imgH="7490484" progId="Prism7.Document">
                    <p:embed/>
                    <p:pic>
                      <p:nvPicPr>
                        <p:cNvPr id="11" name="对象 10">
                          <a:extLst>
                            <a:ext uri="{FF2B5EF4-FFF2-40B4-BE49-F238E27FC236}">
                              <a16:creationId xmlns:a16="http://schemas.microsoft.com/office/drawing/2014/main" id="{90B6A220-E915-46D9-A8BF-51A781B9A49E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1934119" y="1043661"/>
                          <a:ext cx="2276475" cy="74898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0" name="对象 9">
              <a:extLst>
                <a:ext uri="{FF2B5EF4-FFF2-40B4-BE49-F238E27FC236}">
                  <a16:creationId xmlns:a16="http://schemas.microsoft.com/office/drawing/2014/main" id="{00F221FA-A3ED-43EE-A68A-C5C398605644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417165" y="1046836"/>
            <a:ext cx="2346325" cy="74866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4139" name="Prism 7" r:id="rId7" imgW="2346284" imgH="7486162" progId="Prism7.Document">
                    <p:embed/>
                  </p:oleObj>
                </mc:Choice>
                <mc:Fallback>
                  <p:oleObj name="Prism 7" r:id="rId7" imgW="2346284" imgH="7486162" progId="Prism7.Document">
                    <p:embed/>
                    <p:pic>
                      <p:nvPicPr>
                        <p:cNvPr id="10" name="对象 9">
                          <a:extLst>
                            <a:ext uri="{FF2B5EF4-FFF2-40B4-BE49-F238E27FC236}">
                              <a16:creationId xmlns:a16="http://schemas.microsoft.com/office/drawing/2014/main" id="{00F221FA-A3ED-43EE-A68A-C5C398605644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417165" y="1046836"/>
                          <a:ext cx="2346325" cy="748665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25848D8D-756A-4A94-831E-75B1BA1B44BA}"/>
                </a:ext>
              </a:extLst>
            </p:cNvPr>
            <p:cNvSpPr txBox="1"/>
            <p:nvPr/>
          </p:nvSpPr>
          <p:spPr>
            <a:xfrm>
              <a:off x="1158157" y="736410"/>
              <a:ext cx="864339" cy="36933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en-US" altLang="zh-CN" dirty="0"/>
                <a:t>24hour</a:t>
              </a:r>
              <a:endParaRPr lang="zh-CN" altLang="en-US" dirty="0"/>
            </a:p>
          </p:txBody>
        </p:sp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737E90FF-8EE4-4A5C-A637-3F572BC10E69}"/>
                </a:ext>
              </a:extLst>
            </p:cNvPr>
            <p:cNvSpPr txBox="1"/>
            <p:nvPr/>
          </p:nvSpPr>
          <p:spPr>
            <a:xfrm>
              <a:off x="2687855" y="736410"/>
              <a:ext cx="864339" cy="36933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en-US" altLang="zh-CN" dirty="0"/>
                <a:t>48hour</a:t>
              </a:r>
              <a:endParaRPr lang="zh-CN" altLang="en-US" dirty="0"/>
            </a:p>
          </p:txBody>
        </p:sp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47756902-A959-45B7-968D-D2B29D593579}"/>
                </a:ext>
              </a:extLst>
            </p:cNvPr>
            <p:cNvSpPr txBox="1"/>
            <p:nvPr/>
          </p:nvSpPr>
          <p:spPr>
            <a:xfrm>
              <a:off x="4270744" y="736410"/>
              <a:ext cx="864339" cy="36933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en-US" altLang="zh-CN" dirty="0"/>
                <a:t>72hour</a:t>
              </a:r>
              <a:endParaRPr lang="zh-CN" altLang="en-US" dirty="0"/>
            </a:p>
          </p:txBody>
        </p:sp>
      </p:grpSp>
      <p:sp>
        <p:nvSpPr>
          <p:cNvPr id="19" name="TextBox 3">
            <a:extLst>
              <a:ext uri="{FF2B5EF4-FFF2-40B4-BE49-F238E27FC236}">
                <a16:creationId xmlns:a16="http://schemas.microsoft.com/office/drawing/2014/main" id="{06FE688C-23FE-4026-B48F-CF2F49AA760F}"/>
              </a:ext>
            </a:extLst>
          </p:cNvPr>
          <p:cNvSpPr txBox="1"/>
          <p:nvPr/>
        </p:nvSpPr>
        <p:spPr>
          <a:xfrm>
            <a:off x="384656" y="854407"/>
            <a:ext cx="435888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kern="100" dirty="0">
                <a:latin typeface="Arial" panose="020B0604020202020204" pitchFamily="34" charset="0"/>
                <a:cs typeface="Times New Roman" panose="02020603050405020304" pitchFamily="18" charset="0"/>
              </a:rPr>
              <a:t>(C) </a:t>
            </a:r>
            <a:r>
              <a:rPr lang="en-US" altLang="zh-CN" sz="2000" b="1" i="1" kern="100" dirty="0">
                <a:latin typeface="Arial" panose="020B0604020202020204" pitchFamily="34" charset="0"/>
                <a:cs typeface="Times New Roman" panose="02020603050405020304" pitchFamily="18" charset="0"/>
              </a:rPr>
              <a:t>Cytokine assay using Luminex</a:t>
            </a:r>
            <a:endParaRPr 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标题 1">
            <a:extLst>
              <a:ext uri="{FF2B5EF4-FFF2-40B4-BE49-F238E27FC236}">
                <a16:creationId xmlns:a16="http://schemas.microsoft.com/office/drawing/2014/main" id="{E6C0F36F-C33D-40C4-ACD5-F7979E3FFF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99845" y="169819"/>
            <a:ext cx="4916292" cy="588919"/>
          </a:xfrm>
        </p:spPr>
        <p:txBody>
          <a:bodyPr>
            <a:normAutofit/>
          </a:bodyPr>
          <a:lstStyle/>
          <a:p>
            <a:pPr>
              <a:lnSpc>
                <a:spcPct val="100000"/>
              </a:lnSpc>
            </a:pPr>
            <a:r>
              <a:rPr lang="en-US" altLang="zh-CN" sz="2800" b="1" kern="100" dirty="0">
                <a:latin typeface="Arial" panose="020B0604020202020204" pitchFamily="34" charset="0"/>
                <a:cs typeface="Times New Roman" panose="02020603050405020304" pitchFamily="18" charset="0"/>
              </a:rPr>
              <a:t>Extended data for Figure 6. </a:t>
            </a:r>
            <a:endParaRPr lang="zh-CN" altLang="en-US" sz="2800" dirty="0"/>
          </a:p>
        </p:txBody>
      </p:sp>
    </p:spTree>
    <p:extLst>
      <p:ext uri="{BB962C8B-B14F-4D97-AF65-F5344CB8AC3E}">
        <p14:creationId xmlns:p14="http://schemas.microsoft.com/office/powerpoint/2010/main" val="1764668693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3FF8B78C-5A4A-4BDB-8DA6-251C44F1853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7124" t="12393" r="63709" b="16656"/>
          <a:stretch/>
        </p:blipFill>
        <p:spPr>
          <a:xfrm>
            <a:off x="1975428" y="2341129"/>
            <a:ext cx="2561295" cy="2286000"/>
          </a:xfrm>
          <a:prstGeom prst="rect">
            <a:avLst/>
          </a:prstGeom>
        </p:spPr>
      </p:pic>
      <p:sp>
        <p:nvSpPr>
          <p:cNvPr id="6" name="矩形 5">
            <a:extLst>
              <a:ext uri="{FF2B5EF4-FFF2-40B4-BE49-F238E27FC236}">
                <a16:creationId xmlns:a16="http://schemas.microsoft.com/office/drawing/2014/main" id="{D7B9413C-74CA-464E-BB8F-648F6C0D1664}"/>
              </a:ext>
            </a:extLst>
          </p:cNvPr>
          <p:cNvSpPr/>
          <p:nvPr/>
        </p:nvSpPr>
        <p:spPr>
          <a:xfrm>
            <a:off x="454471" y="1573834"/>
            <a:ext cx="6137746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zh-CN" sz="1800" b="1" dirty="0">
                <a:latin typeface="Arial" panose="020B0604020202020204" pitchFamily="34" charset="0"/>
                <a:cs typeface="Arial" panose="020B0604020202020204" pitchFamily="34" charset="0"/>
              </a:rPr>
              <a:t>(A) </a:t>
            </a:r>
            <a:r>
              <a:rPr lang="en-GB" altLang="zh-CN" i="1" kern="100" dirty="0">
                <a:latin typeface="Arial" panose="020B0604020202020204" pitchFamily="34" charset="0"/>
                <a:cs typeface="Times New Roman" panose="02020603050405020304" pitchFamily="18" charset="0"/>
              </a:rPr>
              <a:t>The t-distributed stochastic neighbourhood embedding (</a:t>
            </a:r>
            <a:r>
              <a:rPr lang="en-US" altLang="zh-CN" i="1" kern="100" dirty="0">
                <a:latin typeface="Arial" panose="020B0604020202020204" pitchFamily="34" charset="0"/>
                <a:cs typeface="Times New Roman" panose="02020603050405020304" pitchFamily="18" charset="0"/>
              </a:rPr>
              <a:t>t-SNE</a:t>
            </a:r>
            <a:r>
              <a:rPr lang="en-GB" altLang="zh-CN" i="1" kern="100" dirty="0">
                <a:latin typeface="Arial" panose="020B0604020202020204" pitchFamily="34" charset="0"/>
                <a:cs typeface="Times New Roman" panose="02020603050405020304" pitchFamily="18" charset="0"/>
              </a:rPr>
              <a:t>) plot of expanded T cells.</a:t>
            </a:r>
            <a:endParaRPr lang="zh-CN" altLang="zh-CN" i="1" kern="100" dirty="0">
              <a:latin typeface="Arial" panose="020B0604020202020204" pitchFamily="34" charset="0"/>
              <a:cs typeface="Times New Roman" panose="02020603050405020304" pitchFamily="18" charset="0"/>
            </a:endParaRPr>
          </a:p>
        </p:txBody>
      </p:sp>
      <p:sp>
        <p:nvSpPr>
          <p:cNvPr id="8" name="标题 1">
            <a:extLst>
              <a:ext uri="{FF2B5EF4-FFF2-40B4-BE49-F238E27FC236}">
                <a16:creationId xmlns:a16="http://schemas.microsoft.com/office/drawing/2014/main" id="{05B0F1FD-D170-4D7B-8280-03E9121D1C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399317"/>
            <a:ext cx="6226492" cy="529598"/>
          </a:xfrm>
        </p:spPr>
        <p:txBody>
          <a:bodyPr>
            <a:normAutofit/>
          </a:bodyPr>
          <a:lstStyle/>
          <a:p>
            <a:pPr>
              <a:lnSpc>
                <a:spcPct val="100000"/>
              </a:lnSpc>
            </a:pPr>
            <a:r>
              <a:rPr lang="en-US" altLang="zh-CN" sz="2800" b="1" kern="100" dirty="0">
                <a:latin typeface="Arial" panose="020B0604020202020204" pitchFamily="34" charset="0"/>
                <a:cs typeface="Times New Roman" panose="02020603050405020304" pitchFamily="18" charset="0"/>
              </a:rPr>
              <a:t>Extended data for Figure 7. </a:t>
            </a:r>
            <a:endParaRPr lang="zh-CN" altLang="en-US" sz="2800" dirty="0"/>
          </a:p>
        </p:txBody>
      </p:sp>
      <p:pic>
        <p:nvPicPr>
          <p:cNvPr id="9" name="图片 4">
            <a:extLst>
              <a:ext uri="{FF2B5EF4-FFF2-40B4-BE49-F238E27FC236}">
                <a16:creationId xmlns:a16="http://schemas.microsoft.com/office/drawing/2014/main" id="{A70E8168-7459-43F1-B1ED-8823C975BA6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7243" t="12320" r="31112" b="16728"/>
          <a:stretch/>
        </p:blipFill>
        <p:spPr>
          <a:xfrm>
            <a:off x="1921192" y="4702162"/>
            <a:ext cx="2778962" cy="2286000"/>
          </a:xfrm>
          <a:prstGeom prst="rect">
            <a:avLst/>
          </a:prstGeom>
        </p:spPr>
      </p:pic>
      <p:pic>
        <p:nvPicPr>
          <p:cNvPr id="10" name="图片 4">
            <a:extLst>
              <a:ext uri="{FF2B5EF4-FFF2-40B4-BE49-F238E27FC236}">
                <a16:creationId xmlns:a16="http://schemas.microsoft.com/office/drawing/2014/main" id="{68F2F066-1E6B-4C5C-898D-380B249E1A1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68355" t="11248" b="11166"/>
          <a:stretch/>
        </p:blipFill>
        <p:spPr>
          <a:xfrm>
            <a:off x="2039996" y="7064250"/>
            <a:ext cx="2541353" cy="2286000"/>
          </a:xfrm>
          <a:prstGeom prst="rect">
            <a:avLst/>
          </a:prstGeom>
        </p:spPr>
      </p:pic>
      <p:cxnSp>
        <p:nvCxnSpPr>
          <p:cNvPr id="3" name="Straight Arrow Connector 2">
            <a:extLst>
              <a:ext uri="{FF2B5EF4-FFF2-40B4-BE49-F238E27FC236}">
                <a16:creationId xmlns:a16="http://schemas.microsoft.com/office/drawing/2014/main" id="{09118AF4-03F0-4897-9ACB-3E95A45ABC1F}"/>
              </a:ext>
            </a:extLst>
          </p:cNvPr>
          <p:cNvCxnSpPr/>
          <p:nvPr/>
        </p:nvCxnSpPr>
        <p:spPr>
          <a:xfrm flipV="1">
            <a:off x="1744595" y="2958612"/>
            <a:ext cx="0" cy="6400800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DAFB637B-6A35-40B9-84FE-28152E7B7A12}"/>
              </a:ext>
            </a:extLst>
          </p:cNvPr>
          <p:cNvSpPr txBox="1"/>
          <p:nvPr/>
        </p:nvSpPr>
        <p:spPr>
          <a:xfrm rot="10800000">
            <a:off x="1282930" y="5774102"/>
            <a:ext cx="461665" cy="706284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dirty="0" err="1"/>
              <a:t>tSNE</a:t>
            </a:r>
            <a:r>
              <a:rPr lang="en-US" dirty="0"/>
              <a:t> 2</a:t>
            </a:r>
          </a:p>
        </p:txBody>
      </p: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B05BE382-E8C3-4408-88F1-E285E7DE9058}"/>
              </a:ext>
            </a:extLst>
          </p:cNvPr>
          <p:cNvCxnSpPr/>
          <p:nvPr/>
        </p:nvCxnSpPr>
        <p:spPr>
          <a:xfrm>
            <a:off x="1770716" y="9359412"/>
            <a:ext cx="2926080" cy="0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982847DB-761F-43F3-A684-17C526229793}"/>
              </a:ext>
            </a:extLst>
          </p:cNvPr>
          <p:cNvSpPr txBox="1"/>
          <p:nvPr/>
        </p:nvSpPr>
        <p:spPr>
          <a:xfrm>
            <a:off x="2724727" y="9359412"/>
            <a:ext cx="7986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tSNE</a:t>
            </a:r>
            <a:r>
              <a:rPr lang="en-US" dirty="0"/>
              <a:t> 1</a:t>
            </a:r>
          </a:p>
        </p:txBody>
      </p:sp>
    </p:spTree>
    <p:extLst>
      <p:ext uri="{BB962C8B-B14F-4D97-AF65-F5344CB8AC3E}">
        <p14:creationId xmlns:p14="http://schemas.microsoft.com/office/powerpoint/2010/main" val="2882435515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BF1E4021-2525-46D1-AA2E-9E005E03642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8526" y="1632249"/>
            <a:ext cx="2700000" cy="1800000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0E66C1CA-0285-4785-BEF1-04F64927118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36274" y="1713250"/>
            <a:ext cx="2314617" cy="1800000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DEFAD34B-3800-4850-9EA6-C5251BB5A3C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0352" y="3232375"/>
            <a:ext cx="2430243" cy="2700000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096B2D58-71A4-4167-906E-D6B80F5D2585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76034" y="3513250"/>
            <a:ext cx="2648269" cy="2118615"/>
          </a:xfrm>
          <a:prstGeom prst="rect">
            <a:avLst/>
          </a:prstGeom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5213B82E-48B5-405C-9509-6C4B523F73C3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0352" y="6013376"/>
            <a:ext cx="2880000" cy="2880000"/>
          </a:xfrm>
          <a:prstGeom prst="rect">
            <a:avLst/>
          </a:pr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A3233FB8-89A9-4B82-8F16-659C0E869357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77934" y="6013376"/>
            <a:ext cx="2880000" cy="2880000"/>
          </a:xfrm>
          <a:prstGeom prst="rect">
            <a:avLst/>
          </a:prstGeom>
        </p:spPr>
      </p:pic>
      <p:sp>
        <p:nvSpPr>
          <p:cNvPr id="11" name="矩形 10">
            <a:extLst>
              <a:ext uri="{FF2B5EF4-FFF2-40B4-BE49-F238E27FC236}">
                <a16:creationId xmlns:a16="http://schemas.microsoft.com/office/drawing/2014/main" id="{9FE102CF-EF5E-4DDB-935B-D44511C27B57}"/>
              </a:ext>
            </a:extLst>
          </p:cNvPr>
          <p:cNvSpPr/>
          <p:nvPr/>
        </p:nvSpPr>
        <p:spPr>
          <a:xfrm>
            <a:off x="254396" y="509021"/>
            <a:ext cx="6447075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zh-CN" sz="1800" b="1" dirty="0">
                <a:latin typeface="Arial" panose="020B0604020202020204" pitchFamily="34" charset="0"/>
                <a:cs typeface="Arial" panose="020B0604020202020204" pitchFamily="34" charset="0"/>
              </a:rPr>
              <a:t>(B)  </a:t>
            </a:r>
            <a:r>
              <a:rPr lang="en-US" altLang="zh-CN" i="1" kern="100" dirty="0">
                <a:latin typeface="Arial" panose="020B0604020202020204" pitchFamily="34" charset="0"/>
                <a:cs typeface="Times New Roman" panose="02020603050405020304" pitchFamily="18" charset="0"/>
              </a:rPr>
              <a:t>Comparison between </a:t>
            </a:r>
            <a:r>
              <a:rPr lang="en-US" altLang="zh-CN" i="1" kern="100" dirty="0" err="1">
                <a:latin typeface="Arial" panose="020B0604020202020204" pitchFamily="34" charset="0"/>
                <a:cs typeface="Times New Roman" panose="02020603050405020304" pitchFamily="18" charset="0"/>
              </a:rPr>
              <a:t>γδ</a:t>
            </a:r>
            <a:r>
              <a:rPr lang="en-US" altLang="zh-CN" i="1" kern="100" dirty="0">
                <a:latin typeface="Arial" panose="020B0604020202020204" pitchFamily="34" charset="0"/>
                <a:cs typeface="Times New Roman" panose="02020603050405020304" pitchFamily="18" charset="0"/>
              </a:rPr>
              <a:t> T cells from healthy donor PBMC and HCC patient PBMC, including </a:t>
            </a:r>
            <a:r>
              <a:rPr lang="en-US" altLang="zh-CN" i="1" kern="100" dirty="0" err="1">
                <a:latin typeface="Arial" panose="020B0604020202020204" pitchFamily="34" charset="0"/>
                <a:cs typeface="Times New Roman" panose="02020603050405020304" pitchFamily="18" charset="0"/>
              </a:rPr>
              <a:t>γδ</a:t>
            </a:r>
            <a:r>
              <a:rPr lang="en-US" altLang="zh-CN" i="1" kern="100" dirty="0">
                <a:latin typeface="Arial" panose="020B0604020202020204" pitchFamily="34" charset="0"/>
                <a:cs typeface="Times New Roman" panose="02020603050405020304" pitchFamily="18" charset="0"/>
              </a:rPr>
              <a:t> TCRs, major metabolic pathways, GSVA cytotoxic scores, and gene expression levels of inhibitory molecules. </a:t>
            </a:r>
            <a:endParaRPr lang="zh-CN" altLang="zh-CN" i="1" kern="100" dirty="0">
              <a:latin typeface="Arial" panose="020B060402020202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03018646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图片 17">
            <a:extLst>
              <a:ext uri="{FF2B5EF4-FFF2-40B4-BE49-F238E27FC236}">
                <a16:creationId xmlns:a16="http://schemas.microsoft.com/office/drawing/2014/main" id="{4C2B8912-E8A1-4217-A81B-BC7E28F07AC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3603" y="1798170"/>
            <a:ext cx="5400000" cy="5400000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F02D579F-A3BC-49C8-8848-19C1F28AAFB1}"/>
              </a:ext>
            </a:extLst>
          </p:cNvPr>
          <p:cNvSpPr txBox="1"/>
          <p:nvPr/>
        </p:nvSpPr>
        <p:spPr>
          <a:xfrm>
            <a:off x="342900" y="635000"/>
            <a:ext cx="6111688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dirty="0">
                <a:latin typeface="Arial" panose="020B0604020202020204" pitchFamily="34" charset="0"/>
                <a:cs typeface="Arial" panose="020B0604020202020204" pitchFamily="34" charset="0"/>
              </a:rPr>
              <a:t>(C) </a:t>
            </a:r>
            <a:r>
              <a:rPr lang="en-US" altLang="zh-CN" sz="1800" i="1" dirty="0">
                <a:latin typeface="Arial" panose="020B0604020202020204" pitchFamily="34" charset="0"/>
                <a:cs typeface="Arial" panose="020B0604020202020204" pitchFamily="34" charset="0"/>
              </a:rPr>
              <a:t>Violin plots. Expressions of inhibitory molecules, including PD1, LAG3, TIM3, and CTLA4, on </a:t>
            </a:r>
            <a:r>
              <a:rPr lang="en-US" altLang="zh-CN" i="1" kern="100" dirty="0" err="1">
                <a:latin typeface="Arial" panose="020B0604020202020204" pitchFamily="34" charset="0"/>
                <a:cs typeface="Times New Roman" panose="02020603050405020304" pitchFamily="18" charset="0"/>
              </a:rPr>
              <a:t>γδ</a:t>
            </a:r>
            <a:r>
              <a:rPr lang="en-US" altLang="zh-CN" i="1" kern="100" dirty="0">
                <a:latin typeface="Arial" panose="020B0604020202020204" pitchFamily="34" charset="0"/>
                <a:cs typeface="Times New Roman" panose="02020603050405020304" pitchFamily="18" charset="0"/>
              </a:rPr>
              <a:t> T cells of HCC TME, healthy PBMC, and patient PBMC.</a:t>
            </a:r>
            <a:endParaRPr lang="zh-CN" altLang="en-US" i="1" dirty="0"/>
          </a:p>
        </p:txBody>
      </p:sp>
    </p:spTree>
    <p:extLst>
      <p:ext uri="{BB962C8B-B14F-4D97-AF65-F5344CB8AC3E}">
        <p14:creationId xmlns:p14="http://schemas.microsoft.com/office/powerpoint/2010/main" val="393018305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3">
            <a:extLst>
              <a:ext uri="{FF2B5EF4-FFF2-40B4-BE49-F238E27FC236}">
                <a16:creationId xmlns:a16="http://schemas.microsoft.com/office/drawing/2014/main" id="{1AA3361E-A4F8-4522-8C94-0345F1668E9D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862" t="4266"/>
          <a:stretch/>
        </p:blipFill>
        <p:spPr>
          <a:xfrm>
            <a:off x="1110665" y="1799232"/>
            <a:ext cx="4279831" cy="2626168"/>
          </a:xfrm>
          <a:prstGeom prst="rect">
            <a:avLst/>
          </a:prstGeom>
        </p:spPr>
      </p:pic>
      <p:pic>
        <p:nvPicPr>
          <p:cNvPr id="9" name="Picture 4">
            <a:extLst>
              <a:ext uri="{FF2B5EF4-FFF2-40B4-BE49-F238E27FC236}">
                <a16:creationId xmlns:a16="http://schemas.microsoft.com/office/drawing/2014/main" id="{C672FCDA-FAAC-4CEE-B78C-BD9D4188F436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536" t="4266"/>
          <a:stretch/>
        </p:blipFill>
        <p:spPr>
          <a:xfrm>
            <a:off x="1110665" y="4373022"/>
            <a:ext cx="4294809" cy="2626168"/>
          </a:xfrm>
          <a:prstGeom prst="rect">
            <a:avLst/>
          </a:prstGeom>
        </p:spPr>
      </p:pic>
      <p:pic>
        <p:nvPicPr>
          <p:cNvPr id="10" name="Picture 5">
            <a:extLst>
              <a:ext uri="{FF2B5EF4-FFF2-40B4-BE49-F238E27FC236}">
                <a16:creationId xmlns:a16="http://schemas.microsoft.com/office/drawing/2014/main" id="{B7B27E1E-5141-40C1-A1D7-88A024370D37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11" t="4266"/>
          <a:stretch/>
        </p:blipFill>
        <p:spPr>
          <a:xfrm>
            <a:off x="1110665" y="6976522"/>
            <a:ext cx="4309743" cy="2626168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936FA1D3-5B45-40AB-A225-E4C97C912477}"/>
              </a:ext>
            </a:extLst>
          </p:cNvPr>
          <p:cNvSpPr txBox="1"/>
          <p:nvPr/>
        </p:nvSpPr>
        <p:spPr>
          <a:xfrm>
            <a:off x="204671" y="1220515"/>
            <a:ext cx="550984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i="1" kern="100" dirty="0">
                <a:latin typeface="Arial" panose="020B0604020202020204" pitchFamily="34" charset="0"/>
                <a:cs typeface="Times New Roman" panose="02020603050405020304" pitchFamily="18" charset="0"/>
              </a:rPr>
              <a:t>Major functional enrichment of all clusters (0-5)</a:t>
            </a:r>
            <a:endParaRPr lang="en-US" sz="2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F6676D08-B0B5-43AA-AC9C-2FA26D63DFDB}"/>
              </a:ext>
            </a:extLst>
          </p:cNvPr>
          <p:cNvSpPr txBox="1"/>
          <p:nvPr/>
        </p:nvSpPr>
        <p:spPr>
          <a:xfrm>
            <a:off x="5600700" y="2504082"/>
            <a:ext cx="95090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luster 0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583FAA93-F4B9-4A9C-AE9A-8D47776655D7}"/>
              </a:ext>
            </a:extLst>
          </p:cNvPr>
          <p:cNvSpPr txBox="1"/>
          <p:nvPr/>
        </p:nvSpPr>
        <p:spPr>
          <a:xfrm>
            <a:off x="5600700" y="5342532"/>
            <a:ext cx="95090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luster 1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A5235B9F-B0BD-4D4A-A6D2-6E525593F67C}"/>
              </a:ext>
            </a:extLst>
          </p:cNvPr>
          <p:cNvSpPr txBox="1"/>
          <p:nvPr/>
        </p:nvSpPr>
        <p:spPr>
          <a:xfrm>
            <a:off x="5600700" y="8027093"/>
            <a:ext cx="95090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luster 2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标题 1">
            <a:extLst>
              <a:ext uri="{FF2B5EF4-FFF2-40B4-BE49-F238E27FC236}">
                <a16:creationId xmlns:a16="http://schemas.microsoft.com/office/drawing/2014/main" id="{011FF37A-3DC0-4001-88A2-750165559D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399317"/>
            <a:ext cx="6226492" cy="529598"/>
          </a:xfrm>
        </p:spPr>
        <p:txBody>
          <a:bodyPr>
            <a:normAutofit/>
          </a:bodyPr>
          <a:lstStyle/>
          <a:p>
            <a:pPr>
              <a:lnSpc>
                <a:spcPct val="100000"/>
              </a:lnSpc>
            </a:pPr>
            <a:r>
              <a:rPr lang="en-US" altLang="zh-CN" sz="2800" b="1" kern="100" dirty="0">
                <a:latin typeface="Arial" panose="020B0604020202020204" pitchFamily="34" charset="0"/>
                <a:cs typeface="Times New Roman" panose="02020603050405020304" pitchFamily="18" charset="0"/>
              </a:rPr>
              <a:t>Extended data for Figure 1. </a:t>
            </a:r>
            <a:endParaRPr lang="zh-CN" altLang="en-US" sz="2800" dirty="0"/>
          </a:p>
        </p:txBody>
      </p:sp>
    </p:spTree>
    <p:extLst>
      <p:ext uri="{BB962C8B-B14F-4D97-AF65-F5344CB8AC3E}">
        <p14:creationId xmlns:p14="http://schemas.microsoft.com/office/powerpoint/2010/main" val="412765619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8">
            <a:extLst>
              <a:ext uri="{FF2B5EF4-FFF2-40B4-BE49-F238E27FC236}">
                <a16:creationId xmlns:a16="http://schemas.microsoft.com/office/drawing/2014/main" id="{B614A086-D9CE-40F1-A52D-BAE159F74BFB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07" t="4227"/>
          <a:stretch/>
        </p:blipFill>
        <p:spPr>
          <a:xfrm>
            <a:off x="941070" y="1346834"/>
            <a:ext cx="4320000" cy="2633388"/>
          </a:xfrm>
          <a:prstGeom prst="rect">
            <a:avLst/>
          </a:prstGeom>
        </p:spPr>
      </p:pic>
      <p:pic>
        <p:nvPicPr>
          <p:cNvPr id="12" name="Picture 10">
            <a:extLst>
              <a:ext uri="{FF2B5EF4-FFF2-40B4-BE49-F238E27FC236}">
                <a16:creationId xmlns:a16="http://schemas.microsoft.com/office/drawing/2014/main" id="{BBA10156-3E40-4D68-99E0-832A3C793077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227"/>
          <a:stretch/>
        </p:blipFill>
        <p:spPr>
          <a:xfrm>
            <a:off x="655850" y="3974083"/>
            <a:ext cx="4644000" cy="2655179"/>
          </a:xfrm>
          <a:prstGeom prst="rect">
            <a:avLst/>
          </a:prstGeom>
        </p:spPr>
      </p:pic>
      <p:sp>
        <p:nvSpPr>
          <p:cNvPr id="13" name="文本框 12">
            <a:extLst>
              <a:ext uri="{FF2B5EF4-FFF2-40B4-BE49-F238E27FC236}">
                <a16:creationId xmlns:a16="http://schemas.microsoft.com/office/drawing/2014/main" id="{49420599-CEE9-412D-AE2E-F6EAC3525F8A}"/>
              </a:ext>
            </a:extLst>
          </p:cNvPr>
          <p:cNvSpPr txBox="1"/>
          <p:nvPr/>
        </p:nvSpPr>
        <p:spPr>
          <a:xfrm>
            <a:off x="5372098" y="7695249"/>
            <a:ext cx="95090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4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dirty="0"/>
              <a:t>Cluster 5</a:t>
            </a:r>
            <a:endParaRPr lang="zh-CN" altLang="en-US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5020D69A-8B15-4992-BAB5-7587533C76B0}"/>
              </a:ext>
            </a:extLst>
          </p:cNvPr>
          <p:cNvSpPr txBox="1"/>
          <p:nvPr/>
        </p:nvSpPr>
        <p:spPr>
          <a:xfrm>
            <a:off x="5372100" y="2049781"/>
            <a:ext cx="95090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luster 3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D1E5EEB5-F810-4FE8-97C3-1864E2E616D8}"/>
              </a:ext>
            </a:extLst>
          </p:cNvPr>
          <p:cNvSpPr txBox="1"/>
          <p:nvPr/>
        </p:nvSpPr>
        <p:spPr>
          <a:xfrm>
            <a:off x="5372099" y="4773931"/>
            <a:ext cx="95090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luster 4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2AF651F2-01C5-46B5-AF3A-9430260F9800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697"/>
          <a:stretch/>
        </p:blipFill>
        <p:spPr>
          <a:xfrm>
            <a:off x="655850" y="6780848"/>
            <a:ext cx="4680000" cy="269056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9257002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标题 1">
            <a:extLst>
              <a:ext uri="{FF2B5EF4-FFF2-40B4-BE49-F238E27FC236}">
                <a16:creationId xmlns:a16="http://schemas.microsoft.com/office/drawing/2014/main" id="{5E2DBA6A-2697-445D-854B-C93C2C377AC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399317"/>
            <a:ext cx="6226492" cy="529598"/>
          </a:xfrm>
        </p:spPr>
        <p:txBody>
          <a:bodyPr>
            <a:normAutofit/>
          </a:bodyPr>
          <a:lstStyle/>
          <a:p>
            <a:pPr>
              <a:lnSpc>
                <a:spcPct val="100000"/>
              </a:lnSpc>
            </a:pPr>
            <a:r>
              <a:rPr lang="en-US" altLang="zh-CN" sz="2800" b="1" kern="100" dirty="0">
                <a:latin typeface="Arial" panose="020B0604020202020204" pitchFamily="34" charset="0"/>
                <a:cs typeface="Times New Roman" panose="02020603050405020304" pitchFamily="18" charset="0"/>
              </a:rPr>
              <a:t>Extended data for Figure 2. </a:t>
            </a:r>
            <a:endParaRPr lang="zh-CN" altLang="en-US" sz="2800" dirty="0"/>
          </a:p>
        </p:txBody>
      </p:sp>
      <p:graphicFrame>
        <p:nvGraphicFramePr>
          <p:cNvPr id="18" name="对象 17">
            <a:extLst>
              <a:ext uri="{FF2B5EF4-FFF2-40B4-BE49-F238E27FC236}">
                <a16:creationId xmlns:a16="http://schemas.microsoft.com/office/drawing/2014/main" id="{853C9307-2C7C-49FC-AAD2-3F690C04E35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47577880"/>
              </p:ext>
            </p:extLst>
          </p:nvPr>
        </p:nvGraphicFramePr>
        <p:xfrm>
          <a:off x="1754844" y="7112005"/>
          <a:ext cx="1684547" cy="198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2" name="Prism 9" r:id="rId3" imgW="2335480" imgH="2744374" progId="Prism9.Document">
                  <p:embed/>
                </p:oleObj>
              </mc:Choice>
              <mc:Fallback>
                <p:oleObj name="Prism 9" r:id="rId3" imgW="2335480" imgH="2744374" progId="Prism9.Document">
                  <p:embed/>
                  <p:pic>
                    <p:nvPicPr>
                      <p:cNvPr id="18" name="对象 17">
                        <a:extLst>
                          <a:ext uri="{FF2B5EF4-FFF2-40B4-BE49-F238E27FC236}">
                            <a16:creationId xmlns:a16="http://schemas.microsoft.com/office/drawing/2014/main" id="{853C9307-2C7C-49FC-AAD2-3F690C04E35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754844" y="7112005"/>
                        <a:ext cx="1684547" cy="198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9" name="对象 18">
            <a:extLst>
              <a:ext uri="{FF2B5EF4-FFF2-40B4-BE49-F238E27FC236}">
                <a16:creationId xmlns:a16="http://schemas.microsoft.com/office/drawing/2014/main" id="{C0334613-3127-4336-8020-BBD0350686F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95053027"/>
              </p:ext>
            </p:extLst>
          </p:nvPr>
        </p:nvGraphicFramePr>
        <p:xfrm>
          <a:off x="3335120" y="7112005"/>
          <a:ext cx="1684547" cy="198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3" name="Prism 9" r:id="rId5" imgW="2335480" imgH="2744374" progId="Prism9.Document">
                  <p:embed/>
                </p:oleObj>
              </mc:Choice>
              <mc:Fallback>
                <p:oleObj name="Prism 9" r:id="rId5" imgW="2335480" imgH="2744374" progId="Prism9.Document">
                  <p:embed/>
                  <p:pic>
                    <p:nvPicPr>
                      <p:cNvPr id="19" name="对象 18">
                        <a:extLst>
                          <a:ext uri="{FF2B5EF4-FFF2-40B4-BE49-F238E27FC236}">
                            <a16:creationId xmlns:a16="http://schemas.microsoft.com/office/drawing/2014/main" id="{C0334613-3127-4336-8020-BBD0350686F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335120" y="7112005"/>
                        <a:ext cx="1684547" cy="198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1" name="TextBox 13">
            <a:extLst>
              <a:ext uri="{FF2B5EF4-FFF2-40B4-BE49-F238E27FC236}">
                <a16:creationId xmlns:a16="http://schemas.microsoft.com/office/drawing/2014/main" id="{75FB851A-3DFB-434E-BC3A-3197BF89820E}"/>
              </a:ext>
            </a:extLst>
          </p:cNvPr>
          <p:cNvSpPr txBox="1"/>
          <p:nvPr/>
        </p:nvSpPr>
        <p:spPr>
          <a:xfrm>
            <a:off x="1153862" y="7146660"/>
            <a:ext cx="48307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3">
            <a:extLst>
              <a:ext uri="{FF2B5EF4-FFF2-40B4-BE49-F238E27FC236}">
                <a16:creationId xmlns:a16="http://schemas.microsoft.com/office/drawing/2014/main" id="{50DC8C26-F429-4FE4-A938-427636CD61DE}"/>
              </a:ext>
            </a:extLst>
          </p:cNvPr>
          <p:cNvSpPr txBox="1"/>
          <p:nvPr/>
        </p:nvSpPr>
        <p:spPr>
          <a:xfrm>
            <a:off x="221874" y="6348328"/>
            <a:ext cx="62264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i="1" dirty="0">
                <a:latin typeface="Arial" panose="020B0604020202020204" pitchFamily="34" charset="0"/>
              </a:rPr>
              <a:t>Cell counts obtained using confocal microscope imaging</a:t>
            </a:r>
            <a:r>
              <a:rPr lang="zh-CN" altLang="en-US" dirty="0">
                <a:latin typeface="Arial" panose="020B0604020202020204" pitchFamily="34" charset="0"/>
              </a:rPr>
              <a:t>：</a:t>
            </a:r>
            <a:endParaRPr lang="zh-CN" altLang="en-US" dirty="0"/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AECA29EB-CAF3-490B-946F-9FE327F1D0E9}"/>
              </a:ext>
            </a:extLst>
          </p:cNvPr>
          <p:cNvSpPr txBox="1"/>
          <p:nvPr/>
        </p:nvSpPr>
        <p:spPr>
          <a:xfrm>
            <a:off x="93518" y="1267691"/>
            <a:ext cx="6354848" cy="418576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GB" altLang="zh-CN" sz="1400" i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Peripheral blood analysis of peripheral blood mononuclear cells of clinical samples</a:t>
            </a:r>
            <a:endParaRPr lang="zh-CN" altLang="zh-CN" sz="14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Arial" panose="020B0604020202020204" pitchFamily="34" charset="0"/>
            </a:endParaRPr>
          </a:p>
          <a:p>
            <a:pPr algn="just">
              <a:lnSpc>
                <a:spcPct val="150000"/>
              </a:lnSpc>
            </a:pPr>
            <a:r>
              <a:rPr lang="en-GB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(A) Counts of Vδ1 and Vδ2 T cells in hepatocellular carcinoma (HCC) tumour tissue and peri-tumour tissue. Manual counting was performed in eight different optical views (63X OIL) using the Leica SP8 confocal microscope. </a:t>
            </a:r>
            <a:endParaRPr lang="zh-CN" altLang="zh-CN" sz="14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Arial" panose="020B0604020202020204" pitchFamily="34" charset="0"/>
            </a:endParaRPr>
          </a:p>
          <a:p>
            <a:pPr algn="just">
              <a:lnSpc>
                <a:spcPct val="150000"/>
              </a:lnSpc>
            </a:pPr>
            <a:r>
              <a:rPr lang="en-GB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(B) Relative percentages of peripheral </a:t>
            </a:r>
            <a:r>
              <a:rPr lang="en-GB" altLang="zh-CN" sz="1400" kern="10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γδ</a:t>
            </a:r>
            <a:r>
              <a:rPr lang="en-GB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T cells, the Vδ1 subset, and the Vδ2 subset, as well as the alterations in the Vδ2/Vδ1 ratio in healthy and liver cancer populations. </a:t>
            </a:r>
            <a:endParaRPr lang="zh-CN" altLang="zh-CN" sz="14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Arial" panose="020B0604020202020204" pitchFamily="34" charset="0"/>
            </a:endParaRPr>
          </a:p>
          <a:p>
            <a:pPr algn="just">
              <a:lnSpc>
                <a:spcPct val="150000"/>
              </a:lnSpc>
            </a:pPr>
            <a:r>
              <a:rPr lang="en-GB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(C) Both peripheral cytotoxic (Th1-like) and regulatory (Th2-like) </a:t>
            </a:r>
            <a:r>
              <a:rPr lang="en-GB" altLang="zh-CN" sz="1400" kern="10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γδ</a:t>
            </a:r>
            <a:r>
              <a:rPr lang="en-GB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T cell populations decreased in HCC patients. However, inflammatory </a:t>
            </a:r>
            <a:r>
              <a:rPr lang="en-GB" altLang="zh-CN" sz="1400" kern="10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γδ</a:t>
            </a:r>
            <a:r>
              <a:rPr lang="en-GB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T cells showed no statistical difference.</a:t>
            </a:r>
            <a:endParaRPr lang="zh-CN" altLang="zh-CN" sz="14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Arial" panose="020B0604020202020204" pitchFamily="34" charset="0"/>
            </a:endParaRPr>
          </a:p>
          <a:p>
            <a:pPr algn="just">
              <a:lnSpc>
                <a:spcPct val="150000"/>
              </a:lnSpc>
            </a:pPr>
            <a:r>
              <a:rPr lang="en-GB" altLang="zh-CN" sz="14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ns, no significance; * P&lt;0.05; ** P&lt;0.01; *** P&lt;0.001; **** P&lt;0.0001.</a:t>
            </a:r>
            <a:endParaRPr lang="zh-CN" altLang="zh-CN" sz="14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Arial" panose="020B0604020202020204" pitchFamily="34" charset="0"/>
            </a:endParaRPr>
          </a:p>
          <a:p>
            <a:endParaRPr lang="zh-CN" altLang="en-US" sz="1400" dirty="0"/>
          </a:p>
        </p:txBody>
      </p:sp>
    </p:spTree>
    <p:extLst>
      <p:ext uri="{BB962C8B-B14F-4D97-AF65-F5344CB8AC3E}">
        <p14:creationId xmlns:p14="http://schemas.microsoft.com/office/powerpoint/2010/main" val="185245323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对象 2">
            <a:extLst>
              <a:ext uri="{FF2B5EF4-FFF2-40B4-BE49-F238E27FC236}">
                <a16:creationId xmlns:a16="http://schemas.microsoft.com/office/drawing/2014/main" id="{E33A36ED-7717-4CC0-90FA-C2DBD66D98D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82022114"/>
              </p:ext>
            </p:extLst>
          </p:nvPr>
        </p:nvGraphicFramePr>
        <p:xfrm>
          <a:off x="979488" y="4010025"/>
          <a:ext cx="2527300" cy="2006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14" name="Prism 9" r:id="rId3" imgW="3178918" imgH="2524680" progId="Prism9.Document">
                  <p:embed/>
                </p:oleObj>
              </mc:Choice>
              <mc:Fallback>
                <p:oleObj name="Prism 9" r:id="rId3" imgW="3178918" imgH="2524680" progId="Prism9.Document">
                  <p:embed/>
                  <p:pic>
                    <p:nvPicPr>
                      <p:cNvPr id="3" name="对象 2">
                        <a:extLst>
                          <a:ext uri="{FF2B5EF4-FFF2-40B4-BE49-F238E27FC236}">
                            <a16:creationId xmlns:a16="http://schemas.microsoft.com/office/drawing/2014/main" id="{E33A36ED-7717-4CC0-90FA-C2DBD66D98D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979488" y="4010025"/>
                        <a:ext cx="2527300" cy="2006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对象 8">
            <a:extLst>
              <a:ext uri="{FF2B5EF4-FFF2-40B4-BE49-F238E27FC236}">
                <a16:creationId xmlns:a16="http://schemas.microsoft.com/office/drawing/2014/main" id="{5CD7DE07-1C36-45AF-ADDB-F2DDD3D6104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31185261"/>
              </p:ext>
            </p:extLst>
          </p:nvPr>
        </p:nvGraphicFramePr>
        <p:xfrm>
          <a:off x="3352179" y="4025900"/>
          <a:ext cx="2649537" cy="20018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15" name="Prism 9" r:id="rId5" imgW="3238340" imgH="2448687" progId="Prism9.Document">
                  <p:embed/>
                </p:oleObj>
              </mc:Choice>
              <mc:Fallback>
                <p:oleObj name="Prism 9" r:id="rId5" imgW="3238340" imgH="2448687" progId="Prism9.Document">
                  <p:embed/>
                  <p:pic>
                    <p:nvPicPr>
                      <p:cNvPr id="9" name="对象 8">
                        <a:extLst>
                          <a:ext uri="{FF2B5EF4-FFF2-40B4-BE49-F238E27FC236}">
                            <a16:creationId xmlns:a16="http://schemas.microsoft.com/office/drawing/2014/main" id="{5CD7DE07-1C36-45AF-ADDB-F2DDD3D6104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352179" y="4025900"/>
                        <a:ext cx="2649537" cy="20018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3" name="对象 22">
            <a:extLst>
              <a:ext uri="{FF2B5EF4-FFF2-40B4-BE49-F238E27FC236}">
                <a16:creationId xmlns:a16="http://schemas.microsoft.com/office/drawing/2014/main" id="{5EEE791A-E255-4196-9141-8116471CEA5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51667624"/>
              </p:ext>
            </p:extLst>
          </p:nvPr>
        </p:nvGraphicFramePr>
        <p:xfrm>
          <a:off x="915988" y="6044579"/>
          <a:ext cx="2654300" cy="20034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16" name="Prism 9" r:id="rId7" imgW="3242662" imgH="2448687" progId="Prism9.Document">
                  <p:embed/>
                </p:oleObj>
              </mc:Choice>
              <mc:Fallback>
                <p:oleObj name="Prism 9" r:id="rId7" imgW="3242662" imgH="2448687" progId="Prism9.Document">
                  <p:embed/>
                  <p:pic>
                    <p:nvPicPr>
                      <p:cNvPr id="23" name="对象 22">
                        <a:extLst>
                          <a:ext uri="{FF2B5EF4-FFF2-40B4-BE49-F238E27FC236}">
                            <a16:creationId xmlns:a16="http://schemas.microsoft.com/office/drawing/2014/main" id="{5EEE791A-E255-4196-9141-8116471CEA5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915988" y="6044579"/>
                        <a:ext cx="2654300" cy="20034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4" name="对象 23">
            <a:extLst>
              <a:ext uri="{FF2B5EF4-FFF2-40B4-BE49-F238E27FC236}">
                <a16:creationId xmlns:a16="http://schemas.microsoft.com/office/drawing/2014/main" id="{4B263A78-133C-41B2-B763-6CD097A92E0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26093910"/>
              </p:ext>
            </p:extLst>
          </p:nvPr>
        </p:nvGraphicFramePr>
        <p:xfrm>
          <a:off x="3382341" y="6044579"/>
          <a:ext cx="2560638" cy="20034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17" name="Prism 9" r:id="rId9" imgW="3128499" imgH="2448687" progId="Prism9.Document">
                  <p:embed/>
                </p:oleObj>
              </mc:Choice>
              <mc:Fallback>
                <p:oleObj name="Prism 9" r:id="rId9" imgW="3128499" imgH="2448687" progId="Prism9.Document">
                  <p:embed/>
                  <p:pic>
                    <p:nvPicPr>
                      <p:cNvPr id="24" name="对象 23">
                        <a:extLst>
                          <a:ext uri="{FF2B5EF4-FFF2-40B4-BE49-F238E27FC236}">
                            <a16:creationId xmlns:a16="http://schemas.microsoft.com/office/drawing/2014/main" id="{4B263A78-133C-41B2-B763-6CD097A92E0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3382341" y="6044579"/>
                        <a:ext cx="2560638" cy="20034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A4B57805-CDFD-4943-8F27-B65F2C07FFD8}"/>
              </a:ext>
            </a:extLst>
          </p:cNvPr>
          <p:cNvSpPr txBox="1"/>
          <p:nvPr/>
        </p:nvSpPr>
        <p:spPr>
          <a:xfrm>
            <a:off x="677555" y="3962126"/>
            <a:ext cx="54053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3">
            <a:extLst>
              <a:ext uri="{FF2B5EF4-FFF2-40B4-BE49-F238E27FC236}">
                <a16:creationId xmlns:a16="http://schemas.microsoft.com/office/drawing/2014/main" id="{3DE419F7-9CD6-4116-A2E0-49DBDA0E3C6C}"/>
              </a:ext>
            </a:extLst>
          </p:cNvPr>
          <p:cNvSpPr txBox="1"/>
          <p:nvPr/>
        </p:nvSpPr>
        <p:spPr>
          <a:xfrm>
            <a:off x="138910" y="779704"/>
            <a:ext cx="6656139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i="1" dirty="0">
                <a:latin typeface="Arial" panose="020B0604020202020204" pitchFamily="34" charset="0"/>
              </a:rPr>
              <a:t>Peripheral </a:t>
            </a:r>
            <a:r>
              <a:rPr lang="en-US" altLang="zh-CN" i="1" dirty="0">
                <a:latin typeface="Arial" panose="020B0604020202020204" pitchFamily="34" charset="0"/>
                <a:sym typeface="Symbol" panose="05050102010706020507" pitchFamily="18" charset="2"/>
              </a:rPr>
              <a:t></a:t>
            </a:r>
            <a:r>
              <a:rPr lang="el-GR" altLang="zh-CN" i="1" dirty="0">
                <a:latin typeface="Arial" panose="020B0604020202020204" pitchFamily="34" charset="0"/>
                <a:sym typeface="Symbol" panose="05050102010706020507" pitchFamily="18" charset="2"/>
              </a:rPr>
              <a:t>δ</a:t>
            </a:r>
            <a:r>
              <a:rPr lang="en-US" altLang="zh-CN" i="1" dirty="0">
                <a:latin typeface="Arial" panose="020B0604020202020204" pitchFamily="34" charset="0"/>
                <a:sym typeface="Symbol" panose="05050102010706020507" pitchFamily="18" charset="2"/>
              </a:rPr>
              <a:t> T</a:t>
            </a:r>
            <a:r>
              <a:rPr lang="en-US" altLang="zh-CN" i="1" dirty="0">
                <a:latin typeface="Arial" panose="020B0604020202020204" pitchFamily="34" charset="0"/>
              </a:rPr>
              <a:t> cell analysis on PBMCs of clinical samples. </a:t>
            </a:r>
          </a:p>
          <a:p>
            <a:r>
              <a:rPr lang="en-US" altLang="zh-CN" i="1" dirty="0">
                <a:latin typeface="Arial" panose="020B0604020202020204" pitchFamily="34" charset="0"/>
              </a:rPr>
              <a:t>The data were from the database of </a:t>
            </a:r>
            <a:r>
              <a:rPr lang="en-GB" altLang="zh-CN" i="1" dirty="0">
                <a:latin typeface="Arial" panose="020B0604020202020204" pitchFamily="34" charset="0"/>
              </a:rPr>
              <a:t>the </a:t>
            </a:r>
            <a:r>
              <a:rPr lang="en-GB" altLang="zh-CN" i="1" dirty="0" err="1">
                <a:latin typeface="Arial" panose="020B0604020202020204" pitchFamily="34" charset="0"/>
              </a:rPr>
              <a:t>Shuangzhi</a:t>
            </a:r>
            <a:r>
              <a:rPr lang="en-GB" altLang="zh-CN" i="1" dirty="0">
                <a:latin typeface="Arial" panose="020B0604020202020204" pitchFamily="34" charset="0"/>
              </a:rPr>
              <a:t> </a:t>
            </a:r>
            <a:r>
              <a:rPr lang="en-GB" altLang="zh-CN" i="1" dirty="0" err="1">
                <a:latin typeface="Arial" panose="020B0604020202020204" pitchFamily="34" charset="0"/>
              </a:rPr>
              <a:t>Purui</a:t>
            </a:r>
            <a:r>
              <a:rPr lang="en-GB" altLang="zh-CN" i="1" dirty="0">
                <a:latin typeface="Arial" panose="020B0604020202020204" pitchFamily="34" charset="0"/>
              </a:rPr>
              <a:t> Medical Laboratory Co Ltd (Wuhan, China). The data set were from </a:t>
            </a:r>
            <a:r>
              <a:rPr lang="en-US" altLang="zh-CN" i="1" dirty="0">
                <a:latin typeface="Arial" panose="020B0604020202020204" pitchFamily="34" charset="0"/>
              </a:rPr>
              <a:t>54 healthy donors and 20 HCC patients (the basic clinical information of these 20 HCC patients is included in the </a:t>
            </a:r>
            <a:r>
              <a:rPr lang="en-US" altLang="zh-CN" sz="1800" i="1" kern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</a:rPr>
              <a:t>file ‘Supplemental Methods’ </a:t>
            </a:r>
            <a:r>
              <a:rPr lang="en-US" altLang="zh-CN" i="1" dirty="0">
                <a:latin typeface="Arial" panose="020B0604020202020204" pitchFamily="34" charset="0"/>
              </a:rPr>
              <a:t>). </a:t>
            </a:r>
            <a:endParaRPr lang="zh-CN" altLang="en-US" i="1" dirty="0"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2732314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对象 3">
            <a:extLst>
              <a:ext uri="{FF2B5EF4-FFF2-40B4-BE49-F238E27FC236}">
                <a16:creationId xmlns:a16="http://schemas.microsoft.com/office/drawing/2014/main" id="{24432AD0-BE0B-4C69-AC4A-C0C6492BB3D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06665599"/>
              </p:ext>
            </p:extLst>
          </p:nvPr>
        </p:nvGraphicFramePr>
        <p:xfrm>
          <a:off x="681038" y="3862388"/>
          <a:ext cx="2341562" cy="1981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49" name="Prism 9" r:id="rId3" imgW="3316130" imgH="2973072" progId="Prism9.Document">
                  <p:embed/>
                </p:oleObj>
              </mc:Choice>
              <mc:Fallback>
                <p:oleObj name="Prism 9" r:id="rId3" imgW="3316130" imgH="2973072" progId="Prism9.Document">
                  <p:embed/>
                  <p:pic>
                    <p:nvPicPr>
                      <p:cNvPr id="12" name="对象 11">
                        <a:extLst>
                          <a:ext uri="{FF2B5EF4-FFF2-40B4-BE49-F238E27FC236}">
                            <a16:creationId xmlns:a16="http://schemas.microsoft.com/office/drawing/2014/main" id="{1626B093-F7C8-4522-A35D-B6C5D93709D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81038" y="3862388"/>
                        <a:ext cx="2341562" cy="1981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对象 4">
            <a:extLst>
              <a:ext uri="{FF2B5EF4-FFF2-40B4-BE49-F238E27FC236}">
                <a16:creationId xmlns:a16="http://schemas.microsoft.com/office/drawing/2014/main" id="{E52BC611-701E-4B8A-8015-C988C859F3C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10562523"/>
              </p:ext>
            </p:extLst>
          </p:nvPr>
        </p:nvGraphicFramePr>
        <p:xfrm>
          <a:off x="2369308" y="3868738"/>
          <a:ext cx="2382837" cy="1981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50" name="Prism 9" r:id="rId5" imgW="3389237" imgH="2896719" progId="Prism9.Document">
                  <p:embed/>
                </p:oleObj>
              </mc:Choice>
              <mc:Fallback>
                <p:oleObj name="Prism 9" r:id="rId5" imgW="3389237" imgH="2896719" progId="Prism9.Document">
                  <p:embed/>
                  <p:pic>
                    <p:nvPicPr>
                      <p:cNvPr id="13" name="对象 12">
                        <a:extLst>
                          <a:ext uri="{FF2B5EF4-FFF2-40B4-BE49-F238E27FC236}">
                            <a16:creationId xmlns:a16="http://schemas.microsoft.com/office/drawing/2014/main" id="{9845E477-FD1E-42FC-8F9C-7F65EC37D52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369308" y="3868738"/>
                        <a:ext cx="2382837" cy="1981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对象 5">
            <a:extLst>
              <a:ext uri="{FF2B5EF4-FFF2-40B4-BE49-F238E27FC236}">
                <a16:creationId xmlns:a16="http://schemas.microsoft.com/office/drawing/2014/main" id="{7E5964AE-BF60-4BDA-A7E0-66441C21D94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52561052"/>
              </p:ext>
            </p:extLst>
          </p:nvPr>
        </p:nvGraphicFramePr>
        <p:xfrm>
          <a:off x="4090366" y="3873500"/>
          <a:ext cx="2327275" cy="1981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51" name="Prism 9" r:id="rId7" imgW="3343500" imgH="2896719" progId="Prism9.Document">
                  <p:embed/>
                </p:oleObj>
              </mc:Choice>
              <mc:Fallback>
                <p:oleObj name="Prism 9" r:id="rId7" imgW="3343500" imgH="2896719" progId="Prism9.Document">
                  <p:embed/>
                  <p:pic>
                    <p:nvPicPr>
                      <p:cNvPr id="20" name="对象 19">
                        <a:extLst>
                          <a:ext uri="{FF2B5EF4-FFF2-40B4-BE49-F238E27FC236}">
                            <a16:creationId xmlns:a16="http://schemas.microsoft.com/office/drawing/2014/main" id="{233B2F3F-32DE-4853-AA42-AE4E1B6E668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4090366" y="3873500"/>
                        <a:ext cx="2327275" cy="1981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TextBox 13">
            <a:extLst>
              <a:ext uri="{FF2B5EF4-FFF2-40B4-BE49-F238E27FC236}">
                <a16:creationId xmlns:a16="http://schemas.microsoft.com/office/drawing/2014/main" id="{B0E97A62-5508-4DCB-A018-19DA1A822EE3}"/>
              </a:ext>
            </a:extLst>
          </p:cNvPr>
          <p:cNvSpPr txBox="1"/>
          <p:nvPr/>
        </p:nvSpPr>
        <p:spPr>
          <a:xfrm>
            <a:off x="583803" y="3799024"/>
            <a:ext cx="54053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13">
            <a:extLst>
              <a:ext uri="{FF2B5EF4-FFF2-40B4-BE49-F238E27FC236}">
                <a16:creationId xmlns:a16="http://schemas.microsoft.com/office/drawing/2014/main" id="{082F3C8E-CA93-4B6C-B690-451D174499CB}"/>
              </a:ext>
            </a:extLst>
          </p:cNvPr>
          <p:cNvSpPr txBox="1"/>
          <p:nvPr/>
        </p:nvSpPr>
        <p:spPr>
          <a:xfrm>
            <a:off x="531612" y="2464747"/>
            <a:ext cx="57947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i="1" dirty="0">
                <a:latin typeface="Arial" panose="020B0604020202020204" pitchFamily="34" charset="0"/>
              </a:rPr>
              <a:t>Functional phenotype of peripheral </a:t>
            </a:r>
            <a:r>
              <a:rPr lang="en-US" altLang="zh-CN" i="1" dirty="0">
                <a:latin typeface="Arial" panose="020B0604020202020204" pitchFamily="34" charset="0"/>
                <a:sym typeface="Symbol" panose="05050102010706020507" pitchFamily="18" charset="2"/>
              </a:rPr>
              <a:t></a:t>
            </a:r>
            <a:r>
              <a:rPr lang="el-GR" altLang="zh-CN" i="1" dirty="0">
                <a:latin typeface="Arial" panose="020B0604020202020204" pitchFamily="34" charset="0"/>
                <a:sym typeface="Symbol" panose="05050102010706020507" pitchFamily="18" charset="2"/>
              </a:rPr>
              <a:t>δ</a:t>
            </a:r>
            <a:r>
              <a:rPr lang="en-US" altLang="zh-CN" i="1" dirty="0">
                <a:latin typeface="Arial" panose="020B0604020202020204" pitchFamily="34" charset="0"/>
                <a:sym typeface="Symbol" panose="05050102010706020507" pitchFamily="18" charset="2"/>
              </a:rPr>
              <a:t> T</a:t>
            </a:r>
            <a:r>
              <a:rPr lang="en-US" altLang="zh-CN" i="1" dirty="0">
                <a:latin typeface="Arial" panose="020B0604020202020204" pitchFamily="34" charset="0"/>
              </a:rPr>
              <a:t> cells.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8681062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1B870E9E-F71B-46C0-ABAD-8095E977192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9576" y="4130814"/>
            <a:ext cx="6478847" cy="3312076"/>
          </a:xfrm>
          <a:prstGeom prst="rect">
            <a:avLst/>
          </a:prstGeom>
        </p:spPr>
      </p:pic>
      <p:sp>
        <p:nvSpPr>
          <p:cNvPr id="7" name="矩形 6">
            <a:extLst>
              <a:ext uri="{FF2B5EF4-FFF2-40B4-BE49-F238E27FC236}">
                <a16:creationId xmlns:a16="http://schemas.microsoft.com/office/drawing/2014/main" id="{A29EE43C-3472-40A4-91FE-F2017E23B71C}"/>
              </a:ext>
            </a:extLst>
          </p:cNvPr>
          <p:cNvSpPr/>
          <p:nvPr/>
        </p:nvSpPr>
        <p:spPr>
          <a:xfrm>
            <a:off x="357102" y="2278444"/>
            <a:ext cx="6311321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18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altLang="zh-CN" b="1" i="1" kern="100" dirty="0">
                <a:latin typeface="Arial" panose="020B0604020202020204" pitchFamily="34" charset="0"/>
                <a:cs typeface="Times New Roman" panose="02020603050405020304" pitchFamily="18" charset="0"/>
              </a:rPr>
              <a:t>Apoptosis pathway.</a:t>
            </a:r>
          </a:p>
          <a:p>
            <a:pPr marL="446088" algn="just"/>
            <a:r>
              <a:rPr lang="en-US" altLang="zh-CN" sz="1400" b="1" i="1" kern="100" dirty="0">
                <a:latin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GB" altLang="zh-CN" sz="1800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Representative genes of the apoptosis pathway (comparisons between healthy and hepatocellular carcinoma as well as among clusters).</a:t>
            </a:r>
            <a:endParaRPr lang="zh-CN" altLang="zh-CN" sz="1400" b="1" i="1" kern="100" dirty="0">
              <a:latin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4" name="标题 1">
            <a:extLst>
              <a:ext uri="{FF2B5EF4-FFF2-40B4-BE49-F238E27FC236}">
                <a16:creationId xmlns:a16="http://schemas.microsoft.com/office/drawing/2014/main" id="{FA742DCD-8EFB-497E-A82C-C99606BA31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399317"/>
            <a:ext cx="6226492" cy="529598"/>
          </a:xfrm>
        </p:spPr>
        <p:txBody>
          <a:bodyPr>
            <a:normAutofit/>
          </a:bodyPr>
          <a:lstStyle/>
          <a:p>
            <a:pPr>
              <a:lnSpc>
                <a:spcPct val="100000"/>
              </a:lnSpc>
            </a:pPr>
            <a:r>
              <a:rPr lang="en-US" altLang="zh-CN" sz="2800" b="1" kern="100" dirty="0">
                <a:latin typeface="Arial" panose="020B0604020202020204" pitchFamily="34" charset="0"/>
                <a:cs typeface="Times New Roman" panose="02020603050405020304" pitchFamily="18" charset="0"/>
              </a:rPr>
              <a:t>Extended data for Figure 4. </a:t>
            </a:r>
            <a:endParaRPr lang="zh-CN" altLang="en-US" sz="2800" dirty="0"/>
          </a:p>
        </p:txBody>
      </p:sp>
      <p:sp>
        <p:nvSpPr>
          <p:cNvPr id="2" name="矩形 1">
            <a:extLst>
              <a:ext uri="{FF2B5EF4-FFF2-40B4-BE49-F238E27FC236}">
                <a16:creationId xmlns:a16="http://schemas.microsoft.com/office/drawing/2014/main" id="{C01CF3C8-D8BE-4989-B0EE-214377157427}"/>
              </a:ext>
            </a:extLst>
          </p:cNvPr>
          <p:cNvSpPr/>
          <p:nvPr/>
        </p:nvSpPr>
        <p:spPr>
          <a:xfrm>
            <a:off x="5955865" y="4435187"/>
            <a:ext cx="597336" cy="51643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32B88BAC-BA08-4A95-9850-076BD6AE4068}"/>
              </a:ext>
            </a:extLst>
          </p:cNvPr>
          <p:cNvSpPr txBox="1"/>
          <p:nvPr/>
        </p:nvSpPr>
        <p:spPr>
          <a:xfrm>
            <a:off x="5891395" y="4389289"/>
            <a:ext cx="830677" cy="585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20000"/>
              </a:lnSpc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Healthy</a:t>
            </a:r>
          </a:p>
          <a:p>
            <a:pPr>
              <a:lnSpc>
                <a:spcPct val="120000"/>
              </a:lnSpc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HCC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3414128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9FDC8878-07B4-4B53-A941-B056D8F31D7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89215" y="1104891"/>
            <a:ext cx="5037265" cy="8667911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61D9CA6B-F324-4D06-BAF4-4FACE9CB098F}"/>
              </a:ext>
            </a:extLst>
          </p:cNvPr>
          <p:cNvSpPr txBox="1"/>
          <p:nvPr/>
        </p:nvSpPr>
        <p:spPr>
          <a:xfrm>
            <a:off x="255068" y="640156"/>
            <a:ext cx="321594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(B) </a:t>
            </a:r>
            <a:r>
              <a:rPr lang="en-US" altLang="zh-CN" sz="2000" b="1" i="1" kern="100" dirty="0">
                <a:latin typeface="Arial" panose="020B0604020202020204" pitchFamily="34" charset="0"/>
                <a:cs typeface="Times New Roman" panose="02020603050405020304" pitchFamily="18" charset="0"/>
              </a:rPr>
              <a:t>Proliferation pathway</a:t>
            </a:r>
            <a:endParaRPr lang="en-US" sz="20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矩形 5">
            <a:extLst>
              <a:ext uri="{FF2B5EF4-FFF2-40B4-BE49-F238E27FC236}">
                <a16:creationId xmlns:a16="http://schemas.microsoft.com/office/drawing/2014/main" id="{A3A66660-5F51-4B02-AF96-F042A5834B52}"/>
              </a:ext>
            </a:extLst>
          </p:cNvPr>
          <p:cNvSpPr/>
          <p:nvPr/>
        </p:nvSpPr>
        <p:spPr>
          <a:xfrm>
            <a:off x="5591534" y="1363556"/>
            <a:ext cx="597336" cy="39578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42705EEA-E18C-49BD-A4E1-695DC5BA6195}"/>
              </a:ext>
            </a:extLst>
          </p:cNvPr>
          <p:cNvSpPr txBox="1"/>
          <p:nvPr/>
        </p:nvSpPr>
        <p:spPr>
          <a:xfrm>
            <a:off x="5493726" y="1268731"/>
            <a:ext cx="83067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Healthy</a:t>
            </a:r>
          </a:p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HCC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9176726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7E8B0080-E636-4227-B5F4-D53FF480262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02908" y="0"/>
            <a:ext cx="3495818" cy="99060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FFF15222-A4BC-47D7-8147-A99131964AAC}"/>
              </a:ext>
            </a:extLst>
          </p:cNvPr>
          <p:cNvSpPr txBox="1"/>
          <p:nvPr/>
        </p:nvSpPr>
        <p:spPr>
          <a:xfrm>
            <a:off x="0" y="1720186"/>
            <a:ext cx="2342501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(C) </a:t>
            </a:r>
            <a:r>
              <a:rPr lang="en-US" altLang="zh-CN" sz="2000" b="1" i="1" kern="100" dirty="0">
                <a:latin typeface="Arial" panose="020B0604020202020204" pitchFamily="34" charset="0"/>
                <a:cs typeface="Times New Roman" panose="02020603050405020304" pitchFamily="18" charset="0"/>
              </a:rPr>
              <a:t>Differentiation</a:t>
            </a:r>
          </a:p>
          <a:p>
            <a:r>
              <a:rPr lang="en-US" altLang="zh-CN" sz="2000" b="1" i="1" kern="100" dirty="0">
                <a:latin typeface="Arial" panose="020B0604020202020204" pitchFamily="34" charset="0"/>
                <a:cs typeface="Times New Roman" panose="02020603050405020304" pitchFamily="18" charset="0"/>
              </a:rPr>
              <a:t>      pathway</a:t>
            </a:r>
            <a:endParaRPr 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矩形 6">
            <a:extLst>
              <a:ext uri="{FF2B5EF4-FFF2-40B4-BE49-F238E27FC236}">
                <a16:creationId xmlns:a16="http://schemas.microsoft.com/office/drawing/2014/main" id="{1E88A4C4-97B2-4854-A012-CAFEFC201B65}"/>
              </a:ext>
            </a:extLst>
          </p:cNvPr>
          <p:cNvSpPr/>
          <p:nvPr/>
        </p:nvSpPr>
        <p:spPr>
          <a:xfrm>
            <a:off x="6033240" y="163857"/>
            <a:ext cx="272474" cy="32593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431CF0C0-E636-424A-927E-8F48BB87C10B}"/>
              </a:ext>
            </a:extLst>
          </p:cNvPr>
          <p:cNvSpPr txBox="1"/>
          <p:nvPr/>
        </p:nvSpPr>
        <p:spPr>
          <a:xfrm>
            <a:off x="5932880" y="87363"/>
            <a:ext cx="692934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Healthy</a:t>
            </a:r>
          </a:p>
          <a:p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HCC</a:t>
            </a:r>
            <a:endParaRPr lang="zh-CN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618554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CEEACA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CEEACA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85</TotalTime>
  <Words>577</Words>
  <Application>Microsoft Office PowerPoint</Application>
  <PresentationFormat>A4 纸张(210x297 毫米)</PresentationFormat>
  <Paragraphs>69</Paragraphs>
  <Slides>15</Slides>
  <Notes>0</Notes>
  <HiddenSlides>0</HiddenSlides>
  <MMClips>0</MMClips>
  <ScaleCrop>false</ScaleCrop>
  <HeadingPairs>
    <vt:vector size="8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2</vt:i4>
      </vt:variant>
      <vt:variant>
        <vt:lpstr>幻灯片标题</vt:lpstr>
      </vt:variant>
      <vt:variant>
        <vt:i4>15</vt:i4>
      </vt:variant>
    </vt:vector>
  </HeadingPairs>
  <TitlesOfParts>
    <vt:vector size="22" baseType="lpstr">
      <vt:lpstr>等线</vt:lpstr>
      <vt:lpstr>Arial</vt:lpstr>
      <vt:lpstr>Calibri</vt:lpstr>
      <vt:lpstr>Calibri Light</vt:lpstr>
      <vt:lpstr>Office Theme</vt:lpstr>
      <vt:lpstr>Prism 9</vt:lpstr>
      <vt:lpstr>Prism 7</vt:lpstr>
      <vt:lpstr>Extended Data for Figures </vt:lpstr>
      <vt:lpstr>Extended data for Figure 1. </vt:lpstr>
      <vt:lpstr>PowerPoint 演示文稿</vt:lpstr>
      <vt:lpstr>Extended data for Figure 2. </vt:lpstr>
      <vt:lpstr>PowerPoint 演示文稿</vt:lpstr>
      <vt:lpstr>PowerPoint 演示文稿</vt:lpstr>
      <vt:lpstr>Extended data for Figure 4. </vt:lpstr>
      <vt:lpstr>PowerPoint 演示文稿</vt:lpstr>
      <vt:lpstr>PowerPoint 演示文稿</vt:lpstr>
      <vt:lpstr>Extended data for Figure 5. </vt:lpstr>
      <vt:lpstr>Extended data for Figure 6. </vt:lpstr>
      <vt:lpstr>Extended data for Figure 6. </vt:lpstr>
      <vt:lpstr>Extended data for Figure 7. 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Materials</dc:title>
  <dc:creator>Derei Wu</dc:creator>
  <cp:lastModifiedBy>Derei Wu</cp:lastModifiedBy>
  <cp:revision>33</cp:revision>
  <dcterms:created xsi:type="dcterms:W3CDTF">2021-04-25T08:28:28Z</dcterms:created>
  <dcterms:modified xsi:type="dcterms:W3CDTF">2022-01-25T07:56:56Z</dcterms:modified>
</cp:coreProperties>
</file>